
<file path=[Content_Types].xml><?xml version="1.0" encoding="utf-8"?>
<Types xmlns="http://schemas.openxmlformats.org/package/2006/content-types">
  <Default Extension="emf" ContentType="image/x-emf"/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7832B"/>
    <a:srgbClr val="FFCC66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7166595-32BD-4204-AE7A-BFD050581266}" v="48" dt="2023-03-14T19:19:25.076"/>
    <p1510:client id="{E839ED6B-F7FD-7F48-8B72-2A69C700E3B7}" v="48" dt="2023-03-15T13:11:36.4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25422"/>
    <p:restoredTop sz="94694"/>
  </p:normalViewPr>
  <p:slideViewPr>
    <p:cSldViewPr snapToGrid="0">
      <p:cViewPr>
        <p:scale>
          <a:sx n="222" d="100"/>
          <a:sy n="222" d="100"/>
        </p:scale>
        <p:origin x="1512" y="-424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SÚS ANTONIO  GÓMEZ OCHOA DE ALDA" userId="111346b4-2c77-4688-bb93-b1ed5af05578" providerId="ADAL" clId="{E7166595-32BD-4204-AE7A-BFD050581266}"/>
    <pc:docChg chg="undo custSel addSld delSld modSld">
      <pc:chgData name="JESÚS ANTONIO  GÓMEZ OCHOA DE ALDA" userId="111346b4-2c77-4688-bb93-b1ed5af05578" providerId="ADAL" clId="{E7166595-32BD-4204-AE7A-BFD050581266}" dt="2023-03-15T15:10:53.331" v="2874" actId="1076"/>
      <pc:docMkLst>
        <pc:docMk/>
      </pc:docMkLst>
      <pc:sldChg chg="addSp delSp modSp mod">
        <pc:chgData name="JESÚS ANTONIO  GÓMEZ OCHOA DE ALDA" userId="111346b4-2c77-4688-bb93-b1ed5af05578" providerId="ADAL" clId="{E7166595-32BD-4204-AE7A-BFD050581266}" dt="2023-03-15T15:10:53.331" v="2874" actId="1076"/>
        <pc:sldMkLst>
          <pc:docMk/>
          <pc:sldMk cId="1785560441" sldId="256"/>
        </pc:sldMkLst>
        <pc:spChg chg="mod">
          <ac:chgData name="JESÚS ANTONIO  GÓMEZ OCHOA DE ALDA" userId="111346b4-2c77-4688-bb93-b1ed5af05578" providerId="ADAL" clId="{E7166595-32BD-4204-AE7A-BFD050581266}" dt="2023-03-14T18:09:27.597" v="1162" actId="1076"/>
          <ac:spMkLst>
            <pc:docMk/>
            <pc:sldMk cId="1785560441" sldId="256"/>
            <ac:spMk id="2" creationId="{3814B44B-9C7F-4FC3-DBF4-72A3F9A0D33F}"/>
          </ac:spMkLst>
        </pc:spChg>
        <pc:spChg chg="mod">
          <ac:chgData name="JESÚS ANTONIO  GÓMEZ OCHOA DE ALDA" userId="111346b4-2c77-4688-bb93-b1ed5af05578" providerId="ADAL" clId="{E7166595-32BD-4204-AE7A-BFD050581266}" dt="2023-03-14T19:11:33.855" v="1816" actId="1076"/>
          <ac:spMkLst>
            <pc:docMk/>
            <pc:sldMk cId="1785560441" sldId="256"/>
            <ac:spMk id="3" creationId="{39EF1756-DDC6-D559-0E19-B9593804957C}"/>
          </ac:spMkLst>
        </pc:spChg>
        <pc:spChg chg="mod">
          <ac:chgData name="JESÚS ANTONIO  GÓMEZ OCHOA DE ALDA" userId="111346b4-2c77-4688-bb93-b1ed5af05578" providerId="ADAL" clId="{E7166595-32BD-4204-AE7A-BFD050581266}" dt="2023-03-14T18:13:55.784" v="1184" actId="14100"/>
          <ac:spMkLst>
            <pc:docMk/>
            <pc:sldMk cId="1785560441" sldId="256"/>
            <ac:spMk id="8" creationId="{17843040-94AB-880F-9C89-AB7696F1944C}"/>
          </ac:spMkLst>
        </pc:spChg>
        <pc:spChg chg="mod">
          <ac:chgData name="JESÚS ANTONIO  GÓMEZ OCHOA DE ALDA" userId="111346b4-2c77-4688-bb93-b1ed5af05578" providerId="ADAL" clId="{E7166595-32BD-4204-AE7A-BFD050581266}" dt="2023-03-14T18:13:52.012" v="1183" actId="14100"/>
          <ac:spMkLst>
            <pc:docMk/>
            <pc:sldMk cId="1785560441" sldId="256"/>
            <ac:spMk id="9" creationId="{E94FB839-DBAC-D065-408E-F4E773DD39C5}"/>
          </ac:spMkLst>
        </pc:spChg>
        <pc:spChg chg="mod">
          <ac:chgData name="JESÚS ANTONIO  GÓMEZ OCHOA DE ALDA" userId="111346b4-2c77-4688-bb93-b1ed5af05578" providerId="ADAL" clId="{E7166595-32BD-4204-AE7A-BFD050581266}" dt="2023-03-14T18:15:19.744" v="1206" actId="14100"/>
          <ac:spMkLst>
            <pc:docMk/>
            <pc:sldMk cId="1785560441" sldId="256"/>
            <ac:spMk id="10" creationId="{FFB52DBD-C116-B296-5E60-721A39CC4067}"/>
          </ac:spMkLst>
        </pc:spChg>
        <pc:spChg chg="mod">
          <ac:chgData name="JESÚS ANTONIO  GÓMEZ OCHOA DE ALDA" userId="111346b4-2c77-4688-bb93-b1ed5af05578" providerId="ADAL" clId="{E7166595-32BD-4204-AE7A-BFD050581266}" dt="2023-03-14T18:15:06.179" v="1204" actId="14100"/>
          <ac:spMkLst>
            <pc:docMk/>
            <pc:sldMk cId="1785560441" sldId="256"/>
            <ac:spMk id="11" creationId="{3C401836-077E-FBCA-852A-A7F8E96109AA}"/>
          </ac:spMkLst>
        </pc:spChg>
        <pc:spChg chg="mod">
          <ac:chgData name="JESÚS ANTONIO  GÓMEZ OCHOA DE ALDA" userId="111346b4-2c77-4688-bb93-b1ed5af05578" providerId="ADAL" clId="{E7166595-32BD-4204-AE7A-BFD050581266}" dt="2023-03-14T18:14:35.593" v="1199" actId="1035"/>
          <ac:spMkLst>
            <pc:docMk/>
            <pc:sldMk cId="1785560441" sldId="256"/>
            <ac:spMk id="12" creationId="{D1C2516E-A669-2895-6EAD-75EAB7B28E1A}"/>
          </ac:spMkLst>
        </pc:spChg>
        <pc:spChg chg="mod">
          <ac:chgData name="JESÚS ANTONIO  GÓMEZ OCHOA DE ALDA" userId="111346b4-2c77-4688-bb93-b1ed5af05578" providerId="ADAL" clId="{E7166595-32BD-4204-AE7A-BFD050581266}" dt="2023-03-14T18:09:27.597" v="1162" actId="1076"/>
          <ac:spMkLst>
            <pc:docMk/>
            <pc:sldMk cId="1785560441" sldId="256"/>
            <ac:spMk id="15" creationId="{50B41022-8BC4-EF0C-B4D6-AA1ED5CACA8F}"/>
          </ac:spMkLst>
        </pc:spChg>
        <pc:spChg chg="add mod">
          <ac:chgData name="JESÚS ANTONIO  GÓMEZ OCHOA DE ALDA" userId="111346b4-2c77-4688-bb93-b1ed5af05578" providerId="ADAL" clId="{E7166595-32BD-4204-AE7A-BFD050581266}" dt="2023-03-14T18:20:20.800" v="1395" actId="1076"/>
          <ac:spMkLst>
            <pc:docMk/>
            <pc:sldMk cId="1785560441" sldId="256"/>
            <ac:spMk id="16" creationId="{E586665B-80BC-7F59-9CB4-928D4D1DEC84}"/>
          </ac:spMkLst>
        </pc:spChg>
        <pc:spChg chg="mod topLvl">
          <ac:chgData name="JESÚS ANTONIO  GÓMEZ OCHOA DE ALDA" userId="111346b4-2c77-4688-bb93-b1ed5af05578" providerId="ADAL" clId="{E7166595-32BD-4204-AE7A-BFD050581266}" dt="2023-03-14T18:08:43.755" v="1155" actId="113"/>
          <ac:spMkLst>
            <pc:docMk/>
            <pc:sldMk cId="1785560441" sldId="256"/>
            <ac:spMk id="18" creationId="{1240CB60-24EE-5862-D362-5611E70FD267}"/>
          </ac:spMkLst>
        </pc:spChg>
        <pc:spChg chg="mod topLvl">
          <ac:chgData name="JESÚS ANTONIO  GÓMEZ OCHOA DE ALDA" userId="111346b4-2c77-4688-bb93-b1ed5af05578" providerId="ADAL" clId="{E7166595-32BD-4204-AE7A-BFD050581266}" dt="2023-03-14T18:08:43.755" v="1155" actId="113"/>
          <ac:spMkLst>
            <pc:docMk/>
            <pc:sldMk cId="1785560441" sldId="256"/>
            <ac:spMk id="19" creationId="{B001D14E-0ECC-ECC5-2602-FFC8F48B1868}"/>
          </ac:spMkLst>
        </pc:spChg>
        <pc:spChg chg="mod topLvl">
          <ac:chgData name="JESÚS ANTONIO  GÓMEZ OCHOA DE ALDA" userId="111346b4-2c77-4688-bb93-b1ed5af05578" providerId="ADAL" clId="{E7166595-32BD-4204-AE7A-BFD050581266}" dt="2023-03-14T18:08:43.755" v="1155" actId="113"/>
          <ac:spMkLst>
            <pc:docMk/>
            <pc:sldMk cId="1785560441" sldId="256"/>
            <ac:spMk id="20" creationId="{E9E2F824-F1A9-5D5F-AFF8-E9DCC358BC58}"/>
          </ac:spMkLst>
        </pc:spChg>
        <pc:spChg chg="mod topLvl">
          <ac:chgData name="JESÚS ANTONIO  GÓMEZ OCHOA DE ALDA" userId="111346b4-2c77-4688-bb93-b1ed5af05578" providerId="ADAL" clId="{E7166595-32BD-4204-AE7A-BFD050581266}" dt="2023-03-14T18:08:43.755" v="1155" actId="113"/>
          <ac:spMkLst>
            <pc:docMk/>
            <pc:sldMk cId="1785560441" sldId="256"/>
            <ac:spMk id="21" creationId="{597497AC-DC58-3DF8-76FB-B07187BB51FA}"/>
          </ac:spMkLst>
        </pc:spChg>
        <pc:spChg chg="mod topLvl">
          <ac:chgData name="JESÚS ANTONIO  GÓMEZ OCHOA DE ALDA" userId="111346b4-2c77-4688-bb93-b1ed5af05578" providerId="ADAL" clId="{E7166595-32BD-4204-AE7A-BFD050581266}" dt="2023-03-14T18:08:43.755" v="1155" actId="113"/>
          <ac:spMkLst>
            <pc:docMk/>
            <pc:sldMk cId="1785560441" sldId="256"/>
            <ac:spMk id="22" creationId="{9AE36A53-2426-2961-9D0E-829D24562E5C}"/>
          </ac:spMkLst>
        </pc:spChg>
        <pc:spChg chg="mod topLvl">
          <ac:chgData name="JESÚS ANTONIO  GÓMEZ OCHOA DE ALDA" userId="111346b4-2c77-4688-bb93-b1ed5af05578" providerId="ADAL" clId="{E7166595-32BD-4204-AE7A-BFD050581266}" dt="2023-03-14T18:08:43.755" v="1155" actId="113"/>
          <ac:spMkLst>
            <pc:docMk/>
            <pc:sldMk cId="1785560441" sldId="256"/>
            <ac:spMk id="23" creationId="{9F9616BB-10AD-52D9-E26A-CB6D6582E745}"/>
          </ac:spMkLst>
        </pc:spChg>
        <pc:spChg chg="mod topLvl">
          <ac:chgData name="JESÚS ANTONIO  GÓMEZ OCHOA DE ALDA" userId="111346b4-2c77-4688-bb93-b1ed5af05578" providerId="ADAL" clId="{E7166595-32BD-4204-AE7A-BFD050581266}" dt="2023-03-14T18:09:27.597" v="1162" actId="1076"/>
          <ac:spMkLst>
            <pc:docMk/>
            <pc:sldMk cId="1785560441" sldId="256"/>
            <ac:spMk id="24" creationId="{73909222-B00F-33D3-B9F0-A061DB47F212}"/>
          </ac:spMkLst>
        </pc:spChg>
        <pc:spChg chg="del mod">
          <ac:chgData name="JESÚS ANTONIO  GÓMEZ OCHOA DE ALDA" userId="111346b4-2c77-4688-bb93-b1ed5af05578" providerId="ADAL" clId="{E7166595-32BD-4204-AE7A-BFD050581266}" dt="2023-03-14T18:09:17.069" v="1160" actId="478"/>
          <ac:spMkLst>
            <pc:docMk/>
            <pc:sldMk cId="1785560441" sldId="256"/>
            <ac:spMk id="33" creationId="{82EE7072-FF7E-0AA6-1BF8-05C7772E492E}"/>
          </ac:spMkLst>
        </pc:spChg>
        <pc:spChg chg="mod">
          <ac:chgData name="JESÚS ANTONIO  GÓMEZ OCHOA DE ALDA" userId="111346b4-2c77-4688-bb93-b1ed5af05578" providerId="ADAL" clId="{E7166595-32BD-4204-AE7A-BFD050581266}" dt="2023-03-14T18:19:59.121" v="1370" actId="1036"/>
          <ac:spMkLst>
            <pc:docMk/>
            <pc:sldMk cId="1785560441" sldId="256"/>
            <ac:spMk id="35" creationId="{289B8BEE-8A2E-E085-F947-10DE8C28E38D}"/>
          </ac:spMkLst>
        </pc:spChg>
        <pc:spChg chg="mod">
          <ac:chgData name="JESÚS ANTONIO  GÓMEZ OCHOA DE ALDA" userId="111346b4-2c77-4688-bb93-b1ed5af05578" providerId="ADAL" clId="{E7166595-32BD-4204-AE7A-BFD050581266}" dt="2023-03-14T18:19:50.269" v="1354" actId="1035"/>
          <ac:spMkLst>
            <pc:docMk/>
            <pc:sldMk cId="1785560441" sldId="256"/>
            <ac:spMk id="36" creationId="{D12DFE0C-1D80-F715-6E9F-25E2A2DD7673}"/>
          </ac:spMkLst>
        </pc:spChg>
        <pc:spChg chg="add del">
          <ac:chgData name="JESÚS ANTONIO  GÓMEZ OCHOA DE ALDA" userId="111346b4-2c77-4688-bb93-b1ed5af05578" providerId="ADAL" clId="{E7166595-32BD-4204-AE7A-BFD050581266}" dt="2023-03-14T17:32:30.304" v="384" actId="478"/>
          <ac:spMkLst>
            <pc:docMk/>
            <pc:sldMk cId="1785560441" sldId="256"/>
            <ac:spMk id="37" creationId="{0313AB2C-9367-3896-6945-FB2647F61185}"/>
          </ac:spMkLst>
        </pc:spChg>
        <pc:spChg chg="del mod">
          <ac:chgData name="JESÚS ANTONIO  GÓMEZ OCHOA DE ALDA" userId="111346b4-2c77-4688-bb93-b1ed5af05578" providerId="ADAL" clId="{E7166595-32BD-4204-AE7A-BFD050581266}" dt="2023-03-13T14:00:52.290" v="60" actId="478"/>
          <ac:spMkLst>
            <pc:docMk/>
            <pc:sldMk cId="1785560441" sldId="256"/>
            <ac:spMk id="42" creationId="{E56B4509-8F26-7AC2-3D3C-19CEA7224603}"/>
          </ac:spMkLst>
        </pc:spChg>
        <pc:spChg chg="del mod">
          <ac:chgData name="JESÚS ANTONIO  GÓMEZ OCHOA DE ALDA" userId="111346b4-2c77-4688-bb93-b1ed5af05578" providerId="ADAL" clId="{E7166595-32BD-4204-AE7A-BFD050581266}" dt="2023-03-13T14:01:37.419" v="63" actId="478"/>
          <ac:spMkLst>
            <pc:docMk/>
            <pc:sldMk cId="1785560441" sldId="256"/>
            <ac:spMk id="43" creationId="{89110CB3-F50E-35EA-A4FB-7A31ACFCA2BE}"/>
          </ac:spMkLst>
        </pc:spChg>
        <pc:spChg chg="add del mod">
          <ac:chgData name="JESÚS ANTONIO  GÓMEZ OCHOA DE ALDA" userId="111346b4-2c77-4688-bb93-b1ed5af05578" providerId="ADAL" clId="{E7166595-32BD-4204-AE7A-BFD050581266}" dt="2023-03-14T17:29:37.701" v="373" actId="478"/>
          <ac:spMkLst>
            <pc:docMk/>
            <pc:sldMk cId="1785560441" sldId="256"/>
            <ac:spMk id="51" creationId="{ECBB220A-994E-F9F7-F247-999B9B49A88E}"/>
          </ac:spMkLst>
        </pc:spChg>
        <pc:spChg chg="add mod">
          <ac:chgData name="JESÚS ANTONIO  GÓMEZ OCHOA DE ALDA" userId="111346b4-2c77-4688-bb93-b1ed5af05578" providerId="ADAL" clId="{E7166595-32BD-4204-AE7A-BFD050581266}" dt="2023-03-14T18:20:12.785" v="1394" actId="1035"/>
          <ac:spMkLst>
            <pc:docMk/>
            <pc:sldMk cId="1785560441" sldId="256"/>
            <ac:spMk id="57" creationId="{509DDFCF-D9D9-5941-32C2-DE49978599B1}"/>
          </ac:spMkLst>
        </pc:spChg>
        <pc:spChg chg="add mod">
          <ac:chgData name="JESÚS ANTONIO  GÓMEZ OCHOA DE ALDA" userId="111346b4-2c77-4688-bb93-b1ed5af05578" providerId="ADAL" clId="{E7166595-32BD-4204-AE7A-BFD050581266}" dt="2023-03-14T19:05:13.071" v="1757" actId="1076"/>
          <ac:spMkLst>
            <pc:docMk/>
            <pc:sldMk cId="1785560441" sldId="256"/>
            <ac:spMk id="58" creationId="{ED0227CF-8EAB-2235-5DB9-AD235D24FE42}"/>
          </ac:spMkLst>
        </pc:spChg>
        <pc:spChg chg="add mod">
          <ac:chgData name="JESÚS ANTONIO  GÓMEZ OCHOA DE ALDA" userId="111346b4-2c77-4688-bb93-b1ed5af05578" providerId="ADAL" clId="{E7166595-32BD-4204-AE7A-BFD050581266}" dt="2023-03-14T19:06:14.404" v="1766" actId="164"/>
          <ac:spMkLst>
            <pc:docMk/>
            <pc:sldMk cId="1785560441" sldId="256"/>
            <ac:spMk id="62" creationId="{232CA65E-7CBB-BFCF-F897-5460DB69025D}"/>
          </ac:spMkLst>
        </pc:spChg>
        <pc:spChg chg="add mod">
          <ac:chgData name="JESÚS ANTONIO  GÓMEZ OCHOA DE ALDA" userId="111346b4-2c77-4688-bb93-b1ed5af05578" providerId="ADAL" clId="{E7166595-32BD-4204-AE7A-BFD050581266}" dt="2023-03-14T19:13:58.700" v="2198" actId="1036"/>
          <ac:spMkLst>
            <pc:docMk/>
            <pc:sldMk cId="1785560441" sldId="256"/>
            <ac:spMk id="66" creationId="{55D6D51C-01AA-2796-18DF-DC62936BA4A9}"/>
          </ac:spMkLst>
        </pc:spChg>
        <pc:spChg chg="mod">
          <ac:chgData name="JESÚS ANTONIO  GÓMEZ OCHOA DE ALDA" userId="111346b4-2c77-4688-bb93-b1ed5af05578" providerId="ADAL" clId="{E7166595-32BD-4204-AE7A-BFD050581266}" dt="2023-03-14T19:19:01.748" v="2694" actId="1035"/>
          <ac:spMkLst>
            <pc:docMk/>
            <pc:sldMk cId="1785560441" sldId="256"/>
            <ac:spMk id="77" creationId="{290A4DDC-0C2D-6B15-1CF0-A246977A6F0A}"/>
          </ac:spMkLst>
        </pc:spChg>
        <pc:spChg chg="mod">
          <ac:chgData name="JESÚS ANTONIO  GÓMEZ OCHOA DE ALDA" userId="111346b4-2c77-4688-bb93-b1ed5af05578" providerId="ADAL" clId="{E7166595-32BD-4204-AE7A-BFD050581266}" dt="2023-03-14T19:18:53.810" v="2677" actId="1036"/>
          <ac:spMkLst>
            <pc:docMk/>
            <pc:sldMk cId="1785560441" sldId="256"/>
            <ac:spMk id="78" creationId="{2774C254-DDCA-724D-9C39-D91FA14040AB}"/>
          </ac:spMkLst>
        </pc:spChg>
        <pc:spChg chg="mod">
          <ac:chgData name="JESÚS ANTONIO  GÓMEZ OCHOA DE ALDA" userId="111346b4-2c77-4688-bb93-b1ed5af05578" providerId="ADAL" clId="{E7166595-32BD-4204-AE7A-BFD050581266}" dt="2023-03-14T19:18:48.581" v="2656" actId="1036"/>
          <ac:spMkLst>
            <pc:docMk/>
            <pc:sldMk cId="1785560441" sldId="256"/>
            <ac:spMk id="79" creationId="{F4925064-58A8-D3D7-5159-0BA7B1FE162E}"/>
          </ac:spMkLst>
        </pc:spChg>
        <pc:spChg chg="mod">
          <ac:chgData name="JESÚS ANTONIO  GÓMEZ OCHOA DE ALDA" userId="111346b4-2c77-4688-bb93-b1ed5af05578" providerId="ADAL" clId="{E7166595-32BD-4204-AE7A-BFD050581266}" dt="2023-03-14T19:18:39.914" v="2632" actId="1035"/>
          <ac:spMkLst>
            <pc:docMk/>
            <pc:sldMk cId="1785560441" sldId="256"/>
            <ac:spMk id="80" creationId="{A52C8569-75DE-D82A-1006-D729D8191531}"/>
          </ac:spMkLst>
        </pc:spChg>
        <pc:spChg chg="mod">
          <ac:chgData name="JESÚS ANTONIO  GÓMEZ OCHOA DE ALDA" userId="111346b4-2c77-4688-bb93-b1ed5af05578" providerId="ADAL" clId="{E7166595-32BD-4204-AE7A-BFD050581266}" dt="2023-03-14T19:18:34.352" v="2614" actId="1035"/>
          <ac:spMkLst>
            <pc:docMk/>
            <pc:sldMk cId="1785560441" sldId="256"/>
            <ac:spMk id="81" creationId="{0F796090-5D8E-BD51-5449-3700C33F4D9B}"/>
          </ac:spMkLst>
        </pc:spChg>
        <pc:spChg chg="del mod">
          <ac:chgData name="JESÚS ANTONIO  GÓMEZ OCHOA DE ALDA" userId="111346b4-2c77-4688-bb93-b1ed5af05578" providerId="ADAL" clId="{E7166595-32BD-4204-AE7A-BFD050581266}" dt="2023-03-14T19:18:27.355" v="2595" actId="478"/>
          <ac:spMkLst>
            <pc:docMk/>
            <pc:sldMk cId="1785560441" sldId="256"/>
            <ac:spMk id="82" creationId="{C12C31F2-5EF5-9A9B-DDE4-095CFA14AFA4}"/>
          </ac:spMkLst>
        </pc:spChg>
        <pc:spChg chg="add mod">
          <ac:chgData name="JESÚS ANTONIO  GÓMEZ OCHOA DE ALDA" userId="111346b4-2c77-4688-bb93-b1ed5af05578" providerId="ADAL" clId="{E7166595-32BD-4204-AE7A-BFD050581266}" dt="2023-03-14T19:24:12.799" v="2871" actId="1076"/>
          <ac:spMkLst>
            <pc:docMk/>
            <pc:sldMk cId="1785560441" sldId="256"/>
            <ac:spMk id="83" creationId="{74931BDC-EF20-98FF-F6E1-5EFB7D76CC4D}"/>
          </ac:spMkLst>
        </pc:spChg>
        <pc:grpChg chg="mod topLvl">
          <ac:chgData name="JESÚS ANTONIO  GÓMEZ OCHOA DE ALDA" userId="111346b4-2c77-4688-bb93-b1ed5af05578" providerId="ADAL" clId="{E7166595-32BD-4204-AE7A-BFD050581266}" dt="2023-03-14T18:09:27.597" v="1162" actId="1076"/>
          <ac:grpSpMkLst>
            <pc:docMk/>
            <pc:sldMk cId="1785560441" sldId="256"/>
            <ac:grpSpMk id="17" creationId="{D7E81A9F-D0BA-9F29-0453-09E385CFD287}"/>
          </ac:grpSpMkLst>
        </pc:grpChg>
        <pc:grpChg chg="del mod">
          <ac:chgData name="JESÚS ANTONIO  GÓMEZ OCHOA DE ALDA" userId="111346b4-2c77-4688-bb93-b1ed5af05578" providerId="ADAL" clId="{E7166595-32BD-4204-AE7A-BFD050581266}" dt="2023-03-14T18:04:41.961" v="915" actId="165"/>
          <ac:grpSpMkLst>
            <pc:docMk/>
            <pc:sldMk cId="1785560441" sldId="256"/>
            <ac:grpSpMk id="38" creationId="{E63F112C-DE70-545B-9628-FE310E4B9772}"/>
          </ac:grpSpMkLst>
        </pc:grpChg>
        <pc:grpChg chg="add mod ord">
          <ac:chgData name="JESÚS ANTONIO  GÓMEZ OCHOA DE ALDA" userId="111346b4-2c77-4688-bb93-b1ed5af05578" providerId="ADAL" clId="{E7166595-32BD-4204-AE7A-BFD050581266}" dt="2023-03-14T18:10:57.546" v="1171" actId="1035"/>
          <ac:grpSpMkLst>
            <pc:docMk/>
            <pc:sldMk cId="1785560441" sldId="256"/>
            <ac:grpSpMk id="42" creationId="{E9A4303B-C96C-88FF-29CF-6AACE8AB513F}"/>
          </ac:grpSpMkLst>
        </pc:grpChg>
        <pc:grpChg chg="add mod">
          <ac:chgData name="JESÚS ANTONIO  GÓMEZ OCHOA DE ALDA" userId="111346b4-2c77-4688-bb93-b1ed5af05578" providerId="ADAL" clId="{E7166595-32BD-4204-AE7A-BFD050581266}" dt="2023-03-14T18:11:02.140" v="1175" actId="1035"/>
          <ac:grpSpMkLst>
            <pc:docMk/>
            <pc:sldMk cId="1785560441" sldId="256"/>
            <ac:grpSpMk id="44" creationId="{358262BB-77D0-7C39-97F0-B814264542FF}"/>
          </ac:grpSpMkLst>
        </pc:grpChg>
        <pc:grpChg chg="add mod ord">
          <ac:chgData name="JESÚS ANTONIO  GÓMEZ OCHOA DE ALDA" userId="111346b4-2c77-4688-bb93-b1ed5af05578" providerId="ADAL" clId="{E7166595-32BD-4204-AE7A-BFD050581266}" dt="2023-03-14T18:09:27.597" v="1162" actId="1076"/>
          <ac:grpSpMkLst>
            <pc:docMk/>
            <pc:sldMk cId="1785560441" sldId="256"/>
            <ac:grpSpMk id="45" creationId="{7C70597C-94F7-6EBA-D8EC-792EAE717099}"/>
          </ac:grpSpMkLst>
        </pc:grpChg>
        <pc:grpChg chg="add mod">
          <ac:chgData name="JESÚS ANTONIO  GÓMEZ OCHOA DE ALDA" userId="111346b4-2c77-4688-bb93-b1ed5af05578" providerId="ADAL" clId="{E7166595-32BD-4204-AE7A-BFD050581266}" dt="2023-03-14T18:09:27.597" v="1162" actId="1076"/>
          <ac:grpSpMkLst>
            <pc:docMk/>
            <pc:sldMk cId="1785560441" sldId="256"/>
            <ac:grpSpMk id="46" creationId="{6B8E5AA9-B55A-C942-C262-F6F4AF3B06A5}"/>
          </ac:grpSpMkLst>
        </pc:grpChg>
        <pc:grpChg chg="add mod">
          <ac:chgData name="JESÚS ANTONIO  GÓMEZ OCHOA DE ALDA" userId="111346b4-2c77-4688-bb93-b1ed5af05578" providerId="ADAL" clId="{E7166595-32BD-4204-AE7A-BFD050581266}" dt="2023-03-14T19:06:14.404" v="1766" actId="164"/>
          <ac:grpSpMkLst>
            <pc:docMk/>
            <pc:sldMk cId="1785560441" sldId="256"/>
            <ac:grpSpMk id="61" creationId="{CF99178B-B967-4701-C9A2-54AD8DEE3235}"/>
          </ac:grpSpMkLst>
        </pc:grpChg>
        <pc:grpChg chg="add mod">
          <ac:chgData name="JESÚS ANTONIO  GÓMEZ OCHOA DE ALDA" userId="111346b4-2c77-4688-bb93-b1ed5af05578" providerId="ADAL" clId="{E7166595-32BD-4204-AE7A-BFD050581266}" dt="2023-03-14T19:23:27.711" v="2864" actId="1036"/>
          <ac:grpSpMkLst>
            <pc:docMk/>
            <pc:sldMk cId="1785560441" sldId="256"/>
            <ac:grpSpMk id="63" creationId="{85640574-3E4C-CB3E-3279-469A06935F5C}"/>
          </ac:grpSpMkLst>
        </pc:grpChg>
        <pc:grpChg chg="add mod">
          <ac:chgData name="JESÚS ANTONIO  GÓMEZ OCHOA DE ALDA" userId="111346b4-2c77-4688-bb93-b1ed5af05578" providerId="ADAL" clId="{E7166595-32BD-4204-AE7A-BFD050581266}" dt="2023-03-14T19:23:48.528" v="2870" actId="1037"/>
          <ac:grpSpMkLst>
            <pc:docMk/>
            <pc:sldMk cId="1785560441" sldId="256"/>
            <ac:grpSpMk id="68" creationId="{01ADF35B-12F6-8E1C-70DD-B057109DE21F}"/>
          </ac:grpSpMkLst>
        </pc:grpChg>
        <pc:grpChg chg="add mod">
          <ac:chgData name="JESÚS ANTONIO  GÓMEZ OCHOA DE ALDA" userId="111346b4-2c77-4688-bb93-b1ed5af05578" providerId="ADAL" clId="{E7166595-32BD-4204-AE7A-BFD050581266}" dt="2023-03-14T19:23:41.318" v="2868" actId="1037"/>
          <ac:grpSpMkLst>
            <pc:docMk/>
            <pc:sldMk cId="1785560441" sldId="256"/>
            <ac:grpSpMk id="76" creationId="{CFF9ADD8-7722-CD38-E803-A70C4B282DF6}"/>
          </ac:grpSpMkLst>
        </pc:grpChg>
        <pc:graphicFrameChg chg="add del mod ord">
          <ac:chgData name="JESÚS ANTONIO  GÓMEZ OCHOA DE ALDA" userId="111346b4-2c77-4688-bb93-b1ed5af05578" providerId="ADAL" clId="{E7166595-32BD-4204-AE7A-BFD050581266}" dt="2023-03-14T19:08:24.921" v="1779" actId="478"/>
          <ac:graphicFrameMkLst>
            <pc:docMk/>
            <pc:sldMk cId="1785560441" sldId="256"/>
            <ac:graphicFrameMk id="52" creationId="{C47B0754-879C-4E53-8216-8C45D1C0DD0A}"/>
          </ac:graphicFrameMkLst>
        </pc:graphicFrameChg>
        <pc:graphicFrameChg chg="add del mod">
          <ac:chgData name="JESÚS ANTONIO  GÓMEZ OCHOA DE ALDA" userId="111346b4-2c77-4688-bb93-b1ed5af05578" providerId="ADAL" clId="{E7166595-32BD-4204-AE7A-BFD050581266}" dt="2023-03-13T14:37:34.283" v="279" actId="478"/>
          <ac:graphicFrameMkLst>
            <pc:docMk/>
            <pc:sldMk cId="1785560441" sldId="256"/>
            <ac:graphicFrameMk id="56" creationId="{C8B23095-8C0D-7550-BE17-63CD833EE7C4}"/>
          </ac:graphicFrameMkLst>
        </pc:graphicFrameChg>
        <pc:graphicFrameChg chg="add del mod">
          <ac:chgData name="JESÚS ANTONIO  GÓMEZ OCHOA DE ALDA" userId="111346b4-2c77-4688-bb93-b1ed5af05578" providerId="ADAL" clId="{E7166595-32BD-4204-AE7A-BFD050581266}" dt="2023-03-13T14:38:42.641" v="281" actId="478"/>
          <ac:graphicFrameMkLst>
            <pc:docMk/>
            <pc:sldMk cId="1785560441" sldId="256"/>
            <ac:graphicFrameMk id="57" creationId="{CDFA391A-3CEB-B65C-EB18-1375927FC49C}"/>
          </ac:graphicFrameMkLst>
        </pc:graphicFrameChg>
        <pc:graphicFrameChg chg="add del mod">
          <ac:chgData name="JESÚS ANTONIO  GÓMEZ OCHOA DE ALDA" userId="111346b4-2c77-4688-bb93-b1ed5af05578" providerId="ADAL" clId="{E7166595-32BD-4204-AE7A-BFD050581266}" dt="2023-03-13T14:38:49.288" v="283" actId="478"/>
          <ac:graphicFrameMkLst>
            <pc:docMk/>
            <pc:sldMk cId="1785560441" sldId="256"/>
            <ac:graphicFrameMk id="58" creationId="{A0C7A0EF-87B5-F511-BF52-5735BAB97A2B}"/>
          </ac:graphicFrameMkLst>
        </pc:graphicFrameChg>
        <pc:picChg chg="add del mod ord modCrop">
          <ac:chgData name="JESÚS ANTONIO  GÓMEZ OCHOA DE ALDA" userId="111346b4-2c77-4688-bb93-b1ed5af05578" providerId="ADAL" clId="{E7166595-32BD-4204-AE7A-BFD050581266}" dt="2023-03-14T18:00:55.966" v="864" actId="167"/>
          <ac:picMkLst>
            <pc:docMk/>
            <pc:sldMk cId="1785560441" sldId="256"/>
            <ac:picMk id="4" creationId="{8D2A467C-12C6-7252-4E67-0351D8110A38}"/>
          </ac:picMkLst>
        </pc:picChg>
        <pc:picChg chg="mod">
          <ac:chgData name="JESÚS ANTONIO  GÓMEZ OCHOA DE ALDA" userId="111346b4-2c77-4688-bb93-b1ed5af05578" providerId="ADAL" clId="{E7166595-32BD-4204-AE7A-BFD050581266}" dt="2023-03-14T18:09:27.597" v="1162" actId="1076"/>
          <ac:picMkLst>
            <pc:docMk/>
            <pc:sldMk cId="1785560441" sldId="256"/>
            <ac:picMk id="5" creationId="{290A79D6-94B3-35F5-20E2-DA12314BCCFE}"/>
          </ac:picMkLst>
        </pc:picChg>
        <pc:picChg chg="mod ord modCrop">
          <ac:chgData name="JESÚS ANTONIO  GÓMEZ OCHOA DE ALDA" userId="111346b4-2c77-4688-bb93-b1ed5af05578" providerId="ADAL" clId="{E7166595-32BD-4204-AE7A-BFD050581266}" dt="2023-03-14T18:10:11.692" v="1166" actId="166"/>
          <ac:picMkLst>
            <pc:docMk/>
            <pc:sldMk cId="1785560441" sldId="256"/>
            <ac:picMk id="6" creationId="{8E55A531-5DE8-D6FC-F615-A94F068E5381}"/>
          </ac:picMkLst>
        </pc:picChg>
        <pc:picChg chg="mod">
          <ac:chgData name="JESÚS ANTONIO  GÓMEZ OCHOA DE ALDA" userId="111346b4-2c77-4688-bb93-b1ed5af05578" providerId="ADAL" clId="{E7166595-32BD-4204-AE7A-BFD050581266}" dt="2023-03-14T18:15:38.027" v="1207" actId="1076"/>
          <ac:picMkLst>
            <pc:docMk/>
            <pc:sldMk cId="1785560441" sldId="256"/>
            <ac:picMk id="7" creationId="{804BB09C-4EAE-8AA4-7534-1B87164F171C}"/>
          </ac:picMkLst>
        </pc:picChg>
        <pc:picChg chg="mod">
          <ac:chgData name="JESÚS ANTONIO  GÓMEZ OCHOA DE ALDA" userId="111346b4-2c77-4688-bb93-b1ed5af05578" providerId="ADAL" clId="{E7166595-32BD-4204-AE7A-BFD050581266}" dt="2023-03-14T18:09:27.597" v="1162" actId="1076"/>
          <ac:picMkLst>
            <pc:docMk/>
            <pc:sldMk cId="1785560441" sldId="256"/>
            <ac:picMk id="13" creationId="{A7F90049-4C99-E39A-53A0-4FA279905F26}"/>
          </ac:picMkLst>
        </pc:picChg>
        <pc:picChg chg="mod modCrop">
          <ac:chgData name="JESÚS ANTONIO  GÓMEZ OCHOA DE ALDA" userId="111346b4-2c77-4688-bb93-b1ed5af05578" providerId="ADAL" clId="{E7166595-32BD-4204-AE7A-BFD050581266}" dt="2023-03-14T17:41:06.439" v="563" actId="164"/>
          <ac:picMkLst>
            <pc:docMk/>
            <pc:sldMk cId="1785560441" sldId="256"/>
            <ac:picMk id="14" creationId="{775E7B6C-88CD-7FF8-EC10-3EADC1E26BE0}"/>
          </ac:picMkLst>
        </pc:picChg>
        <pc:picChg chg="mod">
          <ac:chgData name="JESÚS ANTONIO  GÓMEZ OCHOA DE ALDA" userId="111346b4-2c77-4688-bb93-b1ed5af05578" providerId="ADAL" clId="{E7166595-32BD-4204-AE7A-BFD050581266}" dt="2023-03-14T18:14:16.920" v="1191" actId="1076"/>
          <ac:picMkLst>
            <pc:docMk/>
            <pc:sldMk cId="1785560441" sldId="256"/>
            <ac:picMk id="32" creationId="{26228F0F-4F4B-87DE-0D1F-C71402B5370C}"/>
          </ac:picMkLst>
        </pc:picChg>
        <pc:picChg chg="del mod">
          <ac:chgData name="JESÚS ANTONIO  GÓMEZ OCHOA DE ALDA" userId="111346b4-2c77-4688-bb93-b1ed5af05578" providerId="ADAL" clId="{E7166595-32BD-4204-AE7A-BFD050581266}" dt="2023-03-14T18:09:07.538" v="1159" actId="478"/>
          <ac:picMkLst>
            <pc:docMk/>
            <pc:sldMk cId="1785560441" sldId="256"/>
            <ac:picMk id="34" creationId="{7FDF611E-72AD-184B-6272-63F452731E95}"/>
          </ac:picMkLst>
        </pc:picChg>
        <pc:picChg chg="del mod">
          <ac:chgData name="JESÚS ANTONIO  GÓMEZ OCHOA DE ALDA" userId="111346b4-2c77-4688-bb93-b1ed5af05578" providerId="ADAL" clId="{E7166595-32BD-4204-AE7A-BFD050581266}" dt="2023-03-13T14:03:55.673" v="83" actId="478"/>
          <ac:picMkLst>
            <pc:docMk/>
            <pc:sldMk cId="1785560441" sldId="256"/>
            <ac:picMk id="40" creationId="{7D91CB82-417E-804F-4791-354E3EC32BDF}"/>
          </ac:picMkLst>
        </pc:picChg>
        <pc:picChg chg="add mod modCrop">
          <ac:chgData name="JESÚS ANTONIO  GÓMEZ OCHOA DE ALDA" userId="111346b4-2c77-4688-bb93-b1ed5af05578" providerId="ADAL" clId="{E7166595-32BD-4204-AE7A-BFD050581266}" dt="2023-03-14T17:45:22.630" v="601" actId="164"/>
          <ac:picMkLst>
            <pc:docMk/>
            <pc:sldMk cId="1785560441" sldId="256"/>
            <ac:picMk id="40" creationId="{92CC7D99-D670-E1DC-F3FF-B14B517CF348}"/>
          </ac:picMkLst>
        </pc:picChg>
        <pc:picChg chg="add mod modCrop">
          <ac:chgData name="JESÚS ANTONIO  GÓMEZ OCHOA DE ALDA" userId="111346b4-2c77-4688-bb93-b1ed5af05578" providerId="ADAL" clId="{E7166595-32BD-4204-AE7A-BFD050581266}" dt="2023-03-14T17:41:06.439" v="563" actId="164"/>
          <ac:picMkLst>
            <pc:docMk/>
            <pc:sldMk cId="1785560441" sldId="256"/>
            <ac:picMk id="41" creationId="{1D9E3649-F118-3DEC-EF5D-9E7CB3201455}"/>
          </ac:picMkLst>
        </pc:picChg>
        <pc:picChg chg="del">
          <ac:chgData name="JESÚS ANTONIO  GÓMEZ OCHOA DE ALDA" userId="111346b4-2c77-4688-bb93-b1ed5af05578" providerId="ADAL" clId="{E7166595-32BD-4204-AE7A-BFD050581266}" dt="2023-03-13T14:00:09.790" v="0" actId="478"/>
          <ac:picMkLst>
            <pc:docMk/>
            <pc:sldMk cId="1785560441" sldId="256"/>
            <ac:picMk id="41" creationId="{DD7EF61D-5830-6148-AE36-DF22BD4746EF}"/>
          </ac:picMkLst>
        </pc:picChg>
        <pc:picChg chg="add mod modCrop">
          <ac:chgData name="JESÚS ANTONIO  GÓMEZ OCHOA DE ALDA" userId="111346b4-2c77-4688-bb93-b1ed5af05578" providerId="ADAL" clId="{E7166595-32BD-4204-AE7A-BFD050581266}" dt="2023-03-14T17:45:22.630" v="601" actId="164"/>
          <ac:picMkLst>
            <pc:docMk/>
            <pc:sldMk cId="1785560441" sldId="256"/>
            <ac:picMk id="43" creationId="{52EF91C4-5A1D-8E50-7C83-6CC40235EF0E}"/>
          </ac:picMkLst>
        </pc:picChg>
        <pc:picChg chg="add mod modCrop">
          <ac:chgData name="JESÚS ANTONIO  GÓMEZ OCHOA DE ALDA" userId="111346b4-2c77-4688-bb93-b1ed5af05578" providerId="ADAL" clId="{E7166595-32BD-4204-AE7A-BFD050581266}" dt="2023-03-14T19:02:09.183" v="1741" actId="1076"/>
          <ac:picMkLst>
            <pc:docMk/>
            <pc:sldMk cId="1785560441" sldId="256"/>
            <ac:picMk id="48" creationId="{676258DB-E675-A83D-206E-94FD96418CE3}"/>
          </ac:picMkLst>
        </pc:picChg>
        <pc:picChg chg="add mod modCrop">
          <ac:chgData name="JESÚS ANTONIO  GÓMEZ OCHOA DE ALDA" userId="111346b4-2c77-4688-bb93-b1ed5af05578" providerId="ADAL" clId="{E7166595-32BD-4204-AE7A-BFD050581266}" dt="2023-03-14T19:23:06.758" v="2862" actId="1036"/>
          <ac:picMkLst>
            <pc:docMk/>
            <pc:sldMk cId="1785560441" sldId="256"/>
            <ac:picMk id="50" creationId="{77C5254A-B3C0-EAF0-271E-2BA1026FA832}"/>
          </ac:picMkLst>
        </pc:picChg>
        <pc:picChg chg="add del mod">
          <ac:chgData name="JESÚS ANTONIO  GÓMEZ OCHOA DE ALDA" userId="111346b4-2c77-4688-bb93-b1ed5af05578" providerId="ADAL" clId="{E7166595-32BD-4204-AE7A-BFD050581266}" dt="2023-03-13T14:35:55.525" v="267" actId="478"/>
          <ac:picMkLst>
            <pc:docMk/>
            <pc:sldMk cId="1785560441" sldId="256"/>
            <ac:picMk id="50" creationId="{E7C38E82-A97C-2D12-E333-DC022E8477FC}"/>
          </ac:picMkLst>
        </pc:picChg>
        <pc:picChg chg="add del mod">
          <ac:chgData name="JESÚS ANTONIO  GÓMEZ OCHOA DE ALDA" userId="111346b4-2c77-4688-bb93-b1ed5af05578" providerId="ADAL" clId="{E7166595-32BD-4204-AE7A-BFD050581266}" dt="2023-03-14T17:29:51.939" v="377" actId="478"/>
          <ac:picMkLst>
            <pc:docMk/>
            <pc:sldMk cId="1785560441" sldId="256"/>
            <ac:picMk id="53" creationId="{7AEE8F0F-016C-B655-F325-A45861122B01}"/>
          </ac:picMkLst>
        </pc:picChg>
        <pc:picChg chg="add del mod">
          <ac:chgData name="JESÚS ANTONIO  GÓMEZ OCHOA DE ALDA" userId="111346b4-2c77-4688-bb93-b1ed5af05578" providerId="ADAL" clId="{E7166595-32BD-4204-AE7A-BFD050581266}" dt="2023-03-14T17:29:35.611" v="372" actId="478"/>
          <ac:picMkLst>
            <pc:docMk/>
            <pc:sldMk cId="1785560441" sldId="256"/>
            <ac:picMk id="55" creationId="{83424300-F15C-1105-3DD6-F84E2C3955E1}"/>
          </ac:picMkLst>
        </pc:picChg>
        <pc:picChg chg="add mod modCrop">
          <ac:chgData name="JESÚS ANTONIO  GÓMEZ OCHOA DE ALDA" userId="111346b4-2c77-4688-bb93-b1ed5af05578" providerId="ADAL" clId="{E7166595-32BD-4204-AE7A-BFD050581266}" dt="2023-03-14T19:01:56.831" v="1739" actId="1076"/>
          <ac:picMkLst>
            <pc:docMk/>
            <pc:sldMk cId="1785560441" sldId="256"/>
            <ac:picMk id="56" creationId="{63CAB4D6-D628-3ECB-5F3F-5CD0E4A6E53B}"/>
          </ac:picMkLst>
        </pc:picChg>
        <pc:picChg chg="add mod modCrop">
          <ac:chgData name="JESÚS ANTONIO  GÓMEZ OCHOA DE ALDA" userId="111346b4-2c77-4688-bb93-b1ed5af05578" providerId="ADAL" clId="{E7166595-32BD-4204-AE7A-BFD050581266}" dt="2023-03-14T19:23:31.423" v="2865" actId="1036"/>
          <ac:picMkLst>
            <pc:docMk/>
            <pc:sldMk cId="1785560441" sldId="256"/>
            <ac:picMk id="59" creationId="{C678C305-D965-A1C2-B8A8-0B62611114EA}"/>
          </ac:picMkLst>
        </pc:picChg>
        <pc:picChg chg="add del mod modCrop">
          <ac:chgData name="JESÚS ANTONIO  GÓMEZ OCHOA DE ALDA" userId="111346b4-2c77-4688-bb93-b1ed5af05578" providerId="ADAL" clId="{E7166595-32BD-4204-AE7A-BFD050581266}" dt="2023-03-14T17:29:38.684" v="374" actId="478"/>
          <ac:picMkLst>
            <pc:docMk/>
            <pc:sldMk cId="1785560441" sldId="256"/>
            <ac:picMk id="60" creationId="{B599D18F-0516-BC8A-6463-ECA3AD72C0AA}"/>
          </ac:picMkLst>
        </pc:picChg>
        <pc:picChg chg="add mod modCrop">
          <ac:chgData name="JESÚS ANTONIO  GÓMEZ OCHOA DE ALDA" userId="111346b4-2c77-4688-bb93-b1ed5af05578" providerId="ADAL" clId="{E7166595-32BD-4204-AE7A-BFD050581266}" dt="2023-03-14T19:10:44.667" v="1814" actId="14100"/>
          <ac:picMkLst>
            <pc:docMk/>
            <pc:sldMk cId="1785560441" sldId="256"/>
            <ac:picMk id="65" creationId="{6E8A8E05-299C-61DA-26D2-C00C9E3E4637}"/>
          </ac:picMkLst>
        </pc:picChg>
        <pc:picChg chg="add del mod">
          <ac:chgData name="JESÚS ANTONIO  GÓMEZ OCHOA DE ALDA" userId="111346b4-2c77-4688-bb93-b1ed5af05578" providerId="ADAL" clId="{E7166595-32BD-4204-AE7A-BFD050581266}" dt="2023-03-14T19:14:28.482" v="2201" actId="478"/>
          <ac:picMkLst>
            <pc:docMk/>
            <pc:sldMk cId="1785560441" sldId="256"/>
            <ac:picMk id="67" creationId="{97D4D524-CCDB-34A4-2F66-08A1E13D0E6C}"/>
          </ac:picMkLst>
        </pc:picChg>
        <pc:picChg chg="add mod ord modCrop">
          <ac:chgData name="JESÚS ANTONIO  GÓMEZ OCHOA DE ALDA" userId="111346b4-2c77-4688-bb93-b1ed5af05578" providerId="ADAL" clId="{E7166595-32BD-4204-AE7A-BFD050581266}" dt="2023-03-14T19:22:32.323" v="2854" actId="167"/>
          <ac:picMkLst>
            <pc:docMk/>
            <pc:sldMk cId="1785560441" sldId="256"/>
            <ac:picMk id="84" creationId="{70969B2A-2DBC-2206-9DAD-542A9FF077F0}"/>
          </ac:picMkLst>
        </pc:picChg>
        <pc:picChg chg="mod">
          <ac:chgData name="JESÚS ANTONIO  GÓMEZ OCHOA DE ALDA" userId="111346b4-2c77-4688-bb93-b1ed5af05578" providerId="ADAL" clId="{E7166595-32BD-4204-AE7A-BFD050581266}" dt="2023-03-15T15:10:53.331" v="2874" actId="1076"/>
          <ac:picMkLst>
            <pc:docMk/>
            <pc:sldMk cId="1785560441" sldId="256"/>
            <ac:picMk id="144" creationId="{CDD91083-7FB2-6C58-67E3-03C723E07B86}"/>
          </ac:picMkLst>
        </pc:picChg>
        <pc:cxnChg chg="mod">
          <ac:chgData name="JESÚS ANTONIO  GÓMEZ OCHOA DE ALDA" userId="111346b4-2c77-4688-bb93-b1ed5af05578" providerId="ADAL" clId="{E7166595-32BD-4204-AE7A-BFD050581266}" dt="2023-03-14T18:04:41.961" v="915" actId="165"/>
          <ac:cxnSpMkLst>
            <pc:docMk/>
            <pc:sldMk cId="1785560441" sldId="256"/>
            <ac:cxnSpMk id="25" creationId="{18059E44-5B72-A965-BAC8-B2918BD272E7}"/>
          </ac:cxnSpMkLst>
        </pc:cxnChg>
        <pc:cxnChg chg="mod">
          <ac:chgData name="JESÚS ANTONIO  GÓMEZ OCHOA DE ALDA" userId="111346b4-2c77-4688-bb93-b1ed5af05578" providerId="ADAL" clId="{E7166595-32BD-4204-AE7A-BFD050581266}" dt="2023-03-14T18:04:41.961" v="915" actId="165"/>
          <ac:cxnSpMkLst>
            <pc:docMk/>
            <pc:sldMk cId="1785560441" sldId="256"/>
            <ac:cxnSpMk id="26" creationId="{7B3CF82B-2C21-3425-1DE7-074826D4F50D}"/>
          </ac:cxnSpMkLst>
        </pc:cxnChg>
        <pc:cxnChg chg="mod">
          <ac:chgData name="JESÚS ANTONIO  GÓMEZ OCHOA DE ALDA" userId="111346b4-2c77-4688-bb93-b1ed5af05578" providerId="ADAL" clId="{E7166595-32BD-4204-AE7A-BFD050581266}" dt="2023-03-14T18:04:41.961" v="915" actId="165"/>
          <ac:cxnSpMkLst>
            <pc:docMk/>
            <pc:sldMk cId="1785560441" sldId="256"/>
            <ac:cxnSpMk id="27" creationId="{C7E64754-12C4-6165-C805-5D0245050A3F}"/>
          </ac:cxnSpMkLst>
        </pc:cxnChg>
        <pc:cxnChg chg="mod">
          <ac:chgData name="JESÚS ANTONIO  GÓMEZ OCHOA DE ALDA" userId="111346b4-2c77-4688-bb93-b1ed5af05578" providerId="ADAL" clId="{E7166595-32BD-4204-AE7A-BFD050581266}" dt="2023-03-14T18:04:41.961" v="915" actId="165"/>
          <ac:cxnSpMkLst>
            <pc:docMk/>
            <pc:sldMk cId="1785560441" sldId="256"/>
            <ac:cxnSpMk id="28" creationId="{5D608EEF-D379-A945-32AF-12671E491E72}"/>
          </ac:cxnSpMkLst>
        </pc:cxnChg>
        <pc:cxnChg chg="mod">
          <ac:chgData name="JESÚS ANTONIO  GÓMEZ OCHOA DE ALDA" userId="111346b4-2c77-4688-bb93-b1ed5af05578" providerId="ADAL" clId="{E7166595-32BD-4204-AE7A-BFD050581266}" dt="2023-03-14T18:04:41.961" v="915" actId="165"/>
          <ac:cxnSpMkLst>
            <pc:docMk/>
            <pc:sldMk cId="1785560441" sldId="256"/>
            <ac:cxnSpMk id="29" creationId="{67C778A8-5468-AA59-9F53-D796EB5FF2EB}"/>
          </ac:cxnSpMkLst>
        </pc:cxnChg>
        <pc:cxnChg chg="mod">
          <ac:chgData name="JESÚS ANTONIO  GÓMEZ OCHOA DE ALDA" userId="111346b4-2c77-4688-bb93-b1ed5af05578" providerId="ADAL" clId="{E7166595-32BD-4204-AE7A-BFD050581266}" dt="2023-03-14T18:04:41.961" v="915" actId="165"/>
          <ac:cxnSpMkLst>
            <pc:docMk/>
            <pc:sldMk cId="1785560441" sldId="256"/>
            <ac:cxnSpMk id="30" creationId="{D22218D9-5624-CE1D-EFF3-D25D9055D6D9}"/>
          </ac:cxnSpMkLst>
        </pc:cxnChg>
        <pc:cxnChg chg="mod">
          <ac:chgData name="JESÚS ANTONIO  GÓMEZ OCHOA DE ALDA" userId="111346b4-2c77-4688-bb93-b1ed5af05578" providerId="ADAL" clId="{E7166595-32BD-4204-AE7A-BFD050581266}" dt="2023-03-14T18:04:41.961" v="915" actId="165"/>
          <ac:cxnSpMkLst>
            <pc:docMk/>
            <pc:sldMk cId="1785560441" sldId="256"/>
            <ac:cxnSpMk id="31" creationId="{BC957F19-95C3-A9A6-06EA-6581B8C2C65B}"/>
          </ac:cxnSpMkLst>
        </pc:cxnChg>
        <pc:cxnChg chg="add del mod">
          <ac:chgData name="JESÚS ANTONIO  GÓMEZ OCHOA DE ALDA" userId="111346b4-2c77-4688-bb93-b1ed5af05578" providerId="ADAL" clId="{E7166595-32BD-4204-AE7A-BFD050581266}" dt="2023-03-13T14:03:58.837" v="84" actId="478"/>
          <ac:cxnSpMkLst>
            <pc:docMk/>
            <pc:sldMk cId="1785560441" sldId="256"/>
            <ac:cxnSpMk id="37" creationId="{DD62EDFF-794E-E0DA-6760-20F29EA8BD2B}"/>
          </ac:cxnSpMkLst>
        </pc:cxnChg>
        <pc:cxnChg chg="add del mod">
          <ac:chgData name="JESÚS ANTONIO  GÓMEZ OCHOA DE ALDA" userId="111346b4-2c77-4688-bb93-b1ed5af05578" providerId="ADAL" clId="{E7166595-32BD-4204-AE7A-BFD050581266}" dt="2023-03-13T14:04:04.895" v="87" actId="478"/>
          <ac:cxnSpMkLst>
            <pc:docMk/>
            <pc:sldMk cId="1785560441" sldId="256"/>
            <ac:cxnSpMk id="44" creationId="{5302BADE-8AF5-5A75-C65A-7B2376BC29A8}"/>
          </ac:cxnSpMkLst>
        </pc:cxnChg>
        <pc:cxnChg chg="mod">
          <ac:chgData name="JESÚS ANTONIO  GÓMEZ OCHOA DE ALDA" userId="111346b4-2c77-4688-bb93-b1ed5af05578" providerId="ADAL" clId="{E7166595-32BD-4204-AE7A-BFD050581266}" dt="2023-03-14T19:14:42.225" v="2202"/>
          <ac:cxnSpMkLst>
            <pc:docMk/>
            <pc:sldMk cId="1785560441" sldId="256"/>
            <ac:cxnSpMk id="69" creationId="{2E5C990E-A892-4487-94BD-C41E5C1D3A85}"/>
          </ac:cxnSpMkLst>
        </pc:cxnChg>
        <pc:cxnChg chg="mod">
          <ac:chgData name="JESÚS ANTONIO  GÓMEZ OCHOA DE ALDA" userId="111346b4-2c77-4688-bb93-b1ed5af05578" providerId="ADAL" clId="{E7166595-32BD-4204-AE7A-BFD050581266}" dt="2023-03-14T19:17:04.536" v="2593" actId="1036"/>
          <ac:cxnSpMkLst>
            <pc:docMk/>
            <pc:sldMk cId="1785560441" sldId="256"/>
            <ac:cxnSpMk id="70" creationId="{BA10EC29-12FE-6175-924C-7D73963246A0}"/>
          </ac:cxnSpMkLst>
        </pc:cxnChg>
        <pc:cxnChg chg="del mod">
          <ac:chgData name="JESÚS ANTONIO  GÓMEZ OCHOA DE ALDA" userId="111346b4-2c77-4688-bb93-b1ed5af05578" providerId="ADAL" clId="{E7166595-32BD-4204-AE7A-BFD050581266}" dt="2023-03-14T19:17:08.560" v="2594" actId="478"/>
          <ac:cxnSpMkLst>
            <pc:docMk/>
            <pc:sldMk cId="1785560441" sldId="256"/>
            <ac:cxnSpMk id="71" creationId="{B753D594-A9CA-409C-6F21-777238085F65}"/>
          </ac:cxnSpMkLst>
        </pc:cxnChg>
        <pc:cxnChg chg="mod">
          <ac:chgData name="JESÚS ANTONIO  GÓMEZ OCHOA DE ALDA" userId="111346b4-2c77-4688-bb93-b1ed5af05578" providerId="ADAL" clId="{E7166595-32BD-4204-AE7A-BFD050581266}" dt="2023-03-14T19:16:57.938" v="2577" actId="1036"/>
          <ac:cxnSpMkLst>
            <pc:docMk/>
            <pc:sldMk cId="1785560441" sldId="256"/>
            <ac:cxnSpMk id="72" creationId="{9563563C-20B2-7D36-19D4-E79670C35D5F}"/>
          </ac:cxnSpMkLst>
        </pc:cxnChg>
        <pc:cxnChg chg="mod">
          <ac:chgData name="JESÚS ANTONIO  GÓMEZ OCHOA DE ALDA" userId="111346b4-2c77-4688-bb93-b1ed5af05578" providerId="ADAL" clId="{E7166595-32BD-4204-AE7A-BFD050581266}" dt="2023-03-14T19:16:51.325" v="2567" actId="1036"/>
          <ac:cxnSpMkLst>
            <pc:docMk/>
            <pc:sldMk cId="1785560441" sldId="256"/>
            <ac:cxnSpMk id="73" creationId="{17D52CCC-09BF-E108-25EA-09201F9FD194}"/>
          </ac:cxnSpMkLst>
        </pc:cxnChg>
        <pc:cxnChg chg="mod">
          <ac:chgData name="JESÚS ANTONIO  GÓMEZ OCHOA DE ALDA" userId="111346b4-2c77-4688-bb93-b1ed5af05578" providerId="ADAL" clId="{E7166595-32BD-4204-AE7A-BFD050581266}" dt="2023-03-14T19:16:46.606" v="2561" actId="1036"/>
          <ac:cxnSpMkLst>
            <pc:docMk/>
            <pc:sldMk cId="1785560441" sldId="256"/>
            <ac:cxnSpMk id="74" creationId="{8C262BFD-8C13-838B-A5A8-358D48EC5513}"/>
          </ac:cxnSpMkLst>
        </pc:cxnChg>
        <pc:cxnChg chg="mod">
          <ac:chgData name="JESÚS ANTONIO  GÓMEZ OCHOA DE ALDA" userId="111346b4-2c77-4688-bb93-b1ed5af05578" providerId="ADAL" clId="{E7166595-32BD-4204-AE7A-BFD050581266}" dt="2023-03-14T19:16:40.773" v="2558" actId="1036"/>
          <ac:cxnSpMkLst>
            <pc:docMk/>
            <pc:sldMk cId="1785560441" sldId="256"/>
            <ac:cxnSpMk id="75" creationId="{F106FBFB-9BCB-BE2D-8554-CD6963D5AF05}"/>
          </ac:cxnSpMkLst>
        </pc:cxnChg>
      </pc:sldChg>
      <pc:sldChg chg="addSp delSp modSp new del mod">
        <pc:chgData name="JESÚS ANTONIO  GÓMEZ OCHOA DE ALDA" userId="111346b4-2c77-4688-bb93-b1ed5af05578" providerId="ADAL" clId="{E7166595-32BD-4204-AE7A-BFD050581266}" dt="2023-03-13T14:41:51.826" v="298" actId="47"/>
        <pc:sldMkLst>
          <pc:docMk/>
          <pc:sldMk cId="2964979705" sldId="257"/>
        </pc:sldMkLst>
        <pc:spChg chg="add del">
          <ac:chgData name="JESÚS ANTONIO  GÓMEZ OCHOA DE ALDA" userId="111346b4-2c77-4688-bb93-b1ed5af05578" providerId="ADAL" clId="{E7166595-32BD-4204-AE7A-BFD050581266}" dt="2023-03-13T14:40:46.029" v="295" actId="931"/>
          <ac:spMkLst>
            <pc:docMk/>
            <pc:sldMk cId="2964979705" sldId="257"/>
            <ac:spMk id="3" creationId="{90DE77A1-1C2D-A0DD-F8AB-E4CE9CEAA4C7}"/>
          </ac:spMkLst>
        </pc:spChg>
        <pc:spChg chg="add del">
          <ac:chgData name="JESÚS ANTONIO  GÓMEZ OCHOA DE ALDA" userId="111346b4-2c77-4688-bb93-b1ed5af05578" providerId="ADAL" clId="{E7166595-32BD-4204-AE7A-BFD050581266}" dt="2023-03-13T14:41:49.555" v="297" actId="22"/>
          <ac:spMkLst>
            <pc:docMk/>
            <pc:sldMk cId="2964979705" sldId="257"/>
            <ac:spMk id="7" creationId="{FE349F55-4294-501B-5DDC-4A2091D45EB4}"/>
          </ac:spMkLst>
        </pc:spChg>
        <pc:picChg chg="add del mod">
          <ac:chgData name="JESÚS ANTONIO  GÓMEZ OCHOA DE ALDA" userId="111346b4-2c77-4688-bb93-b1ed5af05578" providerId="ADAL" clId="{E7166595-32BD-4204-AE7A-BFD050581266}" dt="2023-03-13T14:40:46.029" v="295" actId="931"/>
          <ac:picMkLst>
            <pc:docMk/>
            <pc:sldMk cId="2964979705" sldId="257"/>
            <ac:picMk id="5" creationId="{B300D771-B29B-E9A1-A637-02F3F01DEEE2}"/>
          </ac:picMkLst>
        </pc:picChg>
      </pc:sldChg>
      <pc:sldChg chg="addSp delSp modSp new del mod">
        <pc:chgData name="JESÚS ANTONIO  GÓMEZ OCHOA DE ALDA" userId="111346b4-2c77-4688-bb93-b1ed5af05578" providerId="ADAL" clId="{E7166595-32BD-4204-AE7A-BFD050581266}" dt="2023-03-15T15:10:33.267" v="2872" actId="47"/>
        <pc:sldMkLst>
          <pc:docMk/>
          <pc:sldMk cId="4106376102" sldId="257"/>
        </pc:sldMkLst>
        <pc:spChg chg="del">
          <ac:chgData name="JESÚS ANTONIO  GÓMEZ OCHOA DE ALDA" userId="111346b4-2c77-4688-bb93-b1ed5af05578" providerId="ADAL" clId="{E7166595-32BD-4204-AE7A-BFD050581266}" dt="2023-03-14T17:29:06.797" v="368" actId="478"/>
          <ac:spMkLst>
            <pc:docMk/>
            <pc:sldMk cId="4106376102" sldId="257"/>
            <ac:spMk id="2" creationId="{252188C1-480F-550F-BA0D-ABAA403D7514}"/>
          </ac:spMkLst>
        </pc:spChg>
        <pc:spChg chg="del mod">
          <ac:chgData name="JESÚS ANTONIO  GÓMEZ OCHOA DE ALDA" userId="111346b4-2c77-4688-bb93-b1ed5af05578" providerId="ADAL" clId="{E7166595-32BD-4204-AE7A-BFD050581266}" dt="2023-03-14T17:29:08.571" v="369" actId="478"/>
          <ac:spMkLst>
            <pc:docMk/>
            <pc:sldMk cId="4106376102" sldId="257"/>
            <ac:spMk id="3" creationId="{1FD2D45F-7F07-2AFD-DED4-AF4164F2C4AA}"/>
          </ac:spMkLst>
        </pc:spChg>
        <pc:picChg chg="add mod">
          <ac:chgData name="JESÚS ANTONIO  GÓMEZ OCHOA DE ALDA" userId="111346b4-2c77-4688-bb93-b1ed5af05578" providerId="ADAL" clId="{E7166595-32BD-4204-AE7A-BFD050581266}" dt="2023-03-14T17:29:26.745" v="370" actId="1076"/>
          <ac:picMkLst>
            <pc:docMk/>
            <pc:sldMk cId="4106376102" sldId="257"/>
            <ac:picMk id="4" creationId="{5B70F615-A699-E414-23EF-577165EA4D50}"/>
          </ac:picMkLst>
        </pc:picChg>
        <pc:picChg chg="add mod">
          <ac:chgData name="JESÚS ANTONIO  GÓMEZ OCHOA DE ALDA" userId="111346b4-2c77-4688-bb93-b1ed5af05578" providerId="ADAL" clId="{E7166595-32BD-4204-AE7A-BFD050581266}" dt="2023-03-14T17:29:28.420" v="371" actId="1076"/>
          <ac:picMkLst>
            <pc:docMk/>
            <pc:sldMk cId="4106376102" sldId="257"/>
            <ac:picMk id="5" creationId="{EAE7AD13-584A-9566-4E09-F7BE6BE40BED}"/>
          </ac:picMkLst>
        </pc:picChg>
        <pc:picChg chg="add mod">
          <ac:chgData name="JESÚS ANTONIO  GÓMEZ OCHOA DE ALDA" userId="111346b4-2c77-4688-bb93-b1ed5af05578" providerId="ADAL" clId="{E7166595-32BD-4204-AE7A-BFD050581266}" dt="2023-03-14T17:29:46.917" v="376" actId="1076"/>
          <ac:picMkLst>
            <pc:docMk/>
            <pc:sldMk cId="4106376102" sldId="257"/>
            <ac:picMk id="6" creationId="{70E278B5-7887-D9A3-6705-30BBCDAFD322}"/>
          </ac:picMkLst>
        </pc:picChg>
      </pc:sldChg>
      <pc:sldChg chg="addSp delSp modSp new del mod">
        <pc:chgData name="JESÚS ANTONIO  GÓMEZ OCHOA DE ALDA" userId="111346b4-2c77-4688-bb93-b1ed5af05578" providerId="ADAL" clId="{E7166595-32BD-4204-AE7A-BFD050581266}" dt="2023-03-15T15:10:35.243" v="2873" actId="47"/>
        <pc:sldMkLst>
          <pc:docMk/>
          <pc:sldMk cId="2164923562" sldId="258"/>
        </pc:sldMkLst>
        <pc:spChg chg="del">
          <ac:chgData name="JESÚS ANTONIO  GÓMEZ OCHOA DE ALDA" userId="111346b4-2c77-4688-bb93-b1ed5af05578" providerId="ADAL" clId="{E7166595-32BD-4204-AE7A-BFD050581266}" dt="2023-03-14T19:07:17.458" v="1772" actId="478"/>
          <ac:spMkLst>
            <pc:docMk/>
            <pc:sldMk cId="2164923562" sldId="258"/>
            <ac:spMk id="2" creationId="{312ABC1E-5045-F236-D326-09EDB43B4810}"/>
          </ac:spMkLst>
        </pc:spChg>
        <pc:spChg chg="del">
          <ac:chgData name="JESÚS ANTONIO  GÓMEZ OCHOA DE ALDA" userId="111346b4-2c77-4688-bb93-b1ed5af05578" providerId="ADAL" clId="{E7166595-32BD-4204-AE7A-BFD050581266}" dt="2023-03-14T19:07:17.458" v="1772" actId="478"/>
          <ac:spMkLst>
            <pc:docMk/>
            <pc:sldMk cId="2164923562" sldId="258"/>
            <ac:spMk id="3" creationId="{04E34E21-AAF9-2A51-7955-76B79CBAD538}"/>
          </ac:spMkLst>
        </pc:spChg>
        <pc:graphicFrameChg chg="add mod">
          <ac:chgData name="JESÚS ANTONIO  GÓMEZ OCHOA DE ALDA" userId="111346b4-2c77-4688-bb93-b1ed5af05578" providerId="ADAL" clId="{E7166595-32BD-4204-AE7A-BFD050581266}" dt="2023-03-14T19:07:36.646" v="1778"/>
          <ac:graphicFrameMkLst>
            <pc:docMk/>
            <pc:sldMk cId="2164923562" sldId="258"/>
            <ac:graphicFrameMk id="4" creationId="{3A101701-E0EA-3B34-15AF-24AEC949784F}"/>
          </ac:graphicFrameMkLst>
        </pc:graphicFrameChg>
      </pc:sldChg>
    </pc:docChg>
  </pc:docChgLst>
  <pc:docChgLst>
    <pc:chgData name="JESÚS ANTONIO  GÓMEZ OCHOA DE ALDA" userId="111346b4-2c77-4688-bb93-b1ed5af05578" providerId="ADAL" clId="{E839ED6B-F7FD-7F48-8B72-2A69C700E3B7}"/>
    <pc:docChg chg="undo redo custSel modSld">
      <pc:chgData name="JESÚS ANTONIO  GÓMEZ OCHOA DE ALDA" userId="111346b4-2c77-4688-bb93-b1ed5af05578" providerId="ADAL" clId="{E839ED6B-F7FD-7F48-8B72-2A69C700E3B7}" dt="2023-03-15T13:12:31.784" v="2197" actId="1076"/>
      <pc:docMkLst>
        <pc:docMk/>
      </pc:docMkLst>
      <pc:sldChg chg="addSp delSp modSp mod">
        <pc:chgData name="JESÚS ANTONIO  GÓMEZ OCHOA DE ALDA" userId="111346b4-2c77-4688-bb93-b1ed5af05578" providerId="ADAL" clId="{E839ED6B-F7FD-7F48-8B72-2A69C700E3B7}" dt="2023-03-15T13:12:31.784" v="2197" actId="1076"/>
        <pc:sldMkLst>
          <pc:docMk/>
          <pc:sldMk cId="1785560441" sldId="256"/>
        </pc:sldMkLst>
        <pc:spChg chg="mod">
          <ac:chgData name="JESÚS ANTONIO  GÓMEZ OCHOA DE ALDA" userId="111346b4-2c77-4688-bb93-b1ed5af05578" providerId="ADAL" clId="{E839ED6B-F7FD-7F48-8B72-2A69C700E3B7}" dt="2023-03-15T10:23:18.040" v="1798" actId="1076"/>
          <ac:spMkLst>
            <pc:docMk/>
            <pc:sldMk cId="1785560441" sldId="256"/>
            <ac:spMk id="2" creationId="{3814B44B-9C7F-4FC3-DBF4-72A3F9A0D33F}"/>
          </ac:spMkLst>
        </pc:spChg>
        <pc:spChg chg="mod">
          <ac:chgData name="JESÚS ANTONIO  GÓMEZ OCHOA DE ALDA" userId="111346b4-2c77-4688-bb93-b1ed5af05578" providerId="ADAL" clId="{E839ED6B-F7FD-7F48-8B72-2A69C700E3B7}" dt="2023-03-15T11:34:48.953" v="2092" actId="166"/>
          <ac:spMkLst>
            <pc:docMk/>
            <pc:sldMk cId="1785560441" sldId="256"/>
            <ac:spMk id="3" creationId="{39EF1756-DDC6-D559-0E19-B9593804957C}"/>
          </ac:spMkLst>
        </pc:spChg>
        <pc:spChg chg="mod">
          <ac:chgData name="JESÚS ANTONIO  GÓMEZ OCHOA DE ALDA" userId="111346b4-2c77-4688-bb93-b1ed5af05578" providerId="ADAL" clId="{E839ED6B-F7FD-7F48-8B72-2A69C700E3B7}" dt="2023-03-15T11:33:40.914" v="2082" actId="166"/>
          <ac:spMkLst>
            <pc:docMk/>
            <pc:sldMk cId="1785560441" sldId="256"/>
            <ac:spMk id="8" creationId="{17843040-94AB-880F-9C89-AB7696F1944C}"/>
          </ac:spMkLst>
        </pc:spChg>
        <pc:spChg chg="mod">
          <ac:chgData name="JESÚS ANTONIO  GÓMEZ OCHOA DE ALDA" userId="111346b4-2c77-4688-bb93-b1ed5af05578" providerId="ADAL" clId="{E839ED6B-F7FD-7F48-8B72-2A69C700E3B7}" dt="2023-03-15T11:33:59.785" v="2083" actId="166"/>
          <ac:spMkLst>
            <pc:docMk/>
            <pc:sldMk cId="1785560441" sldId="256"/>
            <ac:spMk id="9" creationId="{E94FB839-DBAC-D065-408E-F4E773DD39C5}"/>
          </ac:spMkLst>
        </pc:spChg>
        <pc:spChg chg="mod">
          <ac:chgData name="JESÚS ANTONIO  GÓMEZ OCHOA DE ALDA" userId="111346b4-2c77-4688-bb93-b1ed5af05578" providerId="ADAL" clId="{E839ED6B-F7FD-7F48-8B72-2A69C700E3B7}" dt="2023-03-15T11:33:40.914" v="2082" actId="166"/>
          <ac:spMkLst>
            <pc:docMk/>
            <pc:sldMk cId="1785560441" sldId="256"/>
            <ac:spMk id="10" creationId="{FFB52DBD-C116-B296-5E60-721A39CC4067}"/>
          </ac:spMkLst>
        </pc:spChg>
        <pc:spChg chg="mod">
          <ac:chgData name="JESÚS ANTONIO  GÓMEZ OCHOA DE ALDA" userId="111346b4-2c77-4688-bb93-b1ed5af05578" providerId="ADAL" clId="{E839ED6B-F7FD-7F48-8B72-2A69C700E3B7}" dt="2023-03-15T11:33:40.914" v="2082" actId="166"/>
          <ac:spMkLst>
            <pc:docMk/>
            <pc:sldMk cId="1785560441" sldId="256"/>
            <ac:spMk id="11" creationId="{3C401836-077E-FBCA-852A-A7F8E96109AA}"/>
          </ac:spMkLst>
        </pc:spChg>
        <pc:spChg chg="mod">
          <ac:chgData name="JESÚS ANTONIO  GÓMEZ OCHOA DE ALDA" userId="111346b4-2c77-4688-bb93-b1ed5af05578" providerId="ADAL" clId="{E839ED6B-F7FD-7F48-8B72-2A69C700E3B7}" dt="2023-03-15T11:33:40.914" v="2082" actId="166"/>
          <ac:spMkLst>
            <pc:docMk/>
            <pc:sldMk cId="1785560441" sldId="256"/>
            <ac:spMk id="12" creationId="{D1C2516E-A669-2895-6EAD-75EAB7B28E1A}"/>
          </ac:spMkLst>
        </pc:spChg>
        <pc:spChg chg="mod">
          <ac:chgData name="JESÚS ANTONIO  GÓMEZ OCHOA DE ALDA" userId="111346b4-2c77-4688-bb93-b1ed5af05578" providerId="ADAL" clId="{E839ED6B-F7FD-7F48-8B72-2A69C700E3B7}" dt="2023-03-15T10:23:23.096" v="1799" actId="1076"/>
          <ac:spMkLst>
            <pc:docMk/>
            <pc:sldMk cId="1785560441" sldId="256"/>
            <ac:spMk id="16" creationId="{E586665B-80BC-7F59-9CB4-928D4D1DEC84}"/>
          </ac:spMkLst>
        </pc:spChg>
        <pc:spChg chg="mod">
          <ac:chgData name="JESÚS ANTONIO  GÓMEZ OCHOA DE ALDA" userId="111346b4-2c77-4688-bb93-b1ed5af05578" providerId="ADAL" clId="{E839ED6B-F7FD-7F48-8B72-2A69C700E3B7}" dt="2023-03-15T10:09:41.842" v="755" actId="207"/>
          <ac:spMkLst>
            <pc:docMk/>
            <pc:sldMk cId="1785560441" sldId="256"/>
            <ac:spMk id="18" creationId="{1240CB60-24EE-5862-D362-5611E70FD267}"/>
          </ac:spMkLst>
        </pc:spChg>
        <pc:spChg chg="mod">
          <ac:chgData name="JESÚS ANTONIO  GÓMEZ OCHOA DE ALDA" userId="111346b4-2c77-4688-bb93-b1ed5af05578" providerId="ADAL" clId="{E839ED6B-F7FD-7F48-8B72-2A69C700E3B7}" dt="2023-03-15T10:09:41.842" v="755" actId="207"/>
          <ac:spMkLst>
            <pc:docMk/>
            <pc:sldMk cId="1785560441" sldId="256"/>
            <ac:spMk id="19" creationId="{B001D14E-0ECC-ECC5-2602-FFC8F48B1868}"/>
          </ac:spMkLst>
        </pc:spChg>
        <pc:spChg chg="mod">
          <ac:chgData name="JESÚS ANTONIO  GÓMEZ OCHOA DE ALDA" userId="111346b4-2c77-4688-bb93-b1ed5af05578" providerId="ADAL" clId="{E839ED6B-F7FD-7F48-8B72-2A69C700E3B7}" dt="2023-03-15T10:09:41.842" v="755" actId="207"/>
          <ac:spMkLst>
            <pc:docMk/>
            <pc:sldMk cId="1785560441" sldId="256"/>
            <ac:spMk id="20" creationId="{E9E2F824-F1A9-5D5F-AFF8-E9DCC358BC58}"/>
          </ac:spMkLst>
        </pc:spChg>
        <pc:spChg chg="mod">
          <ac:chgData name="JESÚS ANTONIO  GÓMEZ OCHOA DE ALDA" userId="111346b4-2c77-4688-bb93-b1ed5af05578" providerId="ADAL" clId="{E839ED6B-F7FD-7F48-8B72-2A69C700E3B7}" dt="2023-03-15T10:09:41.842" v="755" actId="207"/>
          <ac:spMkLst>
            <pc:docMk/>
            <pc:sldMk cId="1785560441" sldId="256"/>
            <ac:spMk id="21" creationId="{597497AC-DC58-3DF8-76FB-B07187BB51FA}"/>
          </ac:spMkLst>
        </pc:spChg>
        <pc:spChg chg="mod">
          <ac:chgData name="JESÚS ANTONIO  GÓMEZ OCHOA DE ALDA" userId="111346b4-2c77-4688-bb93-b1ed5af05578" providerId="ADAL" clId="{E839ED6B-F7FD-7F48-8B72-2A69C700E3B7}" dt="2023-03-15T10:09:41.842" v="755" actId="207"/>
          <ac:spMkLst>
            <pc:docMk/>
            <pc:sldMk cId="1785560441" sldId="256"/>
            <ac:spMk id="22" creationId="{9AE36A53-2426-2961-9D0E-829D24562E5C}"/>
          </ac:spMkLst>
        </pc:spChg>
        <pc:spChg chg="mod">
          <ac:chgData name="JESÚS ANTONIO  GÓMEZ OCHOA DE ALDA" userId="111346b4-2c77-4688-bb93-b1ed5af05578" providerId="ADAL" clId="{E839ED6B-F7FD-7F48-8B72-2A69C700E3B7}" dt="2023-03-15T10:09:41.842" v="755" actId="207"/>
          <ac:spMkLst>
            <pc:docMk/>
            <pc:sldMk cId="1785560441" sldId="256"/>
            <ac:spMk id="23" creationId="{9F9616BB-10AD-52D9-E26A-CB6D6582E745}"/>
          </ac:spMkLst>
        </pc:spChg>
        <pc:spChg chg="mod">
          <ac:chgData name="JESÚS ANTONIO  GÓMEZ OCHOA DE ALDA" userId="111346b4-2c77-4688-bb93-b1ed5af05578" providerId="ADAL" clId="{E839ED6B-F7FD-7F48-8B72-2A69C700E3B7}" dt="2023-03-15T10:18:33.946" v="1582" actId="1076"/>
          <ac:spMkLst>
            <pc:docMk/>
            <pc:sldMk cId="1785560441" sldId="256"/>
            <ac:spMk id="24" creationId="{73909222-B00F-33D3-B9F0-A061DB47F212}"/>
          </ac:spMkLst>
        </pc:spChg>
        <pc:spChg chg="add del mod">
          <ac:chgData name="JESÚS ANTONIO  GÓMEZ OCHOA DE ALDA" userId="111346b4-2c77-4688-bb93-b1ed5af05578" providerId="ADAL" clId="{E839ED6B-F7FD-7F48-8B72-2A69C700E3B7}" dt="2023-03-13T16:49:17.696" v="63" actId="1035"/>
          <ac:spMkLst>
            <pc:docMk/>
            <pc:sldMk cId="1785560441" sldId="256"/>
            <ac:spMk id="33" creationId="{82EE7072-FF7E-0AA6-1BF8-05C7772E492E}"/>
          </ac:spMkLst>
        </pc:spChg>
        <pc:spChg chg="mod">
          <ac:chgData name="JESÚS ANTONIO  GÓMEZ OCHOA DE ALDA" userId="111346b4-2c77-4688-bb93-b1ed5af05578" providerId="ADAL" clId="{E839ED6B-F7FD-7F48-8B72-2A69C700E3B7}" dt="2023-03-13T16:49:04.069" v="53" actId="1036"/>
          <ac:spMkLst>
            <pc:docMk/>
            <pc:sldMk cId="1785560441" sldId="256"/>
            <ac:spMk id="35" creationId="{289B8BEE-8A2E-E085-F947-10DE8C28E38D}"/>
          </ac:spMkLst>
        </pc:spChg>
        <pc:spChg chg="mod">
          <ac:chgData name="JESÚS ANTONIO  GÓMEZ OCHOA DE ALDA" userId="111346b4-2c77-4688-bb93-b1ed5af05578" providerId="ADAL" clId="{E839ED6B-F7FD-7F48-8B72-2A69C700E3B7}" dt="2023-03-13T16:52:09.005" v="429" actId="1036"/>
          <ac:spMkLst>
            <pc:docMk/>
            <pc:sldMk cId="1785560441" sldId="256"/>
            <ac:spMk id="51" creationId="{ECBB220A-994E-F9F7-F247-999B9B49A88E}"/>
          </ac:spMkLst>
        </pc:spChg>
        <pc:spChg chg="mod">
          <ac:chgData name="JESÚS ANTONIO  GÓMEZ OCHOA DE ALDA" userId="111346b4-2c77-4688-bb93-b1ed5af05578" providerId="ADAL" clId="{E839ED6B-F7FD-7F48-8B72-2A69C700E3B7}" dt="2023-03-15T10:04:42.243" v="730" actId="207"/>
          <ac:spMkLst>
            <pc:docMk/>
            <pc:sldMk cId="1785560441" sldId="256"/>
            <ac:spMk id="55" creationId="{DD24EDFD-54DD-9CAC-8706-8127344D0F73}"/>
          </ac:spMkLst>
        </pc:spChg>
        <pc:spChg chg="mod">
          <ac:chgData name="JESÚS ANTONIO  GÓMEZ OCHOA DE ALDA" userId="111346b4-2c77-4688-bb93-b1ed5af05578" providerId="ADAL" clId="{E839ED6B-F7FD-7F48-8B72-2A69C700E3B7}" dt="2023-03-15T10:23:27.353" v="1800" actId="1076"/>
          <ac:spMkLst>
            <pc:docMk/>
            <pc:sldMk cId="1785560441" sldId="256"/>
            <ac:spMk id="58" creationId="{ED0227CF-8EAB-2235-5DB9-AD235D24FE42}"/>
          </ac:spMkLst>
        </pc:spChg>
        <pc:spChg chg="mod">
          <ac:chgData name="JESÚS ANTONIO  GÓMEZ OCHOA DE ALDA" userId="111346b4-2c77-4688-bb93-b1ed5af05578" providerId="ADAL" clId="{E839ED6B-F7FD-7F48-8B72-2A69C700E3B7}" dt="2023-03-15T10:04:42.243" v="730" actId="207"/>
          <ac:spMkLst>
            <pc:docMk/>
            <pc:sldMk cId="1785560441" sldId="256"/>
            <ac:spMk id="60" creationId="{86455DE6-075D-A9A5-EEA9-85290443740C}"/>
          </ac:spMkLst>
        </pc:spChg>
        <pc:spChg chg="mod">
          <ac:chgData name="JESÚS ANTONIO  GÓMEZ OCHOA DE ALDA" userId="111346b4-2c77-4688-bb93-b1ed5af05578" providerId="ADAL" clId="{E839ED6B-F7FD-7F48-8B72-2A69C700E3B7}" dt="2023-03-15T10:04:42.243" v="730" actId="207"/>
          <ac:spMkLst>
            <pc:docMk/>
            <pc:sldMk cId="1785560441" sldId="256"/>
            <ac:spMk id="64" creationId="{85FA41AE-76D1-A846-3F94-1A59D17F402D}"/>
          </ac:spMkLst>
        </pc:spChg>
        <pc:spChg chg="mod">
          <ac:chgData name="JESÚS ANTONIO  GÓMEZ OCHOA DE ALDA" userId="111346b4-2c77-4688-bb93-b1ed5af05578" providerId="ADAL" clId="{E839ED6B-F7FD-7F48-8B72-2A69C700E3B7}" dt="2023-03-15T11:35:03.999" v="2093" actId="166"/>
          <ac:spMkLst>
            <pc:docMk/>
            <pc:sldMk cId="1785560441" sldId="256"/>
            <ac:spMk id="66" creationId="{55D6D51C-01AA-2796-18DF-DC62936BA4A9}"/>
          </ac:spMkLst>
        </pc:spChg>
        <pc:spChg chg="mod">
          <ac:chgData name="JESÚS ANTONIO  GÓMEZ OCHOA DE ALDA" userId="111346b4-2c77-4688-bb93-b1ed5af05578" providerId="ADAL" clId="{E839ED6B-F7FD-7F48-8B72-2A69C700E3B7}" dt="2023-03-15T10:04:42.243" v="730" actId="207"/>
          <ac:spMkLst>
            <pc:docMk/>
            <pc:sldMk cId="1785560441" sldId="256"/>
            <ac:spMk id="67" creationId="{39BA3AA2-B526-28AD-1BED-571C91682EEA}"/>
          </ac:spMkLst>
        </pc:spChg>
        <pc:spChg chg="mod">
          <ac:chgData name="JESÚS ANTONIO  GÓMEZ OCHOA DE ALDA" userId="111346b4-2c77-4688-bb93-b1ed5af05578" providerId="ADAL" clId="{E839ED6B-F7FD-7F48-8B72-2A69C700E3B7}" dt="2023-03-15T10:04:42.243" v="730" actId="207"/>
          <ac:spMkLst>
            <pc:docMk/>
            <pc:sldMk cId="1785560441" sldId="256"/>
            <ac:spMk id="71" creationId="{294C8DA3-D3CD-B1C9-42BE-75CABC9C8BBE}"/>
          </ac:spMkLst>
        </pc:spChg>
        <pc:spChg chg="mod">
          <ac:chgData name="JESÚS ANTONIO  GÓMEZ OCHOA DE ALDA" userId="111346b4-2c77-4688-bb93-b1ed5af05578" providerId="ADAL" clId="{E839ED6B-F7FD-7F48-8B72-2A69C700E3B7}" dt="2023-03-15T10:04:42.243" v="730" actId="207"/>
          <ac:spMkLst>
            <pc:docMk/>
            <pc:sldMk cId="1785560441" sldId="256"/>
            <ac:spMk id="82" creationId="{9C39C3A6-BDB3-24CE-D6D1-224D581B80B3}"/>
          </ac:spMkLst>
        </pc:spChg>
        <pc:spChg chg="del">
          <ac:chgData name="JESÚS ANTONIO  GÓMEZ OCHOA DE ALDA" userId="111346b4-2c77-4688-bb93-b1ed5af05578" providerId="ADAL" clId="{E839ED6B-F7FD-7F48-8B72-2A69C700E3B7}" dt="2023-03-15T10:03:04.190" v="507" actId="478"/>
          <ac:spMkLst>
            <pc:docMk/>
            <pc:sldMk cId="1785560441" sldId="256"/>
            <ac:spMk id="83" creationId="{74931BDC-EF20-98FF-F6E1-5EFB7D76CC4D}"/>
          </ac:spMkLst>
        </pc:spChg>
        <pc:spChg chg="add del mod">
          <ac:chgData name="JESÚS ANTONIO  GÓMEZ OCHOA DE ALDA" userId="111346b4-2c77-4688-bb93-b1ed5af05578" providerId="ADAL" clId="{E839ED6B-F7FD-7F48-8B72-2A69C700E3B7}" dt="2023-03-15T10:17:07.112" v="1519" actId="478"/>
          <ac:spMkLst>
            <pc:docMk/>
            <pc:sldMk cId="1785560441" sldId="256"/>
            <ac:spMk id="86" creationId="{BD85DF40-7ACC-5D02-2468-8093ABDC7FC3}"/>
          </ac:spMkLst>
        </pc:spChg>
        <pc:spChg chg="add mod">
          <ac:chgData name="JESÚS ANTONIO  GÓMEZ OCHOA DE ALDA" userId="111346b4-2c77-4688-bb93-b1ed5af05578" providerId="ADAL" clId="{E839ED6B-F7FD-7F48-8B72-2A69C700E3B7}" dt="2023-03-15T10:16:37.040" v="1386" actId="1037"/>
          <ac:spMkLst>
            <pc:docMk/>
            <pc:sldMk cId="1785560441" sldId="256"/>
            <ac:spMk id="87" creationId="{6CB9BB00-8260-321C-3BD1-81F3D6AFCD10}"/>
          </ac:spMkLst>
        </pc:spChg>
        <pc:spChg chg="mod">
          <ac:chgData name="JESÚS ANTONIO  GÓMEZ OCHOA DE ALDA" userId="111346b4-2c77-4688-bb93-b1ed5af05578" providerId="ADAL" clId="{E839ED6B-F7FD-7F48-8B72-2A69C700E3B7}" dt="2023-03-15T10:13:26.440" v="845"/>
          <ac:spMkLst>
            <pc:docMk/>
            <pc:sldMk cId="1785560441" sldId="256"/>
            <ac:spMk id="89" creationId="{D3F1F90B-1CED-9DBD-053C-B537DC8C8AFD}"/>
          </ac:spMkLst>
        </pc:spChg>
        <pc:spChg chg="mod">
          <ac:chgData name="JESÚS ANTONIO  GÓMEZ OCHOA DE ALDA" userId="111346b4-2c77-4688-bb93-b1ed5af05578" providerId="ADAL" clId="{E839ED6B-F7FD-7F48-8B72-2A69C700E3B7}" dt="2023-03-15T10:13:26.440" v="845"/>
          <ac:spMkLst>
            <pc:docMk/>
            <pc:sldMk cId="1785560441" sldId="256"/>
            <ac:spMk id="90" creationId="{71426B1E-8DC9-35EC-7A8B-6F912EFD85C7}"/>
          </ac:spMkLst>
        </pc:spChg>
        <pc:spChg chg="mod">
          <ac:chgData name="JESÚS ANTONIO  GÓMEZ OCHOA DE ALDA" userId="111346b4-2c77-4688-bb93-b1ed5af05578" providerId="ADAL" clId="{E839ED6B-F7FD-7F48-8B72-2A69C700E3B7}" dt="2023-03-15T10:13:26.440" v="845"/>
          <ac:spMkLst>
            <pc:docMk/>
            <pc:sldMk cId="1785560441" sldId="256"/>
            <ac:spMk id="91" creationId="{583BE4DF-E4A3-5ED8-5D96-D6B63FBDFA1F}"/>
          </ac:spMkLst>
        </pc:spChg>
        <pc:spChg chg="mod">
          <ac:chgData name="JESÚS ANTONIO  GÓMEZ OCHOA DE ALDA" userId="111346b4-2c77-4688-bb93-b1ed5af05578" providerId="ADAL" clId="{E839ED6B-F7FD-7F48-8B72-2A69C700E3B7}" dt="2023-03-15T10:13:26.440" v="845"/>
          <ac:spMkLst>
            <pc:docMk/>
            <pc:sldMk cId="1785560441" sldId="256"/>
            <ac:spMk id="92" creationId="{2716F3EF-92AE-EDF0-6529-0CD850C8F5AC}"/>
          </ac:spMkLst>
        </pc:spChg>
        <pc:spChg chg="mod">
          <ac:chgData name="JESÚS ANTONIO  GÓMEZ OCHOA DE ALDA" userId="111346b4-2c77-4688-bb93-b1ed5af05578" providerId="ADAL" clId="{E839ED6B-F7FD-7F48-8B72-2A69C700E3B7}" dt="2023-03-15T10:13:26.440" v="845"/>
          <ac:spMkLst>
            <pc:docMk/>
            <pc:sldMk cId="1785560441" sldId="256"/>
            <ac:spMk id="93" creationId="{8BA907D0-FBEF-49D7-A99D-F2F02E3C3D64}"/>
          </ac:spMkLst>
        </pc:spChg>
        <pc:spChg chg="mod">
          <ac:chgData name="JESÚS ANTONIO  GÓMEZ OCHOA DE ALDA" userId="111346b4-2c77-4688-bb93-b1ed5af05578" providerId="ADAL" clId="{E839ED6B-F7FD-7F48-8B72-2A69C700E3B7}" dt="2023-03-15T10:13:26.440" v="845"/>
          <ac:spMkLst>
            <pc:docMk/>
            <pc:sldMk cId="1785560441" sldId="256"/>
            <ac:spMk id="94" creationId="{9F28CACB-D08F-A3B1-8C3E-CFA2C3A49B46}"/>
          </ac:spMkLst>
        </pc:spChg>
        <pc:spChg chg="add mod">
          <ac:chgData name="JESÚS ANTONIO  GÓMEZ OCHOA DE ALDA" userId="111346b4-2c77-4688-bb93-b1ed5af05578" providerId="ADAL" clId="{E839ED6B-F7FD-7F48-8B72-2A69C700E3B7}" dt="2023-03-15T10:15:44.992" v="1254" actId="1037"/>
          <ac:spMkLst>
            <pc:docMk/>
            <pc:sldMk cId="1785560441" sldId="256"/>
            <ac:spMk id="111" creationId="{E16F70C8-1927-9322-52DC-FE02849473A8}"/>
          </ac:spMkLst>
        </pc:spChg>
        <pc:spChg chg="add mod">
          <ac:chgData name="JESÚS ANTONIO  GÓMEZ OCHOA DE ALDA" userId="111346b4-2c77-4688-bb93-b1ed5af05578" providerId="ADAL" clId="{E839ED6B-F7FD-7F48-8B72-2A69C700E3B7}" dt="2023-03-15T10:17:39.081" v="1525" actId="1036"/>
          <ac:spMkLst>
            <pc:docMk/>
            <pc:sldMk cId="1785560441" sldId="256"/>
            <ac:spMk id="112" creationId="{7AE13DF0-CFE5-FA0C-3737-C2F275612DFB}"/>
          </ac:spMkLst>
        </pc:spChg>
        <pc:spChg chg="add mod">
          <ac:chgData name="JESÚS ANTONIO  GÓMEZ OCHOA DE ALDA" userId="111346b4-2c77-4688-bb93-b1ed5af05578" providerId="ADAL" clId="{E839ED6B-F7FD-7F48-8B72-2A69C700E3B7}" dt="2023-03-15T10:18:41.642" v="1584" actId="1076"/>
          <ac:spMkLst>
            <pc:docMk/>
            <pc:sldMk cId="1785560441" sldId="256"/>
            <ac:spMk id="113" creationId="{9011EC6B-2213-6DE0-7D6B-2F3CAB3962C8}"/>
          </ac:spMkLst>
        </pc:spChg>
        <pc:spChg chg="add mod">
          <ac:chgData name="JESÚS ANTONIO  GÓMEZ OCHOA DE ALDA" userId="111346b4-2c77-4688-bb93-b1ed5af05578" providerId="ADAL" clId="{E839ED6B-F7FD-7F48-8B72-2A69C700E3B7}" dt="2023-03-15T11:28:05.530" v="2043" actId="166"/>
          <ac:spMkLst>
            <pc:docMk/>
            <pc:sldMk cId="1785560441" sldId="256"/>
            <ac:spMk id="114" creationId="{2BE88C00-6B8E-FF97-9EA1-C9EB9E2F5AD1}"/>
          </ac:spMkLst>
        </pc:spChg>
        <pc:spChg chg="add mod">
          <ac:chgData name="JESÚS ANTONIO  GÓMEZ OCHOA DE ALDA" userId="111346b4-2c77-4688-bb93-b1ed5af05578" providerId="ADAL" clId="{E839ED6B-F7FD-7F48-8B72-2A69C700E3B7}" dt="2023-03-15T11:28:34.002" v="2053" actId="1038"/>
          <ac:spMkLst>
            <pc:docMk/>
            <pc:sldMk cId="1785560441" sldId="256"/>
            <ac:spMk id="115" creationId="{3F3BEBBC-529D-6ACF-FADE-677160C9C9D7}"/>
          </ac:spMkLst>
        </pc:spChg>
        <pc:spChg chg="add mod">
          <ac:chgData name="JESÚS ANTONIO  GÓMEZ OCHOA DE ALDA" userId="111346b4-2c77-4688-bb93-b1ed5af05578" providerId="ADAL" clId="{E839ED6B-F7FD-7F48-8B72-2A69C700E3B7}" dt="2023-03-15T11:28:31.817" v="2052" actId="1038"/>
          <ac:spMkLst>
            <pc:docMk/>
            <pc:sldMk cId="1785560441" sldId="256"/>
            <ac:spMk id="116" creationId="{32A4D2E9-F7BA-7051-E3B8-31B311F48C52}"/>
          </ac:spMkLst>
        </pc:spChg>
        <pc:spChg chg="add mod">
          <ac:chgData name="JESÚS ANTONIO  GÓMEZ OCHOA DE ALDA" userId="111346b4-2c77-4688-bb93-b1ed5af05578" providerId="ADAL" clId="{E839ED6B-F7FD-7F48-8B72-2A69C700E3B7}" dt="2023-03-15T11:28:05.530" v="2043" actId="166"/>
          <ac:spMkLst>
            <pc:docMk/>
            <pc:sldMk cId="1785560441" sldId="256"/>
            <ac:spMk id="117" creationId="{7721CCC2-2CE8-6F9B-54E2-D12C9AA596F3}"/>
          </ac:spMkLst>
        </pc:spChg>
        <pc:spChg chg="add mod">
          <ac:chgData name="JESÚS ANTONIO  GÓMEZ OCHOA DE ALDA" userId="111346b4-2c77-4688-bb93-b1ed5af05578" providerId="ADAL" clId="{E839ED6B-F7FD-7F48-8B72-2A69C700E3B7}" dt="2023-03-15T11:28:26.217" v="2049" actId="1038"/>
          <ac:spMkLst>
            <pc:docMk/>
            <pc:sldMk cId="1785560441" sldId="256"/>
            <ac:spMk id="118" creationId="{D5CE85FA-BDD3-DADC-3006-9BB140F43283}"/>
          </ac:spMkLst>
        </pc:spChg>
        <pc:spChg chg="add mod">
          <ac:chgData name="JESÚS ANTONIO  GÓMEZ OCHOA DE ALDA" userId="111346b4-2c77-4688-bb93-b1ed5af05578" providerId="ADAL" clId="{E839ED6B-F7FD-7F48-8B72-2A69C700E3B7}" dt="2023-03-15T11:28:14.891" v="2046" actId="1038"/>
          <ac:spMkLst>
            <pc:docMk/>
            <pc:sldMk cId="1785560441" sldId="256"/>
            <ac:spMk id="119" creationId="{1D9C9BF4-5C42-4243-1D12-FB298BAC5B41}"/>
          </ac:spMkLst>
        </pc:spChg>
        <pc:spChg chg="add mod">
          <ac:chgData name="JESÚS ANTONIO  GÓMEZ OCHOA DE ALDA" userId="111346b4-2c77-4688-bb93-b1ed5af05578" providerId="ADAL" clId="{E839ED6B-F7FD-7F48-8B72-2A69C700E3B7}" dt="2023-03-15T10:22:10.077" v="1707" actId="20577"/>
          <ac:spMkLst>
            <pc:docMk/>
            <pc:sldMk cId="1785560441" sldId="256"/>
            <ac:spMk id="122" creationId="{45CB5B0C-4DFB-8545-A44F-F50604DEC04E}"/>
          </ac:spMkLst>
        </pc:spChg>
        <pc:spChg chg="add mod">
          <ac:chgData name="JESÚS ANTONIO  GÓMEZ OCHOA DE ALDA" userId="111346b4-2c77-4688-bb93-b1ed5af05578" providerId="ADAL" clId="{E839ED6B-F7FD-7F48-8B72-2A69C700E3B7}" dt="2023-03-15T10:22:36.243" v="1797" actId="20577"/>
          <ac:spMkLst>
            <pc:docMk/>
            <pc:sldMk cId="1785560441" sldId="256"/>
            <ac:spMk id="123" creationId="{1B2D8F19-09AA-DE18-2696-300DAA896F71}"/>
          </ac:spMkLst>
        </pc:spChg>
        <pc:spChg chg="add mod">
          <ac:chgData name="JESÚS ANTONIO  GÓMEZ OCHOA DE ALDA" userId="111346b4-2c77-4688-bb93-b1ed5af05578" providerId="ADAL" clId="{E839ED6B-F7FD-7F48-8B72-2A69C700E3B7}" dt="2023-03-15T11:14:17.937" v="1824" actId="1076"/>
          <ac:spMkLst>
            <pc:docMk/>
            <pc:sldMk cId="1785560441" sldId="256"/>
            <ac:spMk id="126" creationId="{FC8C91F3-4EA0-2F7C-87DB-A625DA124932}"/>
          </ac:spMkLst>
        </pc:spChg>
        <pc:spChg chg="add mod">
          <ac:chgData name="JESÚS ANTONIO  GÓMEZ OCHOA DE ALDA" userId="111346b4-2c77-4688-bb93-b1ed5af05578" providerId="ADAL" clId="{E839ED6B-F7FD-7F48-8B72-2A69C700E3B7}" dt="2023-03-15T11:14:31.609" v="1830" actId="20577"/>
          <ac:spMkLst>
            <pc:docMk/>
            <pc:sldMk cId="1785560441" sldId="256"/>
            <ac:spMk id="127" creationId="{262DDD2A-D169-1673-8D41-3E4582760910}"/>
          </ac:spMkLst>
        </pc:spChg>
        <pc:spChg chg="add mod">
          <ac:chgData name="JESÚS ANTONIO  GÓMEZ OCHOA DE ALDA" userId="111346b4-2c77-4688-bb93-b1ed5af05578" providerId="ADAL" clId="{E839ED6B-F7FD-7F48-8B72-2A69C700E3B7}" dt="2023-03-15T11:14:54.951" v="1837" actId="1038"/>
          <ac:spMkLst>
            <pc:docMk/>
            <pc:sldMk cId="1785560441" sldId="256"/>
            <ac:spMk id="128" creationId="{7FDE8402-2A1A-7C7A-7519-A0D695617686}"/>
          </ac:spMkLst>
        </pc:spChg>
        <pc:spChg chg="add del mod">
          <ac:chgData name="JESÚS ANTONIO  GÓMEZ OCHOA DE ALDA" userId="111346b4-2c77-4688-bb93-b1ed5af05578" providerId="ADAL" clId="{E839ED6B-F7FD-7F48-8B72-2A69C700E3B7}" dt="2023-03-15T11:20:30.080" v="1981"/>
          <ac:spMkLst>
            <pc:docMk/>
            <pc:sldMk cId="1785560441" sldId="256"/>
            <ac:spMk id="135" creationId="{E9AB3565-C8A0-2F6B-4A7B-AD12B2171331}"/>
          </ac:spMkLst>
        </pc:spChg>
        <pc:grpChg chg="del mod">
          <ac:chgData name="JESÚS ANTONIO  GÓMEZ OCHOA DE ALDA" userId="111346b4-2c77-4688-bb93-b1ed5af05578" providerId="ADAL" clId="{E839ED6B-F7FD-7F48-8B72-2A69C700E3B7}" dt="2023-03-15T10:11:30.489" v="804" actId="478"/>
          <ac:grpSpMkLst>
            <pc:docMk/>
            <pc:sldMk cId="1785560441" sldId="256"/>
            <ac:grpSpMk id="17" creationId="{D7E81A9F-D0BA-9F29-0453-09E385CFD287}"/>
          </ac:grpSpMkLst>
        </pc:grpChg>
        <pc:grpChg chg="add mod">
          <ac:chgData name="JESÚS ANTONIO  GÓMEZ OCHOA DE ALDA" userId="111346b4-2c77-4688-bb93-b1ed5af05578" providerId="ADAL" clId="{E839ED6B-F7FD-7F48-8B72-2A69C700E3B7}" dt="2023-03-15T10:18:00.509" v="1531" actId="1035"/>
          <ac:grpSpMkLst>
            <pc:docMk/>
            <pc:sldMk cId="1785560441" sldId="256"/>
            <ac:grpSpMk id="37" creationId="{F1F2726F-46DB-79A9-CD9E-801D2DB1908E}"/>
          </ac:grpSpMkLst>
        </pc:grpChg>
        <pc:grpChg chg="add del">
          <ac:chgData name="JESÚS ANTONIO  GÓMEZ OCHOA DE ALDA" userId="111346b4-2c77-4688-bb93-b1ed5af05578" providerId="ADAL" clId="{E839ED6B-F7FD-7F48-8B72-2A69C700E3B7}" dt="2023-03-15T11:31:38.696" v="2066" actId="478"/>
          <ac:grpSpMkLst>
            <pc:docMk/>
            <pc:sldMk cId="1785560441" sldId="256"/>
            <ac:grpSpMk id="45" creationId="{7C70597C-94F7-6EBA-D8EC-792EAE717099}"/>
          </ac:grpSpMkLst>
        </pc:grpChg>
        <pc:grpChg chg="del mod">
          <ac:chgData name="JESÚS ANTONIO  GÓMEZ OCHOA DE ALDA" userId="111346b4-2c77-4688-bb93-b1ed5af05578" providerId="ADAL" clId="{E839ED6B-F7FD-7F48-8B72-2A69C700E3B7}" dt="2023-03-15T10:11:37.035" v="805" actId="478"/>
          <ac:grpSpMkLst>
            <pc:docMk/>
            <pc:sldMk cId="1785560441" sldId="256"/>
            <ac:grpSpMk id="46" creationId="{6B8E5AA9-B55A-C942-C262-F6F4AF3B06A5}"/>
          </ac:grpSpMkLst>
        </pc:grpChg>
        <pc:grpChg chg="add mod">
          <ac:chgData name="JESÚS ANTONIO  GÓMEZ OCHOA DE ALDA" userId="111346b4-2c77-4688-bb93-b1ed5af05578" providerId="ADAL" clId="{E839ED6B-F7FD-7F48-8B72-2A69C700E3B7}" dt="2023-03-15T10:04:49.113" v="737" actId="1036"/>
          <ac:grpSpMkLst>
            <pc:docMk/>
            <pc:sldMk cId="1785560441" sldId="256"/>
            <ac:grpSpMk id="54" creationId="{4CE3BC72-C94C-3297-91D8-4A813600207E}"/>
          </ac:grpSpMkLst>
        </pc:grpChg>
        <pc:grpChg chg="del">
          <ac:chgData name="JESÚS ANTONIO  GÓMEZ OCHOA DE ALDA" userId="111346b4-2c77-4688-bb93-b1ed5af05578" providerId="ADAL" clId="{E839ED6B-F7FD-7F48-8B72-2A69C700E3B7}" dt="2023-03-15T10:03:05.742" v="508" actId="478"/>
          <ac:grpSpMkLst>
            <pc:docMk/>
            <pc:sldMk cId="1785560441" sldId="256"/>
            <ac:grpSpMk id="68" creationId="{01ADF35B-12F6-8E1C-70DD-B057109DE21F}"/>
          </ac:grpSpMkLst>
        </pc:grpChg>
        <pc:grpChg chg="del">
          <ac:chgData name="JESÚS ANTONIO  GÓMEZ OCHOA DE ALDA" userId="111346b4-2c77-4688-bb93-b1ed5af05578" providerId="ADAL" clId="{E839ED6B-F7FD-7F48-8B72-2A69C700E3B7}" dt="2023-03-15T10:03:00.523" v="506" actId="478"/>
          <ac:grpSpMkLst>
            <pc:docMk/>
            <pc:sldMk cId="1785560441" sldId="256"/>
            <ac:grpSpMk id="76" creationId="{CFF9ADD8-7722-CD38-E803-A70C4B282DF6}"/>
          </ac:grpSpMkLst>
        </pc:grpChg>
        <pc:grpChg chg="add mod">
          <ac:chgData name="JESÚS ANTONIO  GÓMEZ OCHOA DE ALDA" userId="111346b4-2c77-4688-bb93-b1ed5af05578" providerId="ADAL" clId="{E839ED6B-F7FD-7F48-8B72-2A69C700E3B7}" dt="2023-03-15T10:18:27.128" v="1581" actId="1037"/>
          <ac:grpSpMkLst>
            <pc:docMk/>
            <pc:sldMk cId="1785560441" sldId="256"/>
            <ac:grpSpMk id="88" creationId="{92C77465-8522-E01B-DA40-57CA96C12D9E}"/>
          </ac:grpSpMkLst>
        </pc:grpChg>
        <pc:grpChg chg="add mod">
          <ac:chgData name="JESÚS ANTONIO  GÓMEZ OCHOA DE ALDA" userId="111346b4-2c77-4688-bb93-b1ed5af05578" providerId="ADAL" clId="{E839ED6B-F7FD-7F48-8B72-2A69C700E3B7}" dt="2023-03-15T10:16:04.274" v="1363" actId="1036"/>
          <ac:grpSpMkLst>
            <pc:docMk/>
            <pc:sldMk cId="1785560441" sldId="256"/>
            <ac:grpSpMk id="95" creationId="{52227022-98C4-CA02-4AF2-7F219152156A}"/>
          </ac:grpSpMkLst>
        </pc:grpChg>
        <pc:grpChg chg="add del mod">
          <ac:chgData name="JESÚS ANTONIO  GÓMEZ OCHOA DE ALDA" userId="111346b4-2c77-4688-bb93-b1ed5af05578" providerId="ADAL" clId="{E839ED6B-F7FD-7F48-8B72-2A69C700E3B7}" dt="2023-03-15T10:15:09.855" v="1119"/>
          <ac:grpSpMkLst>
            <pc:docMk/>
            <pc:sldMk cId="1785560441" sldId="256"/>
            <ac:grpSpMk id="103" creationId="{6F8E307C-1059-879E-47E3-F29FC726EDF3}"/>
          </ac:grpSpMkLst>
        </pc:grpChg>
        <pc:picChg chg="mod topLvl modCrop">
          <ac:chgData name="JESÚS ANTONIO  GÓMEZ OCHOA DE ALDA" userId="111346b4-2c77-4688-bb93-b1ed5af05578" providerId="ADAL" clId="{E839ED6B-F7FD-7F48-8B72-2A69C700E3B7}" dt="2023-03-15T10:09:17.987" v="751" actId="732"/>
          <ac:picMkLst>
            <pc:docMk/>
            <pc:sldMk cId="1785560441" sldId="256"/>
            <ac:picMk id="4" creationId="{8D2A467C-12C6-7252-4E67-0351D8110A38}"/>
          </ac:picMkLst>
        </pc:picChg>
        <pc:picChg chg="mod">
          <ac:chgData name="JESÚS ANTONIO  GÓMEZ OCHOA DE ALDA" userId="111346b4-2c77-4688-bb93-b1ed5af05578" providerId="ADAL" clId="{E839ED6B-F7FD-7F48-8B72-2A69C700E3B7}" dt="2023-03-15T10:14:44.894" v="1117" actId="1038"/>
          <ac:picMkLst>
            <pc:docMk/>
            <pc:sldMk cId="1785560441" sldId="256"/>
            <ac:picMk id="5" creationId="{290A79D6-94B3-35F5-20E2-DA12314BCCFE}"/>
          </ac:picMkLst>
        </pc:picChg>
        <pc:picChg chg="mod topLvl">
          <ac:chgData name="JESÚS ANTONIO  GÓMEZ OCHOA DE ALDA" userId="111346b4-2c77-4688-bb93-b1ed5af05578" providerId="ADAL" clId="{E839ED6B-F7FD-7F48-8B72-2A69C700E3B7}" dt="2023-03-15T10:08:38.056" v="747" actId="165"/>
          <ac:picMkLst>
            <pc:docMk/>
            <pc:sldMk cId="1785560441" sldId="256"/>
            <ac:picMk id="6" creationId="{8E55A531-5DE8-D6FC-F615-A94F068E5381}"/>
          </ac:picMkLst>
        </pc:picChg>
        <pc:picChg chg="mod">
          <ac:chgData name="JESÚS ANTONIO  GÓMEZ OCHOA DE ALDA" userId="111346b4-2c77-4688-bb93-b1ed5af05578" providerId="ADAL" clId="{E839ED6B-F7FD-7F48-8B72-2A69C700E3B7}" dt="2023-03-13T16:49:04.069" v="53" actId="1036"/>
          <ac:picMkLst>
            <pc:docMk/>
            <pc:sldMk cId="1785560441" sldId="256"/>
            <ac:picMk id="13" creationId="{A7F90049-4C99-E39A-53A0-4FA279905F26}"/>
          </ac:picMkLst>
        </pc:picChg>
        <pc:picChg chg="mod">
          <ac:chgData name="JESÚS ANTONIO  GÓMEZ OCHOA DE ALDA" userId="111346b4-2c77-4688-bb93-b1ed5af05578" providerId="ADAL" clId="{E839ED6B-F7FD-7F48-8B72-2A69C700E3B7}" dt="2023-03-13T16:49:04.069" v="53" actId="1036"/>
          <ac:picMkLst>
            <pc:docMk/>
            <pc:sldMk cId="1785560441" sldId="256"/>
            <ac:picMk id="14" creationId="{775E7B6C-88CD-7FF8-EC10-3EADC1E26BE0}"/>
          </ac:picMkLst>
        </pc:picChg>
        <pc:picChg chg="del mod">
          <ac:chgData name="JESÚS ANTONIO  GÓMEZ OCHOA DE ALDA" userId="111346b4-2c77-4688-bb93-b1ed5af05578" providerId="ADAL" clId="{E839ED6B-F7FD-7F48-8B72-2A69C700E3B7}" dt="2023-03-15T11:31:43.894" v="2067" actId="478"/>
          <ac:picMkLst>
            <pc:docMk/>
            <pc:sldMk cId="1785560441" sldId="256"/>
            <ac:picMk id="32" creationId="{26228F0F-4F4B-87DE-0D1F-C71402B5370C}"/>
          </ac:picMkLst>
        </pc:picChg>
        <pc:picChg chg="mod">
          <ac:chgData name="JESÚS ANTONIO  GÓMEZ OCHOA DE ALDA" userId="111346b4-2c77-4688-bb93-b1ed5af05578" providerId="ADAL" clId="{E839ED6B-F7FD-7F48-8B72-2A69C700E3B7}" dt="2023-03-13T16:52:24.444" v="431" actId="1076"/>
          <ac:picMkLst>
            <pc:docMk/>
            <pc:sldMk cId="1785560441" sldId="256"/>
            <ac:picMk id="53" creationId="{7AEE8F0F-016C-B655-F325-A45861122B01}"/>
          </ac:picMkLst>
        </pc:picChg>
        <pc:picChg chg="mod">
          <ac:chgData name="JESÚS ANTONIO  GÓMEZ OCHOA DE ALDA" userId="111346b4-2c77-4688-bb93-b1ed5af05578" providerId="ADAL" clId="{E839ED6B-F7FD-7F48-8B72-2A69C700E3B7}" dt="2023-03-13T16:52:17.216" v="430" actId="14100"/>
          <ac:picMkLst>
            <pc:docMk/>
            <pc:sldMk cId="1785560441" sldId="256"/>
            <ac:picMk id="55" creationId="{83424300-F15C-1105-3DD6-F84E2C3955E1}"/>
          </ac:picMkLst>
        </pc:picChg>
        <pc:picChg chg="mod">
          <ac:chgData name="JESÚS ANTONIO  GÓMEZ OCHOA DE ALDA" userId="111346b4-2c77-4688-bb93-b1ed5af05578" providerId="ADAL" clId="{E839ED6B-F7FD-7F48-8B72-2A69C700E3B7}" dt="2023-03-13T16:51:54.441" v="390" actId="1038"/>
          <ac:picMkLst>
            <pc:docMk/>
            <pc:sldMk cId="1785560441" sldId="256"/>
            <ac:picMk id="60" creationId="{B599D18F-0516-BC8A-6463-ECA3AD72C0AA}"/>
          </ac:picMkLst>
        </pc:picChg>
        <pc:picChg chg="del mod">
          <ac:chgData name="JESÚS ANTONIO  GÓMEZ OCHOA DE ALDA" userId="111346b4-2c77-4688-bb93-b1ed5af05578" providerId="ADAL" clId="{E839ED6B-F7FD-7F48-8B72-2A69C700E3B7}" dt="2023-03-15T11:26:14.449" v="2020" actId="478"/>
          <ac:picMkLst>
            <pc:docMk/>
            <pc:sldMk cId="1785560441" sldId="256"/>
            <ac:picMk id="65" creationId="{6E8A8E05-299C-61DA-26D2-C00C9E3E4637}"/>
          </ac:picMkLst>
        </pc:picChg>
        <pc:picChg chg="add del mod">
          <ac:chgData name="JESÚS ANTONIO  GÓMEZ OCHOA DE ALDA" userId="111346b4-2c77-4688-bb93-b1ed5af05578" providerId="ADAL" clId="{E839ED6B-F7FD-7F48-8B72-2A69C700E3B7}" dt="2023-03-15T10:05:43.052" v="741"/>
          <ac:picMkLst>
            <pc:docMk/>
            <pc:sldMk cId="1785560441" sldId="256"/>
            <ac:picMk id="85" creationId="{569147C7-AF9B-8402-0637-37E6713953A8}"/>
          </ac:picMkLst>
        </pc:picChg>
        <pc:picChg chg="add mod">
          <ac:chgData name="JESÚS ANTONIO  GÓMEZ OCHOA DE ALDA" userId="111346b4-2c77-4688-bb93-b1ed5af05578" providerId="ADAL" clId="{E839ED6B-F7FD-7F48-8B72-2A69C700E3B7}" dt="2023-03-15T10:22:13.203" v="1708" actId="1076"/>
          <ac:picMkLst>
            <pc:docMk/>
            <pc:sldMk cId="1785560441" sldId="256"/>
            <ac:picMk id="120" creationId="{979F316C-A31E-AC9C-417A-E5FC563B501F}"/>
          </ac:picMkLst>
        </pc:picChg>
        <pc:picChg chg="add del mod">
          <ac:chgData name="JESÚS ANTONIO  GÓMEZ OCHOA DE ALDA" userId="111346b4-2c77-4688-bb93-b1ed5af05578" providerId="ADAL" clId="{E839ED6B-F7FD-7F48-8B72-2A69C700E3B7}" dt="2023-03-15T10:26:13.687" v="1802" actId="478"/>
          <ac:picMkLst>
            <pc:docMk/>
            <pc:sldMk cId="1785560441" sldId="256"/>
            <ac:picMk id="121" creationId="{3AEEEDB2-04B2-8DB0-3387-6F4E0FC3F228}"/>
          </ac:picMkLst>
        </pc:picChg>
        <pc:picChg chg="add mod modCrop">
          <ac:chgData name="JESÚS ANTONIO  GÓMEZ OCHOA DE ALDA" userId="111346b4-2c77-4688-bb93-b1ed5af05578" providerId="ADAL" clId="{E839ED6B-F7FD-7F48-8B72-2A69C700E3B7}" dt="2023-03-15T10:27:05.863" v="1812" actId="1076"/>
          <ac:picMkLst>
            <pc:docMk/>
            <pc:sldMk cId="1785560441" sldId="256"/>
            <ac:picMk id="125" creationId="{7036907B-612F-FC96-13B3-70281CE0794A}"/>
          </ac:picMkLst>
        </pc:picChg>
        <pc:picChg chg="add del mod">
          <ac:chgData name="JESÚS ANTONIO  GÓMEZ OCHOA DE ALDA" userId="111346b4-2c77-4688-bb93-b1ed5af05578" providerId="ADAL" clId="{E839ED6B-F7FD-7F48-8B72-2A69C700E3B7}" dt="2023-03-15T11:36:51.204" v="2094" actId="478"/>
          <ac:picMkLst>
            <pc:docMk/>
            <pc:sldMk cId="1785560441" sldId="256"/>
            <ac:picMk id="137" creationId="{82107FCE-6D20-AEB1-93A1-F12054522511}"/>
          </ac:picMkLst>
        </pc:picChg>
        <pc:picChg chg="add mod modCrop">
          <ac:chgData name="JESÚS ANTONIO  GÓMEZ OCHOA DE ALDA" userId="111346b4-2c77-4688-bb93-b1ed5af05578" providerId="ADAL" clId="{E839ED6B-F7FD-7F48-8B72-2A69C700E3B7}" dt="2023-03-15T11:28:19.984" v="2047" actId="1037"/>
          <ac:picMkLst>
            <pc:docMk/>
            <pc:sldMk cId="1785560441" sldId="256"/>
            <ac:picMk id="138" creationId="{FC6BC73E-97CE-47DB-6D21-572F91624F43}"/>
          </ac:picMkLst>
        </pc:picChg>
        <pc:picChg chg="add mod">
          <ac:chgData name="JESÚS ANTONIO  GÓMEZ OCHOA DE ALDA" userId="111346b4-2c77-4688-bb93-b1ed5af05578" providerId="ADAL" clId="{E839ED6B-F7FD-7F48-8B72-2A69C700E3B7}" dt="2023-03-15T11:34:25.041" v="2091" actId="1038"/>
          <ac:picMkLst>
            <pc:docMk/>
            <pc:sldMk cId="1785560441" sldId="256"/>
            <ac:picMk id="139" creationId="{3C3A25C1-A9DF-83B1-DC83-F8909505023E}"/>
          </ac:picMkLst>
        </pc:picChg>
        <pc:picChg chg="add mod">
          <ac:chgData name="JESÚS ANTONIO  GÓMEZ OCHOA DE ALDA" userId="111346b4-2c77-4688-bb93-b1ed5af05578" providerId="ADAL" clId="{E839ED6B-F7FD-7F48-8B72-2A69C700E3B7}" dt="2023-03-15T11:37:24.979" v="2103" actId="1076"/>
          <ac:picMkLst>
            <pc:docMk/>
            <pc:sldMk cId="1785560441" sldId="256"/>
            <ac:picMk id="141" creationId="{62057901-23E1-93FF-76D7-D282B0E64648}"/>
          </ac:picMkLst>
        </pc:picChg>
        <pc:picChg chg="add mod">
          <ac:chgData name="JESÚS ANTONIO  GÓMEZ OCHOA DE ALDA" userId="111346b4-2c77-4688-bb93-b1ed5af05578" providerId="ADAL" clId="{E839ED6B-F7FD-7F48-8B72-2A69C700E3B7}" dt="2023-03-15T11:42:10.867" v="2183" actId="1036"/>
          <ac:picMkLst>
            <pc:docMk/>
            <pc:sldMk cId="1785560441" sldId="256"/>
            <ac:picMk id="142" creationId="{32094C88-D849-8EAE-90FC-ACE782B8E6EF}"/>
          </ac:picMkLst>
        </pc:picChg>
        <pc:picChg chg="add mod modCrop">
          <ac:chgData name="JESÚS ANTONIO  GÓMEZ OCHOA DE ALDA" userId="111346b4-2c77-4688-bb93-b1ed5af05578" providerId="ADAL" clId="{E839ED6B-F7FD-7F48-8B72-2A69C700E3B7}" dt="2023-03-15T13:12:31.784" v="2197" actId="1076"/>
          <ac:picMkLst>
            <pc:docMk/>
            <pc:sldMk cId="1785560441" sldId="256"/>
            <ac:picMk id="144" creationId="{CDD91083-7FB2-6C58-67E3-03C723E07B86}"/>
          </ac:picMkLst>
        </pc:picChg>
        <pc:cxnChg chg="add del mod">
          <ac:chgData name="JESÚS ANTONIO  GÓMEZ OCHOA DE ALDA" userId="111346b4-2c77-4688-bb93-b1ed5af05578" providerId="ADAL" clId="{E839ED6B-F7FD-7F48-8B72-2A69C700E3B7}" dt="2023-03-15T10:02:44.550" v="505" actId="478"/>
          <ac:cxnSpMkLst>
            <pc:docMk/>
            <pc:sldMk cId="1785560441" sldId="256"/>
            <ac:cxnSpMk id="34" creationId="{C0CADC03-8900-774F-1368-C8B5B6FFC772}"/>
          </ac:cxnSpMkLst>
        </pc:cxnChg>
        <pc:cxnChg chg="mod">
          <ac:chgData name="JESÚS ANTONIO  GÓMEZ OCHOA DE ALDA" userId="111346b4-2c77-4688-bb93-b1ed5af05578" providerId="ADAL" clId="{E839ED6B-F7FD-7F48-8B72-2A69C700E3B7}" dt="2023-03-15T10:04:42.243" v="730" actId="207"/>
          <ac:cxnSpMkLst>
            <pc:docMk/>
            <pc:sldMk cId="1785560441" sldId="256"/>
            <ac:cxnSpMk id="38" creationId="{78B76DAD-1E0D-DB76-DDED-B1A4BAF0C77F}"/>
          </ac:cxnSpMkLst>
        </pc:cxnChg>
        <pc:cxnChg chg="mod">
          <ac:chgData name="JESÚS ANTONIO  GÓMEZ OCHOA DE ALDA" userId="111346b4-2c77-4688-bb93-b1ed5af05578" providerId="ADAL" clId="{E839ED6B-F7FD-7F48-8B72-2A69C700E3B7}" dt="2023-03-15T10:04:42.243" v="730" actId="207"/>
          <ac:cxnSpMkLst>
            <pc:docMk/>
            <pc:sldMk cId="1785560441" sldId="256"/>
            <ac:cxnSpMk id="39" creationId="{BF1D22A9-A23F-7FC8-80D9-13D87FE2CBF4}"/>
          </ac:cxnSpMkLst>
        </pc:cxnChg>
        <pc:cxnChg chg="mod">
          <ac:chgData name="JESÚS ANTONIO  GÓMEZ OCHOA DE ALDA" userId="111346b4-2c77-4688-bb93-b1ed5af05578" providerId="ADAL" clId="{E839ED6B-F7FD-7F48-8B72-2A69C700E3B7}" dt="2023-03-15T10:04:42.243" v="730" actId="207"/>
          <ac:cxnSpMkLst>
            <pc:docMk/>
            <pc:sldMk cId="1785560441" sldId="256"/>
            <ac:cxnSpMk id="47" creationId="{9B4232D5-A1CC-A937-4863-5B7DDE7F35EB}"/>
          </ac:cxnSpMkLst>
        </pc:cxnChg>
        <pc:cxnChg chg="mod">
          <ac:chgData name="JESÚS ANTONIO  GÓMEZ OCHOA DE ALDA" userId="111346b4-2c77-4688-bb93-b1ed5af05578" providerId="ADAL" clId="{E839ED6B-F7FD-7F48-8B72-2A69C700E3B7}" dt="2023-03-15T10:04:42.243" v="730" actId="207"/>
          <ac:cxnSpMkLst>
            <pc:docMk/>
            <pc:sldMk cId="1785560441" sldId="256"/>
            <ac:cxnSpMk id="49" creationId="{755F2509-8A75-6353-0389-FD518DB3510A}"/>
          </ac:cxnSpMkLst>
        </pc:cxnChg>
        <pc:cxnChg chg="mod">
          <ac:chgData name="JESÚS ANTONIO  GÓMEZ OCHOA DE ALDA" userId="111346b4-2c77-4688-bb93-b1ed5af05578" providerId="ADAL" clId="{E839ED6B-F7FD-7F48-8B72-2A69C700E3B7}" dt="2023-03-15T10:04:42.243" v="730" actId="207"/>
          <ac:cxnSpMkLst>
            <pc:docMk/>
            <pc:sldMk cId="1785560441" sldId="256"/>
            <ac:cxnSpMk id="51" creationId="{43385C95-B5E8-BF27-52AB-CE763E53BC42}"/>
          </ac:cxnSpMkLst>
        </pc:cxnChg>
        <pc:cxnChg chg="mod">
          <ac:chgData name="JESÚS ANTONIO  GÓMEZ OCHOA DE ALDA" userId="111346b4-2c77-4688-bb93-b1ed5af05578" providerId="ADAL" clId="{E839ED6B-F7FD-7F48-8B72-2A69C700E3B7}" dt="2023-03-15T10:04:42.243" v="730" actId="207"/>
          <ac:cxnSpMkLst>
            <pc:docMk/>
            <pc:sldMk cId="1785560441" sldId="256"/>
            <ac:cxnSpMk id="52" creationId="{E888C2BA-DDFA-3C44-B984-75E651554BA8}"/>
          </ac:cxnSpMkLst>
        </pc:cxnChg>
        <pc:cxnChg chg="mod">
          <ac:chgData name="JESÚS ANTONIO  GÓMEZ OCHOA DE ALDA" userId="111346b4-2c77-4688-bb93-b1ed5af05578" providerId="ADAL" clId="{E839ED6B-F7FD-7F48-8B72-2A69C700E3B7}" dt="2023-03-15T10:04:42.243" v="730" actId="207"/>
          <ac:cxnSpMkLst>
            <pc:docMk/>
            <pc:sldMk cId="1785560441" sldId="256"/>
            <ac:cxnSpMk id="53" creationId="{2EFDF184-C93E-003D-2B0D-9E0CB453DF1F}"/>
          </ac:cxnSpMkLst>
        </pc:cxnChg>
        <pc:cxnChg chg="mod">
          <ac:chgData name="JESÚS ANTONIO  GÓMEZ OCHOA DE ALDA" userId="111346b4-2c77-4688-bb93-b1ed5af05578" providerId="ADAL" clId="{E839ED6B-F7FD-7F48-8B72-2A69C700E3B7}" dt="2023-03-15T10:13:44.250" v="867"/>
          <ac:cxnSpMkLst>
            <pc:docMk/>
            <pc:sldMk cId="1785560441" sldId="256"/>
            <ac:cxnSpMk id="96" creationId="{1B013964-2C2C-1A59-EA88-101AA251F06C}"/>
          </ac:cxnSpMkLst>
        </pc:cxnChg>
        <pc:cxnChg chg="mod">
          <ac:chgData name="JESÚS ANTONIO  GÓMEZ OCHOA DE ALDA" userId="111346b4-2c77-4688-bb93-b1ed5af05578" providerId="ADAL" clId="{E839ED6B-F7FD-7F48-8B72-2A69C700E3B7}" dt="2023-03-15T10:13:44.250" v="867"/>
          <ac:cxnSpMkLst>
            <pc:docMk/>
            <pc:sldMk cId="1785560441" sldId="256"/>
            <ac:cxnSpMk id="97" creationId="{EDB4035A-CCA3-F793-D131-3B39C6C7C907}"/>
          </ac:cxnSpMkLst>
        </pc:cxnChg>
        <pc:cxnChg chg="mod">
          <ac:chgData name="JESÚS ANTONIO  GÓMEZ OCHOA DE ALDA" userId="111346b4-2c77-4688-bb93-b1ed5af05578" providerId="ADAL" clId="{E839ED6B-F7FD-7F48-8B72-2A69C700E3B7}" dt="2023-03-15T10:13:44.250" v="867"/>
          <ac:cxnSpMkLst>
            <pc:docMk/>
            <pc:sldMk cId="1785560441" sldId="256"/>
            <ac:cxnSpMk id="98" creationId="{B30DF344-4F9E-A00D-77D7-274B92F4C523}"/>
          </ac:cxnSpMkLst>
        </pc:cxnChg>
        <pc:cxnChg chg="mod">
          <ac:chgData name="JESÚS ANTONIO  GÓMEZ OCHOA DE ALDA" userId="111346b4-2c77-4688-bb93-b1ed5af05578" providerId="ADAL" clId="{E839ED6B-F7FD-7F48-8B72-2A69C700E3B7}" dt="2023-03-15T10:13:44.250" v="867"/>
          <ac:cxnSpMkLst>
            <pc:docMk/>
            <pc:sldMk cId="1785560441" sldId="256"/>
            <ac:cxnSpMk id="99" creationId="{7865DB2A-3D35-3E05-C876-B2426A14B226}"/>
          </ac:cxnSpMkLst>
        </pc:cxnChg>
        <pc:cxnChg chg="mod">
          <ac:chgData name="JESÚS ANTONIO  GÓMEZ OCHOA DE ALDA" userId="111346b4-2c77-4688-bb93-b1ed5af05578" providerId="ADAL" clId="{E839ED6B-F7FD-7F48-8B72-2A69C700E3B7}" dt="2023-03-15T10:13:44.250" v="867"/>
          <ac:cxnSpMkLst>
            <pc:docMk/>
            <pc:sldMk cId="1785560441" sldId="256"/>
            <ac:cxnSpMk id="100" creationId="{C2190C47-E506-9DC4-AB22-666CF137EE95}"/>
          </ac:cxnSpMkLst>
        </pc:cxnChg>
        <pc:cxnChg chg="mod">
          <ac:chgData name="JESÚS ANTONIO  GÓMEZ OCHOA DE ALDA" userId="111346b4-2c77-4688-bb93-b1ed5af05578" providerId="ADAL" clId="{E839ED6B-F7FD-7F48-8B72-2A69C700E3B7}" dt="2023-03-15T10:13:44.250" v="867"/>
          <ac:cxnSpMkLst>
            <pc:docMk/>
            <pc:sldMk cId="1785560441" sldId="256"/>
            <ac:cxnSpMk id="101" creationId="{8F0E8717-004F-489B-154F-7346F657F87B}"/>
          </ac:cxnSpMkLst>
        </pc:cxnChg>
        <pc:cxnChg chg="mod">
          <ac:chgData name="JESÚS ANTONIO  GÓMEZ OCHOA DE ALDA" userId="111346b4-2c77-4688-bb93-b1ed5af05578" providerId="ADAL" clId="{E839ED6B-F7FD-7F48-8B72-2A69C700E3B7}" dt="2023-03-15T10:13:44.250" v="867"/>
          <ac:cxnSpMkLst>
            <pc:docMk/>
            <pc:sldMk cId="1785560441" sldId="256"/>
            <ac:cxnSpMk id="102" creationId="{2F26C559-90D7-AD02-7240-A56DF430EB9B}"/>
          </ac:cxnSpMkLst>
        </pc:cxnChg>
        <pc:cxnChg chg="mod">
          <ac:chgData name="JESÚS ANTONIO  GÓMEZ OCHOA DE ALDA" userId="111346b4-2c77-4688-bb93-b1ed5af05578" providerId="ADAL" clId="{E839ED6B-F7FD-7F48-8B72-2A69C700E3B7}" dt="2023-03-15T10:15:07.431" v="1118"/>
          <ac:cxnSpMkLst>
            <pc:docMk/>
            <pc:sldMk cId="1785560441" sldId="256"/>
            <ac:cxnSpMk id="104" creationId="{E9451E09-D244-A47C-5A7C-924C2D6D7428}"/>
          </ac:cxnSpMkLst>
        </pc:cxnChg>
        <pc:cxnChg chg="mod">
          <ac:chgData name="JESÚS ANTONIO  GÓMEZ OCHOA DE ALDA" userId="111346b4-2c77-4688-bb93-b1ed5af05578" providerId="ADAL" clId="{E839ED6B-F7FD-7F48-8B72-2A69C700E3B7}" dt="2023-03-15T10:15:07.431" v="1118"/>
          <ac:cxnSpMkLst>
            <pc:docMk/>
            <pc:sldMk cId="1785560441" sldId="256"/>
            <ac:cxnSpMk id="105" creationId="{0BAE4606-F9B0-ADC0-13B9-5E50D696FECD}"/>
          </ac:cxnSpMkLst>
        </pc:cxnChg>
        <pc:cxnChg chg="mod">
          <ac:chgData name="JESÚS ANTONIO  GÓMEZ OCHOA DE ALDA" userId="111346b4-2c77-4688-bb93-b1ed5af05578" providerId="ADAL" clId="{E839ED6B-F7FD-7F48-8B72-2A69C700E3B7}" dt="2023-03-15T10:15:07.431" v="1118"/>
          <ac:cxnSpMkLst>
            <pc:docMk/>
            <pc:sldMk cId="1785560441" sldId="256"/>
            <ac:cxnSpMk id="106" creationId="{27A6EDD6-9D27-4FC7-0262-4FA50CB0FAEB}"/>
          </ac:cxnSpMkLst>
        </pc:cxnChg>
        <pc:cxnChg chg="mod">
          <ac:chgData name="JESÚS ANTONIO  GÓMEZ OCHOA DE ALDA" userId="111346b4-2c77-4688-bb93-b1ed5af05578" providerId="ADAL" clId="{E839ED6B-F7FD-7F48-8B72-2A69C700E3B7}" dt="2023-03-15T10:15:07.431" v="1118"/>
          <ac:cxnSpMkLst>
            <pc:docMk/>
            <pc:sldMk cId="1785560441" sldId="256"/>
            <ac:cxnSpMk id="107" creationId="{D02434C3-F546-A2B8-A2EE-89D73E772099}"/>
          </ac:cxnSpMkLst>
        </pc:cxnChg>
        <pc:cxnChg chg="mod">
          <ac:chgData name="JESÚS ANTONIO  GÓMEZ OCHOA DE ALDA" userId="111346b4-2c77-4688-bb93-b1ed5af05578" providerId="ADAL" clId="{E839ED6B-F7FD-7F48-8B72-2A69C700E3B7}" dt="2023-03-15T10:15:07.431" v="1118"/>
          <ac:cxnSpMkLst>
            <pc:docMk/>
            <pc:sldMk cId="1785560441" sldId="256"/>
            <ac:cxnSpMk id="108" creationId="{7824A6B2-BE3E-4463-5431-3B710CFC6B3A}"/>
          </ac:cxnSpMkLst>
        </pc:cxnChg>
        <pc:cxnChg chg="mod">
          <ac:chgData name="JESÚS ANTONIO  GÓMEZ OCHOA DE ALDA" userId="111346b4-2c77-4688-bb93-b1ed5af05578" providerId="ADAL" clId="{E839ED6B-F7FD-7F48-8B72-2A69C700E3B7}" dt="2023-03-15T10:15:07.431" v="1118"/>
          <ac:cxnSpMkLst>
            <pc:docMk/>
            <pc:sldMk cId="1785560441" sldId="256"/>
            <ac:cxnSpMk id="109" creationId="{AC913545-A59E-4FE8-AFE0-659DCD40C267}"/>
          </ac:cxnSpMkLst>
        </pc:cxnChg>
        <pc:cxnChg chg="mod">
          <ac:chgData name="JESÚS ANTONIO  GÓMEZ OCHOA DE ALDA" userId="111346b4-2c77-4688-bb93-b1ed5af05578" providerId="ADAL" clId="{E839ED6B-F7FD-7F48-8B72-2A69C700E3B7}" dt="2023-03-15T10:15:07.431" v="1118"/>
          <ac:cxnSpMkLst>
            <pc:docMk/>
            <pc:sldMk cId="1785560441" sldId="256"/>
            <ac:cxnSpMk id="110" creationId="{F2E4659F-CF14-4976-52D6-0289995F50C6}"/>
          </ac:cxnSpMkLst>
        </pc:cxnChg>
        <pc:cxnChg chg="add mod">
          <ac:chgData name="JESÚS ANTONIO  GÓMEZ OCHOA DE ALDA" userId="111346b4-2c77-4688-bb93-b1ed5af05578" providerId="ADAL" clId="{E839ED6B-F7FD-7F48-8B72-2A69C700E3B7}" dt="2023-03-15T11:34:07.301" v="2087" actId="1036"/>
          <ac:cxnSpMkLst>
            <pc:docMk/>
            <pc:sldMk cId="1785560441" sldId="256"/>
            <ac:cxnSpMk id="130" creationId="{8DDC1543-7972-BA19-33AC-6157B9FFACFD}"/>
          </ac:cxnSpMkLst>
        </pc:cxnChg>
        <pc:cxnChg chg="add mod">
          <ac:chgData name="JESÚS ANTONIO  GÓMEZ OCHOA DE ALDA" userId="111346b4-2c77-4688-bb93-b1ed5af05578" providerId="ADAL" clId="{E839ED6B-F7FD-7F48-8B72-2A69C700E3B7}" dt="2023-03-15T11:33:59.785" v="2083" actId="166"/>
          <ac:cxnSpMkLst>
            <pc:docMk/>
            <pc:sldMk cId="1785560441" sldId="256"/>
            <ac:cxnSpMk id="131" creationId="{C7F3A268-088D-BBF7-C5E0-BD4BCF829854}"/>
          </ac:cxnSpMkLst>
        </pc:cxnChg>
        <pc:cxnChg chg="add mod">
          <ac:chgData name="JESÚS ANTONIO  GÓMEZ OCHOA DE ALDA" userId="111346b4-2c77-4688-bb93-b1ed5af05578" providerId="ADAL" clId="{E839ED6B-F7FD-7F48-8B72-2A69C700E3B7}" dt="2023-03-15T11:33:59.785" v="2083" actId="166"/>
          <ac:cxnSpMkLst>
            <pc:docMk/>
            <pc:sldMk cId="1785560441" sldId="256"/>
            <ac:cxnSpMk id="133" creationId="{2FD603DD-D055-3A3F-5B3E-179A3A99DBD1}"/>
          </ac:cxnSpMkLst>
        </pc:cxnChg>
      </pc:sldChg>
      <pc:sldChg chg="addSp delSp modSp mod">
        <pc:chgData name="JESÚS ANTONIO  GÓMEZ OCHOA DE ALDA" userId="111346b4-2c77-4688-bb93-b1ed5af05578" providerId="ADAL" clId="{E839ED6B-F7FD-7F48-8B72-2A69C700E3B7}" dt="2023-03-15T11:31:30.890" v="2064" actId="1076"/>
        <pc:sldMkLst>
          <pc:docMk/>
          <pc:sldMk cId="4106376102" sldId="257"/>
        </pc:sldMkLst>
        <pc:picChg chg="add del mod modCrop">
          <ac:chgData name="JESÚS ANTONIO  GÓMEZ OCHOA DE ALDA" userId="111346b4-2c77-4688-bb93-b1ed5af05578" providerId="ADAL" clId="{E839ED6B-F7FD-7F48-8B72-2A69C700E3B7}" dt="2023-03-15T11:28:49.549" v="2054" actId="478"/>
          <ac:picMkLst>
            <pc:docMk/>
            <pc:sldMk cId="4106376102" sldId="257"/>
            <ac:picMk id="3" creationId="{29373DCB-E28A-734B-65B3-577BB27A8246}"/>
          </ac:picMkLst>
        </pc:picChg>
        <pc:picChg chg="add mod modCrop">
          <ac:chgData name="JESÚS ANTONIO  GÓMEZ OCHOA DE ALDA" userId="111346b4-2c77-4688-bb93-b1ed5af05578" providerId="ADAL" clId="{E839ED6B-F7FD-7F48-8B72-2A69C700E3B7}" dt="2023-03-15T11:31:30.890" v="2064" actId="1076"/>
          <ac:picMkLst>
            <pc:docMk/>
            <pc:sldMk cId="4106376102" sldId="257"/>
            <ac:picMk id="8" creationId="{4326F957-1087-A750-A79D-CE1BF80A14F3}"/>
          </ac:picMkLst>
        </pc:picChg>
      </pc:sldChg>
      <pc:sldChg chg="delSp mod">
        <pc:chgData name="JESÚS ANTONIO  GÓMEZ OCHOA DE ALDA" userId="111346b4-2c77-4688-bb93-b1ed5af05578" providerId="ADAL" clId="{E839ED6B-F7FD-7F48-8B72-2A69C700E3B7}" dt="2023-03-15T10:24:31.562" v="1801" actId="478"/>
        <pc:sldMkLst>
          <pc:docMk/>
          <pc:sldMk cId="2164923562" sldId="258"/>
        </pc:sldMkLst>
        <pc:graphicFrameChg chg="del">
          <ac:chgData name="JESÚS ANTONIO  GÓMEZ OCHOA DE ALDA" userId="111346b4-2c77-4688-bb93-b1ed5af05578" providerId="ADAL" clId="{E839ED6B-F7FD-7F48-8B72-2A69C700E3B7}" dt="2023-03-15T10:24:31.562" v="1801" actId="478"/>
          <ac:graphicFrameMkLst>
            <pc:docMk/>
            <pc:sldMk cId="2164923562" sldId="258"/>
            <ac:graphicFrameMk id="4" creationId="{3A101701-E0EA-3B34-15AF-24AEC949784F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F82B42-C7BA-CD49-B6BE-333DA0408E38}" type="datetimeFigureOut">
              <a:rPr lang="es-ES_tradnl" smtClean="0"/>
              <a:t>7/2/24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EE95E4-A74E-7F48-9082-1D5F9054C368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9908256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2291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796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17132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0324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817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0717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2569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059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6900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760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2732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D4AC2-1608-BF4A-8B68-79338B31DF2E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B35DFA-7ED7-104C-B123-7F54BFEE236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976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g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gif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Agrupar 18"/>
          <p:cNvGrpSpPr/>
          <p:nvPr/>
        </p:nvGrpSpPr>
        <p:grpSpPr>
          <a:xfrm>
            <a:off x="371331" y="236884"/>
            <a:ext cx="5941113" cy="8781857"/>
            <a:chOff x="371331" y="236884"/>
            <a:chExt cx="5941113" cy="8781857"/>
          </a:xfrm>
        </p:grpSpPr>
        <p:pic>
          <p:nvPicPr>
            <p:cNvPr id="84" name="Imagen 83" descr="Gráfico&#10;&#10;Descripción generada automáticamente">
              <a:extLst>
                <a:ext uri="{FF2B5EF4-FFF2-40B4-BE49-F238E27FC236}">
                  <a16:creationId xmlns:a16="http://schemas.microsoft.com/office/drawing/2014/main" id="{70969B2A-2DBC-2206-9DAD-542A9FF077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425" t="10984" r="87153" b="11057"/>
            <a:stretch/>
          </p:blipFill>
          <p:spPr>
            <a:xfrm>
              <a:off x="5780778" y="2367677"/>
              <a:ext cx="46810" cy="1603931"/>
            </a:xfrm>
            <a:prstGeom prst="rect">
              <a:avLst/>
            </a:prstGeom>
          </p:spPr>
        </p:pic>
        <p:grpSp>
          <p:nvGrpSpPr>
            <p:cNvPr id="45" name="Grupo 44">
              <a:extLst>
                <a:ext uri="{FF2B5EF4-FFF2-40B4-BE49-F238E27FC236}">
                  <a16:creationId xmlns:a16="http://schemas.microsoft.com/office/drawing/2014/main" id="{7C70597C-94F7-6EBA-D8EC-792EAE717099}"/>
                </a:ext>
              </a:extLst>
            </p:cNvPr>
            <p:cNvGrpSpPr/>
            <p:nvPr/>
          </p:nvGrpSpPr>
          <p:grpSpPr>
            <a:xfrm>
              <a:off x="655757" y="2350278"/>
              <a:ext cx="2544285" cy="1750198"/>
              <a:chOff x="655757" y="2350278"/>
              <a:chExt cx="2544285" cy="1750198"/>
            </a:xfrm>
          </p:grpSpPr>
          <p:pic>
            <p:nvPicPr>
              <p:cNvPr id="4" name="Imagen 3">
                <a:extLst>
                  <a:ext uri="{FF2B5EF4-FFF2-40B4-BE49-F238E27FC236}">
                    <a16:creationId xmlns:a16="http://schemas.microsoft.com/office/drawing/2014/main" id="{8D2A467C-12C6-7252-4E67-0351D8110A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5184" t="11594" r="13204" b="3585"/>
              <a:stretch/>
            </p:blipFill>
            <p:spPr>
              <a:xfrm>
                <a:off x="876288" y="2380218"/>
                <a:ext cx="2323754" cy="1720258"/>
              </a:xfrm>
              <a:prstGeom prst="rect">
                <a:avLst/>
              </a:prstGeom>
            </p:spPr>
          </p:pic>
          <p:pic>
            <p:nvPicPr>
              <p:cNvPr id="6" name="Imagen 5">
                <a:extLst>
                  <a:ext uri="{FF2B5EF4-FFF2-40B4-BE49-F238E27FC236}">
                    <a16:creationId xmlns:a16="http://schemas.microsoft.com/office/drawing/2014/main" id="{8E55A531-5DE8-D6FC-F615-A94F068E53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830" t="10037" r="87236" b="11353"/>
              <a:stretch/>
            </p:blipFill>
            <p:spPr>
              <a:xfrm>
                <a:off x="655757" y="2350278"/>
                <a:ext cx="257432" cy="1594230"/>
              </a:xfrm>
              <a:prstGeom prst="rect">
                <a:avLst/>
              </a:prstGeom>
            </p:spPr>
          </p:pic>
        </p:grpSp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290A79D6-94B3-35F5-20E2-DA12314BCC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973" t="9853" r="87203" b="11353"/>
            <a:stretch/>
          </p:blipFill>
          <p:spPr>
            <a:xfrm>
              <a:off x="3171001" y="2344677"/>
              <a:ext cx="26504" cy="1584000"/>
            </a:xfrm>
            <a:prstGeom prst="rect">
              <a:avLst/>
            </a:prstGeom>
          </p:spPr>
        </p:pic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804BB09C-4EAE-8AA4-7534-1B87164F17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6673" t="63505" r="10382" b="13368"/>
            <a:stretch/>
          </p:blipFill>
          <p:spPr>
            <a:xfrm>
              <a:off x="2640691" y="2570597"/>
              <a:ext cx="344455" cy="384602"/>
            </a:xfrm>
            <a:prstGeom prst="rect">
              <a:avLst/>
            </a:prstGeom>
          </p:spPr>
        </p:pic>
        <p:pic>
          <p:nvPicPr>
            <p:cNvPr id="13" name="Imagen 12" descr="Gráfico&#10;&#10;Descripción generada automáticamente con confianza media">
              <a:extLst>
                <a:ext uri="{FF2B5EF4-FFF2-40B4-BE49-F238E27FC236}">
                  <a16:creationId xmlns:a16="http://schemas.microsoft.com/office/drawing/2014/main" id="{A7F90049-4C99-E39A-53A0-4FA279905F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7558" t="10748" r="12453" b="10677"/>
            <a:stretch/>
          </p:blipFill>
          <p:spPr>
            <a:xfrm>
              <a:off x="5954869" y="579521"/>
              <a:ext cx="357575" cy="1757953"/>
            </a:xfrm>
            <a:prstGeom prst="rect">
              <a:avLst/>
            </a:prstGeom>
          </p:spPr>
        </p:pic>
        <p:sp>
          <p:nvSpPr>
            <p:cNvPr id="15" name="Rectángulo 14">
              <a:extLst>
                <a:ext uri="{FF2B5EF4-FFF2-40B4-BE49-F238E27FC236}">
                  <a16:creationId xmlns:a16="http://schemas.microsoft.com/office/drawing/2014/main" id="{50B41022-8BC4-EF0C-B4D6-AA1ED5CACA8F}"/>
                </a:ext>
              </a:extLst>
            </p:cNvPr>
            <p:cNvSpPr/>
            <p:nvPr/>
          </p:nvSpPr>
          <p:spPr>
            <a:xfrm>
              <a:off x="2772696" y="3436204"/>
              <a:ext cx="391958" cy="45216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73909222-B00F-33D3-B9F0-A061DB47F212}"/>
                </a:ext>
              </a:extLst>
            </p:cNvPr>
            <p:cNvSpPr txBox="1"/>
            <p:nvPr/>
          </p:nvSpPr>
          <p:spPr>
            <a:xfrm rot="5400000">
              <a:off x="5658318" y="3486347"/>
              <a:ext cx="421071" cy="2786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400" dirty="0"/>
                <a:t>MIB score</a:t>
              </a: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289B8BEE-8A2E-E085-F947-10DE8C28E38D}"/>
                </a:ext>
              </a:extLst>
            </p:cNvPr>
            <p:cNvSpPr txBox="1"/>
            <p:nvPr/>
          </p:nvSpPr>
          <p:spPr>
            <a:xfrm>
              <a:off x="373126" y="462196"/>
              <a:ext cx="4224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dirty="0"/>
                <a:t>A</a:t>
              </a: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D12DFE0C-1D80-F715-6E9F-25E2A2DD7673}"/>
                </a:ext>
              </a:extLst>
            </p:cNvPr>
            <p:cNvSpPr txBox="1"/>
            <p:nvPr/>
          </p:nvSpPr>
          <p:spPr>
            <a:xfrm>
              <a:off x="378007" y="2269957"/>
              <a:ext cx="4224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dirty="0"/>
                <a:t>B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E586665B-80BC-7F59-9CB4-928D4D1DEC84}"/>
                </a:ext>
              </a:extLst>
            </p:cNvPr>
            <p:cNvSpPr txBox="1"/>
            <p:nvPr/>
          </p:nvSpPr>
          <p:spPr>
            <a:xfrm>
              <a:off x="653687" y="8680187"/>
              <a:ext cx="28283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800" b="1" dirty="0" err="1">
                  <a:cs typeface="Courier New"/>
                </a:rPr>
                <a:t>ZepA</a:t>
              </a:r>
              <a:r>
                <a:rPr lang="es-ES_tradnl" sz="800" b="1" dirty="0">
                  <a:cs typeface="Courier New"/>
                </a:rPr>
                <a:t> </a:t>
              </a:r>
              <a:r>
                <a:rPr lang="es-ES_tradnl" sz="800" b="1" i="1" dirty="0" err="1">
                  <a:cs typeface="Courier New"/>
                </a:rPr>
                <a:t>Anabaena</a:t>
              </a:r>
              <a:r>
                <a:rPr lang="es-ES_tradnl" sz="800" b="1" i="1" dirty="0">
                  <a:cs typeface="Courier New"/>
                </a:rPr>
                <a:t> </a:t>
              </a:r>
              <a:r>
                <a:rPr lang="es-ES_tradnl" sz="800" b="1" dirty="0" err="1">
                  <a:cs typeface="Courier New"/>
                </a:rPr>
                <a:t>sp</a:t>
              </a:r>
              <a:r>
                <a:rPr lang="es-ES_tradnl" sz="800" b="1" dirty="0">
                  <a:cs typeface="Courier New"/>
                </a:rPr>
                <a:t>. </a:t>
              </a:r>
              <a:r>
                <a:rPr lang="es-ES_tradnl" sz="800" b="1">
                  <a:cs typeface="Courier New"/>
                </a:rPr>
                <a:t>PCC 7120</a:t>
              </a:r>
              <a:endParaRPr lang="es-ES_tradnl" sz="800" b="1" dirty="0">
                <a:cs typeface="Courier New"/>
              </a:endParaRPr>
            </a:p>
            <a:p>
              <a:pPr algn="ctr"/>
              <a:r>
                <a:rPr lang="es-ES_tradnl" sz="800" b="1" dirty="0">
                  <a:cs typeface="Courier New"/>
                </a:rPr>
                <a:t>(</a:t>
              </a:r>
              <a:r>
                <a:rPr lang="es-ES_tradnl" sz="800" b="1" dirty="0" err="1">
                  <a:cs typeface="Courier New"/>
                </a:rPr>
                <a:t>Cyanobacteria</a:t>
              </a:r>
              <a:r>
                <a:rPr lang="es-ES_tradnl" sz="800" b="1" dirty="0">
                  <a:cs typeface="Courier New"/>
                </a:rPr>
                <a:t>)</a:t>
              </a:r>
            </a:p>
          </p:txBody>
        </p:sp>
        <p:grpSp>
          <p:nvGrpSpPr>
            <p:cNvPr id="44" name="Grupo 43">
              <a:extLst>
                <a:ext uri="{FF2B5EF4-FFF2-40B4-BE49-F238E27FC236}">
                  <a16:creationId xmlns:a16="http://schemas.microsoft.com/office/drawing/2014/main" id="{358262BB-77D0-7C39-97F0-B814264542FF}"/>
                </a:ext>
              </a:extLst>
            </p:cNvPr>
            <p:cNvGrpSpPr/>
            <p:nvPr/>
          </p:nvGrpSpPr>
          <p:grpSpPr>
            <a:xfrm>
              <a:off x="3332941" y="542390"/>
              <a:ext cx="2508057" cy="1785720"/>
              <a:chOff x="3332941" y="564558"/>
              <a:chExt cx="2508057" cy="1785720"/>
            </a:xfrm>
          </p:grpSpPr>
          <p:pic>
            <p:nvPicPr>
              <p:cNvPr id="40" name="Imagen 39" descr="Diagrama&#10;&#10;Descripción generada automáticamente">
                <a:extLst>
                  <a:ext uri="{FF2B5EF4-FFF2-40B4-BE49-F238E27FC236}">
                    <a16:creationId xmlns:a16="http://schemas.microsoft.com/office/drawing/2014/main" id="{92CC7D99-D670-E1DC-F3FF-B14B517CF3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7586" t="11816" r="24722" b="12062"/>
              <a:stretch/>
            </p:blipFill>
            <p:spPr>
              <a:xfrm>
                <a:off x="3339741" y="564558"/>
                <a:ext cx="2501257" cy="1757953"/>
              </a:xfrm>
              <a:prstGeom prst="rect">
                <a:avLst/>
              </a:prstGeom>
            </p:spPr>
          </p:pic>
          <p:pic>
            <p:nvPicPr>
              <p:cNvPr id="43" name="Imagen 42" descr="Diagrama&#10;&#10;Descripción generada automáticamente">
                <a:extLst>
                  <a:ext uri="{FF2B5EF4-FFF2-40B4-BE49-F238E27FC236}">
                    <a16:creationId xmlns:a16="http://schemas.microsoft.com/office/drawing/2014/main" id="{52EF91C4-5A1D-8E50-7C83-6CC40235EF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7179" t="13290" r="88611" b="10588"/>
              <a:stretch/>
            </p:blipFill>
            <p:spPr>
              <a:xfrm>
                <a:off x="3332941" y="592325"/>
                <a:ext cx="155570" cy="1757953"/>
              </a:xfrm>
              <a:prstGeom prst="rect">
                <a:avLst/>
              </a:prstGeom>
            </p:spPr>
          </p:pic>
        </p:grpSp>
        <p:grpSp>
          <p:nvGrpSpPr>
            <p:cNvPr id="42" name="Grupo 41">
              <a:extLst>
                <a:ext uri="{FF2B5EF4-FFF2-40B4-BE49-F238E27FC236}">
                  <a16:creationId xmlns:a16="http://schemas.microsoft.com/office/drawing/2014/main" id="{E9A4303B-C96C-88FF-29CF-6AACE8AB513F}"/>
                </a:ext>
              </a:extLst>
            </p:cNvPr>
            <p:cNvGrpSpPr/>
            <p:nvPr/>
          </p:nvGrpSpPr>
          <p:grpSpPr>
            <a:xfrm>
              <a:off x="644648" y="544161"/>
              <a:ext cx="2549070" cy="1823432"/>
              <a:chOff x="644648" y="566329"/>
              <a:chExt cx="2549070" cy="1823432"/>
            </a:xfrm>
          </p:grpSpPr>
          <p:pic>
            <p:nvPicPr>
              <p:cNvPr id="14" name="Imagen 13" descr="Gráfico&#10;&#10;Descripción generada automáticamente con confianza baja">
                <a:extLst>
                  <a:ext uri="{FF2B5EF4-FFF2-40B4-BE49-F238E27FC236}">
                    <a16:creationId xmlns:a16="http://schemas.microsoft.com/office/drawing/2014/main" id="{775E7B6C-88CD-7FF8-EC10-3EADC1E26BE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0806" t="11704" r="25386" b="12089"/>
              <a:stretch/>
            </p:blipFill>
            <p:spPr>
              <a:xfrm>
                <a:off x="838630" y="566329"/>
                <a:ext cx="2355088" cy="1757953"/>
              </a:xfrm>
              <a:prstGeom prst="rect">
                <a:avLst/>
              </a:prstGeom>
            </p:spPr>
          </p:pic>
          <p:pic>
            <p:nvPicPr>
              <p:cNvPr id="41" name="Imagen 40" descr="Gráfico&#10;&#10;Descripción generada automáticamente con confianza baja">
                <a:extLst>
                  <a:ext uri="{FF2B5EF4-FFF2-40B4-BE49-F238E27FC236}">
                    <a16:creationId xmlns:a16="http://schemas.microsoft.com/office/drawing/2014/main" id="{1D9E3649-F118-3DEC-EF5D-9E7CB32014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5453" t="11704" r="88534" b="9285"/>
              <a:stretch/>
            </p:blipFill>
            <p:spPr>
              <a:xfrm>
                <a:off x="644648" y="567117"/>
                <a:ext cx="221934" cy="1822644"/>
              </a:xfrm>
              <a:prstGeom prst="rect">
                <a:avLst/>
              </a:prstGeom>
            </p:spPr>
          </p:pic>
        </p:grpSp>
        <p:pic>
          <p:nvPicPr>
            <p:cNvPr id="48" name="Imagen 47" descr="Interfaz de usuario gráfica&#10;&#10;Descripción generada automáticamente">
              <a:extLst>
                <a:ext uri="{FF2B5EF4-FFF2-40B4-BE49-F238E27FC236}">
                  <a16:creationId xmlns:a16="http://schemas.microsoft.com/office/drawing/2014/main" id="{676258DB-E675-A83D-206E-94FD96418C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0202" t="-10630" r="8824"/>
            <a:stretch/>
          </p:blipFill>
          <p:spPr>
            <a:xfrm>
              <a:off x="3563760" y="4343831"/>
              <a:ext cx="2583657" cy="470654"/>
            </a:xfrm>
            <a:prstGeom prst="rect">
              <a:avLst/>
            </a:prstGeom>
          </p:spPr>
        </p:pic>
        <p:pic>
          <p:nvPicPr>
            <p:cNvPr id="56" name="Imagen 55" descr="Interfaz de usuario gráfica, Gráfico&#10;&#10;Descripción generada automáticamente">
              <a:extLst>
                <a:ext uri="{FF2B5EF4-FFF2-40B4-BE49-F238E27FC236}">
                  <a16:creationId xmlns:a16="http://schemas.microsoft.com/office/drawing/2014/main" id="{63CAB4D6-D628-3ECB-5F3F-5CD0E4A6E5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9580" r="9033"/>
            <a:stretch/>
          </p:blipFill>
          <p:spPr>
            <a:xfrm>
              <a:off x="665790" y="4401469"/>
              <a:ext cx="2693219" cy="441220"/>
            </a:xfrm>
            <a:prstGeom prst="rect">
              <a:avLst/>
            </a:prstGeom>
          </p:spPr>
        </p:pic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509DDFCF-D9D9-5941-32C2-DE49978599B1}"/>
                </a:ext>
              </a:extLst>
            </p:cNvPr>
            <p:cNvSpPr txBox="1"/>
            <p:nvPr/>
          </p:nvSpPr>
          <p:spPr>
            <a:xfrm>
              <a:off x="380018" y="4179657"/>
              <a:ext cx="4224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dirty="0"/>
                <a:t>C</a:t>
              </a:r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ED0227CF-8EAB-2235-5DB9-AD235D24FE42}"/>
                </a:ext>
              </a:extLst>
            </p:cNvPr>
            <p:cNvSpPr txBox="1"/>
            <p:nvPr/>
          </p:nvSpPr>
          <p:spPr>
            <a:xfrm>
              <a:off x="3546280" y="8680187"/>
              <a:ext cx="26936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PT" sz="800" b="1" dirty="0" err="1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ZepA</a:t>
              </a:r>
              <a:r>
                <a:rPr lang="pt-PT" sz="800" b="1" dirty="0">
                  <a:solidFill>
                    <a:srgbClr val="000000"/>
                  </a:solidFill>
                  <a:ea typeface="Times New Roman" panose="02020603050405020304" pitchFamily="18" charset="0"/>
                </a:rPr>
                <a:t> </a:t>
              </a:r>
              <a:r>
                <a:rPr lang="pt-PT" sz="800" b="1" i="1" dirty="0" err="1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Lacipirellula</a:t>
              </a:r>
              <a:r>
                <a:rPr lang="pt-PT" sz="800" b="1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</a:t>
              </a:r>
              <a:r>
                <a:rPr lang="pt-PT" sz="800" b="1" i="1" dirty="0" err="1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limnantheis</a:t>
              </a:r>
              <a:endParaRPr lang="pt-PT" sz="800" b="1" i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endParaRPr>
            </a:p>
            <a:p>
              <a:pPr algn="ctr"/>
              <a:r>
                <a:rPr lang="pt-PT" sz="800" b="1" dirty="0">
                  <a:solidFill>
                    <a:srgbClr val="000000"/>
                  </a:solidFill>
                  <a:ea typeface="Times New Roman" panose="02020603050405020304" pitchFamily="18" charset="0"/>
                </a:rPr>
                <a:t>(PVC </a:t>
              </a:r>
              <a:r>
                <a:rPr lang="pt-PT" sz="800" b="1" dirty="0" err="1">
                  <a:solidFill>
                    <a:srgbClr val="000000"/>
                  </a:solidFill>
                  <a:ea typeface="Times New Roman" panose="02020603050405020304" pitchFamily="18" charset="0"/>
                </a:rPr>
                <a:t>superphylum</a:t>
              </a:r>
              <a:r>
                <a:rPr lang="pt-PT" sz="800" b="1" dirty="0">
                  <a:solidFill>
                    <a:srgbClr val="000000"/>
                  </a:solidFill>
                  <a:ea typeface="Times New Roman" panose="02020603050405020304" pitchFamily="18" charset="0"/>
                </a:rPr>
                <a:t>)</a:t>
              </a:r>
              <a:r>
                <a:rPr lang="pt-PT" sz="800" b="1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</a:t>
              </a:r>
              <a:endParaRPr lang="es-ES_tradnl" sz="800" dirty="0"/>
            </a:p>
          </p:txBody>
        </p:sp>
        <p:grpSp>
          <p:nvGrpSpPr>
            <p:cNvPr id="63" name="Grupo 62">
              <a:extLst>
                <a:ext uri="{FF2B5EF4-FFF2-40B4-BE49-F238E27FC236}">
                  <a16:creationId xmlns:a16="http://schemas.microsoft.com/office/drawing/2014/main" id="{85640574-3E4C-CB3E-3279-469A06935F5C}"/>
                </a:ext>
              </a:extLst>
            </p:cNvPr>
            <p:cNvGrpSpPr/>
            <p:nvPr/>
          </p:nvGrpSpPr>
          <p:grpSpPr>
            <a:xfrm>
              <a:off x="3371850" y="2367677"/>
              <a:ext cx="2440781" cy="1816742"/>
              <a:chOff x="3371850" y="2367677"/>
              <a:chExt cx="2440781" cy="1816742"/>
            </a:xfrm>
          </p:grpSpPr>
          <p:grpSp>
            <p:nvGrpSpPr>
              <p:cNvPr id="61" name="Grupo 60">
                <a:extLst>
                  <a:ext uri="{FF2B5EF4-FFF2-40B4-BE49-F238E27FC236}">
                    <a16:creationId xmlns:a16="http://schemas.microsoft.com/office/drawing/2014/main" id="{CF99178B-B967-4701-C9A2-54AD8DEE3235}"/>
                  </a:ext>
                </a:extLst>
              </p:cNvPr>
              <p:cNvGrpSpPr/>
              <p:nvPr/>
            </p:nvGrpSpPr>
            <p:grpSpPr>
              <a:xfrm>
                <a:off x="3371850" y="2367677"/>
                <a:ext cx="2440781" cy="1816742"/>
                <a:chOff x="3371850" y="2367677"/>
                <a:chExt cx="2440781" cy="1816742"/>
              </a:xfrm>
            </p:grpSpPr>
            <p:pic>
              <p:nvPicPr>
                <p:cNvPr id="50" name="Imagen 49" descr="Gráfico&#10;&#10;Descripción generada automáticamente">
                  <a:extLst>
                    <a:ext uri="{FF2B5EF4-FFF2-40B4-BE49-F238E27FC236}">
                      <a16:creationId xmlns:a16="http://schemas.microsoft.com/office/drawing/2014/main" id="{77C5254A-B3C0-EAF0-271E-2BA1026FA83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15310" t="10984" r="12844"/>
                <a:stretch/>
              </p:blipFill>
              <p:spPr>
                <a:xfrm>
                  <a:off x="3502592" y="2367677"/>
                  <a:ext cx="2310039" cy="1816742"/>
                </a:xfrm>
                <a:prstGeom prst="rect">
                  <a:avLst/>
                </a:prstGeom>
              </p:spPr>
            </p:pic>
            <p:pic>
              <p:nvPicPr>
                <p:cNvPr id="59" name="Imagen 58" descr="Gráfico&#10;&#10;Descripción generada automáticamente">
                  <a:extLst>
                    <a:ext uri="{FF2B5EF4-FFF2-40B4-BE49-F238E27FC236}">
                      <a16:creationId xmlns:a16="http://schemas.microsoft.com/office/drawing/2014/main" id="{C678C305-D965-A1C2-B8A8-0B62611114E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8009" t="10984" r="87153" b="11057"/>
                <a:stretch/>
              </p:blipFill>
              <p:spPr>
                <a:xfrm>
                  <a:off x="3371850" y="2368014"/>
                  <a:ext cx="158009" cy="1591555"/>
                </a:xfrm>
                <a:prstGeom prst="rect">
                  <a:avLst/>
                </a:prstGeom>
              </p:spPr>
            </p:pic>
          </p:grpSp>
          <p:sp>
            <p:nvSpPr>
              <p:cNvPr id="62" name="Rectángulo 61">
                <a:extLst>
                  <a:ext uri="{FF2B5EF4-FFF2-40B4-BE49-F238E27FC236}">
                    <a16:creationId xmlns:a16="http://schemas.microsoft.com/office/drawing/2014/main" id="{232CA65E-7CBB-BFCF-F897-5460DB69025D}"/>
                  </a:ext>
                </a:extLst>
              </p:cNvPr>
              <p:cNvSpPr/>
              <p:nvPr/>
            </p:nvSpPr>
            <p:spPr>
              <a:xfrm>
                <a:off x="3529809" y="3420844"/>
                <a:ext cx="334565" cy="4675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37" name="Grupo 95">
              <a:extLst>
                <a:ext uri="{FF2B5EF4-FFF2-40B4-BE49-F238E27FC236}">
                  <a16:creationId xmlns:a16="http://schemas.microsoft.com/office/drawing/2014/main" id="{F1F2726F-46DB-79A9-CD9E-801D2DB1908E}"/>
                </a:ext>
              </a:extLst>
            </p:cNvPr>
            <p:cNvGrpSpPr/>
            <p:nvPr/>
          </p:nvGrpSpPr>
          <p:grpSpPr>
            <a:xfrm>
              <a:off x="5778362" y="3340156"/>
              <a:ext cx="45719" cy="518385"/>
              <a:chOff x="5257800" y="2587625"/>
              <a:chExt cx="47213" cy="866775"/>
            </a:xfrm>
            <a:noFill/>
          </p:grpSpPr>
          <p:cxnSp>
            <p:nvCxnSpPr>
              <p:cNvPr id="38" name="Conector recto 37">
                <a:extLst>
                  <a:ext uri="{FF2B5EF4-FFF2-40B4-BE49-F238E27FC236}">
                    <a16:creationId xmlns:a16="http://schemas.microsoft.com/office/drawing/2014/main" id="{78B76DAD-1E0D-DB76-DDED-B1A4BAF0C7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98663" y="2587625"/>
                <a:ext cx="0" cy="866775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ector recto 38">
                <a:extLst>
                  <a:ext uri="{FF2B5EF4-FFF2-40B4-BE49-F238E27FC236}">
                    <a16:creationId xmlns:a16="http://schemas.microsoft.com/office/drawing/2014/main" id="{BF1D22A9-A23F-7FC8-80D9-13D87FE2CBF4}"/>
                  </a:ext>
                </a:extLst>
              </p:cNvPr>
              <p:cNvCxnSpPr/>
              <p:nvPr/>
            </p:nvCxnSpPr>
            <p:spPr>
              <a:xfrm>
                <a:off x="5257800" y="3286125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Conector recto 46">
                <a:extLst>
                  <a:ext uri="{FF2B5EF4-FFF2-40B4-BE49-F238E27FC236}">
                    <a16:creationId xmlns:a16="http://schemas.microsoft.com/office/drawing/2014/main" id="{9B4232D5-A1CC-A937-4863-5B7DDE7F35EB}"/>
                  </a:ext>
                </a:extLst>
              </p:cNvPr>
              <p:cNvCxnSpPr/>
              <p:nvPr/>
            </p:nvCxnSpPr>
            <p:spPr>
              <a:xfrm>
                <a:off x="5257800" y="3454400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Conector recto 48">
                <a:extLst>
                  <a:ext uri="{FF2B5EF4-FFF2-40B4-BE49-F238E27FC236}">
                    <a16:creationId xmlns:a16="http://schemas.microsoft.com/office/drawing/2014/main" id="{755F2509-8A75-6353-0389-FD518DB3510A}"/>
                  </a:ext>
                </a:extLst>
              </p:cNvPr>
              <p:cNvCxnSpPr/>
              <p:nvPr/>
            </p:nvCxnSpPr>
            <p:spPr>
              <a:xfrm>
                <a:off x="5264150" y="3114675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ector recto 50">
                <a:extLst>
                  <a:ext uri="{FF2B5EF4-FFF2-40B4-BE49-F238E27FC236}">
                    <a16:creationId xmlns:a16="http://schemas.microsoft.com/office/drawing/2014/main" id="{43385C95-B5E8-BF27-52AB-CE763E53BC42}"/>
                  </a:ext>
                </a:extLst>
              </p:cNvPr>
              <p:cNvCxnSpPr/>
              <p:nvPr/>
            </p:nvCxnSpPr>
            <p:spPr>
              <a:xfrm>
                <a:off x="5257800" y="2943225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ector recto 51">
                <a:extLst>
                  <a:ext uri="{FF2B5EF4-FFF2-40B4-BE49-F238E27FC236}">
                    <a16:creationId xmlns:a16="http://schemas.microsoft.com/office/drawing/2014/main" id="{E888C2BA-DDFA-3C44-B984-75E651554BA8}"/>
                  </a:ext>
                </a:extLst>
              </p:cNvPr>
              <p:cNvCxnSpPr/>
              <p:nvPr/>
            </p:nvCxnSpPr>
            <p:spPr>
              <a:xfrm>
                <a:off x="5257800" y="2765425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Conector recto 52">
                <a:extLst>
                  <a:ext uri="{FF2B5EF4-FFF2-40B4-BE49-F238E27FC236}">
                    <a16:creationId xmlns:a16="http://schemas.microsoft.com/office/drawing/2014/main" id="{2EFDF184-C93E-003D-2B0D-9E0CB453DF1F}"/>
                  </a:ext>
                </a:extLst>
              </p:cNvPr>
              <p:cNvCxnSpPr/>
              <p:nvPr/>
            </p:nvCxnSpPr>
            <p:spPr>
              <a:xfrm>
                <a:off x="5257800" y="2590800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4" name="Grupo 53">
              <a:extLst>
                <a:ext uri="{FF2B5EF4-FFF2-40B4-BE49-F238E27FC236}">
                  <a16:creationId xmlns:a16="http://schemas.microsoft.com/office/drawing/2014/main" id="{4CE3BC72-C94C-3297-91D8-4A813600207E}"/>
                </a:ext>
              </a:extLst>
            </p:cNvPr>
            <p:cNvGrpSpPr/>
            <p:nvPr/>
          </p:nvGrpSpPr>
          <p:grpSpPr>
            <a:xfrm>
              <a:off x="5807847" y="3270131"/>
              <a:ext cx="66418" cy="663319"/>
              <a:chOff x="3288653" y="3400486"/>
              <a:chExt cx="110706" cy="663319"/>
            </a:xfrm>
            <a:noFill/>
          </p:grpSpPr>
          <p:sp>
            <p:nvSpPr>
              <p:cNvPr id="55" name="CuadroTexto 54">
                <a:extLst>
                  <a:ext uri="{FF2B5EF4-FFF2-40B4-BE49-F238E27FC236}">
                    <a16:creationId xmlns:a16="http://schemas.microsoft.com/office/drawing/2014/main" id="{DD24EDFD-54DD-9CAC-8706-8127344D0F73}"/>
                  </a:ext>
                </a:extLst>
              </p:cNvPr>
              <p:cNvSpPr txBox="1"/>
              <p:nvPr/>
            </p:nvSpPr>
            <p:spPr>
              <a:xfrm>
                <a:off x="3304798" y="3909917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0</a:t>
                </a:r>
              </a:p>
            </p:txBody>
          </p:sp>
          <p:sp>
            <p:nvSpPr>
              <p:cNvPr id="60" name="CuadroTexto 59">
                <a:extLst>
                  <a:ext uri="{FF2B5EF4-FFF2-40B4-BE49-F238E27FC236}">
                    <a16:creationId xmlns:a16="http://schemas.microsoft.com/office/drawing/2014/main" id="{86455DE6-075D-A9A5-EEA9-85290443740C}"/>
                  </a:ext>
                </a:extLst>
              </p:cNvPr>
              <p:cNvSpPr txBox="1"/>
              <p:nvPr/>
            </p:nvSpPr>
            <p:spPr>
              <a:xfrm>
                <a:off x="3300184" y="3812657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1</a:t>
                </a:r>
              </a:p>
            </p:txBody>
          </p:sp>
          <p:sp>
            <p:nvSpPr>
              <p:cNvPr id="64" name="CuadroTexto 63">
                <a:extLst>
                  <a:ext uri="{FF2B5EF4-FFF2-40B4-BE49-F238E27FC236}">
                    <a16:creationId xmlns:a16="http://schemas.microsoft.com/office/drawing/2014/main" id="{85FA41AE-76D1-A846-3F94-1A59D17F402D}"/>
                  </a:ext>
                </a:extLst>
              </p:cNvPr>
              <p:cNvSpPr txBox="1"/>
              <p:nvPr/>
            </p:nvSpPr>
            <p:spPr>
              <a:xfrm>
                <a:off x="3300184" y="3713775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2</a:t>
                </a:r>
              </a:p>
            </p:txBody>
          </p:sp>
          <p:sp>
            <p:nvSpPr>
              <p:cNvPr id="67" name="CuadroTexto 66">
                <a:extLst>
                  <a:ext uri="{FF2B5EF4-FFF2-40B4-BE49-F238E27FC236}">
                    <a16:creationId xmlns:a16="http://schemas.microsoft.com/office/drawing/2014/main" id="{39BA3AA2-B526-28AD-1BED-571C91682EEA}"/>
                  </a:ext>
                </a:extLst>
              </p:cNvPr>
              <p:cNvSpPr txBox="1"/>
              <p:nvPr/>
            </p:nvSpPr>
            <p:spPr>
              <a:xfrm>
                <a:off x="3295779" y="3610398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3</a:t>
                </a:r>
              </a:p>
            </p:txBody>
          </p:sp>
          <p:sp>
            <p:nvSpPr>
              <p:cNvPr id="71" name="CuadroTexto 70">
                <a:extLst>
                  <a:ext uri="{FF2B5EF4-FFF2-40B4-BE49-F238E27FC236}">
                    <a16:creationId xmlns:a16="http://schemas.microsoft.com/office/drawing/2014/main" id="{294C8DA3-D3CD-B1C9-42BE-75CABC9C8BBE}"/>
                  </a:ext>
                </a:extLst>
              </p:cNvPr>
              <p:cNvSpPr txBox="1"/>
              <p:nvPr/>
            </p:nvSpPr>
            <p:spPr>
              <a:xfrm>
                <a:off x="3292322" y="3495799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4</a:t>
                </a:r>
              </a:p>
            </p:txBody>
          </p:sp>
          <p:sp>
            <p:nvSpPr>
              <p:cNvPr id="82" name="CuadroTexto 81">
                <a:extLst>
                  <a:ext uri="{FF2B5EF4-FFF2-40B4-BE49-F238E27FC236}">
                    <a16:creationId xmlns:a16="http://schemas.microsoft.com/office/drawing/2014/main" id="{9C39C3A6-BDB3-24CE-D6D1-224D581B80B3}"/>
                  </a:ext>
                </a:extLst>
              </p:cNvPr>
              <p:cNvSpPr txBox="1"/>
              <p:nvPr/>
            </p:nvSpPr>
            <p:spPr>
              <a:xfrm>
                <a:off x="3288653" y="3400486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5</a:t>
                </a:r>
              </a:p>
            </p:txBody>
          </p:sp>
        </p:grpSp>
        <p:sp>
          <p:nvSpPr>
            <p:cNvPr id="87" name="Rectángulo 86">
              <a:extLst>
                <a:ext uri="{FF2B5EF4-FFF2-40B4-BE49-F238E27FC236}">
                  <a16:creationId xmlns:a16="http://schemas.microsoft.com/office/drawing/2014/main" id="{6CB9BB00-8260-321C-3BD1-81F3D6AFCD10}"/>
                </a:ext>
              </a:extLst>
            </p:cNvPr>
            <p:cNvSpPr/>
            <p:nvPr/>
          </p:nvSpPr>
          <p:spPr>
            <a:xfrm>
              <a:off x="5803017" y="3932556"/>
              <a:ext cx="77083" cy="10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grpSp>
          <p:nvGrpSpPr>
            <p:cNvPr id="95" name="Grupo 95">
              <a:extLst>
                <a:ext uri="{FF2B5EF4-FFF2-40B4-BE49-F238E27FC236}">
                  <a16:creationId xmlns:a16="http://schemas.microsoft.com/office/drawing/2014/main" id="{52227022-98C4-CA02-4AF2-7F219152156A}"/>
                </a:ext>
              </a:extLst>
            </p:cNvPr>
            <p:cNvGrpSpPr/>
            <p:nvPr/>
          </p:nvGrpSpPr>
          <p:grpSpPr>
            <a:xfrm>
              <a:off x="3146287" y="3336981"/>
              <a:ext cx="45719" cy="518385"/>
              <a:chOff x="5257800" y="2587625"/>
              <a:chExt cx="47213" cy="866775"/>
            </a:xfrm>
            <a:noFill/>
          </p:grpSpPr>
          <p:cxnSp>
            <p:nvCxnSpPr>
              <p:cNvPr id="96" name="Conector recto 95">
                <a:extLst>
                  <a:ext uri="{FF2B5EF4-FFF2-40B4-BE49-F238E27FC236}">
                    <a16:creationId xmlns:a16="http://schemas.microsoft.com/office/drawing/2014/main" id="{1B013964-2C2C-1A59-EA88-101AA251F0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98663" y="2587625"/>
                <a:ext cx="0" cy="866775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Conector recto 96">
                <a:extLst>
                  <a:ext uri="{FF2B5EF4-FFF2-40B4-BE49-F238E27FC236}">
                    <a16:creationId xmlns:a16="http://schemas.microsoft.com/office/drawing/2014/main" id="{EDB4035A-CCA3-F793-D131-3B39C6C7C907}"/>
                  </a:ext>
                </a:extLst>
              </p:cNvPr>
              <p:cNvCxnSpPr/>
              <p:nvPr/>
            </p:nvCxnSpPr>
            <p:spPr>
              <a:xfrm>
                <a:off x="5257800" y="3286125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Conector recto 97">
                <a:extLst>
                  <a:ext uri="{FF2B5EF4-FFF2-40B4-BE49-F238E27FC236}">
                    <a16:creationId xmlns:a16="http://schemas.microsoft.com/office/drawing/2014/main" id="{B30DF344-4F9E-A00D-77D7-274B92F4C523}"/>
                  </a:ext>
                </a:extLst>
              </p:cNvPr>
              <p:cNvCxnSpPr/>
              <p:nvPr/>
            </p:nvCxnSpPr>
            <p:spPr>
              <a:xfrm>
                <a:off x="5257800" y="3454400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Conector recto 98">
                <a:extLst>
                  <a:ext uri="{FF2B5EF4-FFF2-40B4-BE49-F238E27FC236}">
                    <a16:creationId xmlns:a16="http://schemas.microsoft.com/office/drawing/2014/main" id="{7865DB2A-3D35-3E05-C876-B2426A14B226}"/>
                  </a:ext>
                </a:extLst>
              </p:cNvPr>
              <p:cNvCxnSpPr/>
              <p:nvPr/>
            </p:nvCxnSpPr>
            <p:spPr>
              <a:xfrm>
                <a:off x="5264150" y="3114675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Conector recto 99">
                <a:extLst>
                  <a:ext uri="{FF2B5EF4-FFF2-40B4-BE49-F238E27FC236}">
                    <a16:creationId xmlns:a16="http://schemas.microsoft.com/office/drawing/2014/main" id="{C2190C47-E506-9DC4-AB22-666CF137EE95}"/>
                  </a:ext>
                </a:extLst>
              </p:cNvPr>
              <p:cNvCxnSpPr/>
              <p:nvPr/>
            </p:nvCxnSpPr>
            <p:spPr>
              <a:xfrm>
                <a:off x="5257800" y="2943225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Conector recto 100">
                <a:extLst>
                  <a:ext uri="{FF2B5EF4-FFF2-40B4-BE49-F238E27FC236}">
                    <a16:creationId xmlns:a16="http://schemas.microsoft.com/office/drawing/2014/main" id="{8F0E8717-004F-489B-154F-7346F657F87B}"/>
                  </a:ext>
                </a:extLst>
              </p:cNvPr>
              <p:cNvCxnSpPr/>
              <p:nvPr/>
            </p:nvCxnSpPr>
            <p:spPr>
              <a:xfrm>
                <a:off x="5257800" y="2765425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Conector recto 101">
                <a:extLst>
                  <a:ext uri="{FF2B5EF4-FFF2-40B4-BE49-F238E27FC236}">
                    <a16:creationId xmlns:a16="http://schemas.microsoft.com/office/drawing/2014/main" id="{2F26C559-90D7-AD02-7240-A56DF430EB9B}"/>
                  </a:ext>
                </a:extLst>
              </p:cNvPr>
              <p:cNvCxnSpPr/>
              <p:nvPr/>
            </p:nvCxnSpPr>
            <p:spPr>
              <a:xfrm>
                <a:off x="5257800" y="2590800"/>
                <a:ext cx="40863" cy="0"/>
              </a:xfrm>
              <a:prstGeom prst="line">
                <a:avLst/>
              </a:prstGeom>
              <a:grpFill/>
              <a:ln w="952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1" name="Rectángulo 110">
              <a:extLst>
                <a:ext uri="{FF2B5EF4-FFF2-40B4-BE49-F238E27FC236}">
                  <a16:creationId xmlns:a16="http://schemas.microsoft.com/office/drawing/2014/main" id="{E16F70C8-1927-9322-52DC-FE02849473A8}"/>
                </a:ext>
              </a:extLst>
            </p:cNvPr>
            <p:cNvSpPr/>
            <p:nvPr/>
          </p:nvSpPr>
          <p:spPr>
            <a:xfrm>
              <a:off x="3196342" y="3270132"/>
              <a:ext cx="77083" cy="6763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12" name="Rectángulo 111">
              <a:extLst>
                <a:ext uri="{FF2B5EF4-FFF2-40B4-BE49-F238E27FC236}">
                  <a16:creationId xmlns:a16="http://schemas.microsoft.com/office/drawing/2014/main" id="{7AE13DF0-CFE5-FA0C-3737-C2F275612DFB}"/>
                </a:ext>
              </a:extLst>
            </p:cNvPr>
            <p:cNvSpPr/>
            <p:nvPr/>
          </p:nvSpPr>
          <p:spPr>
            <a:xfrm>
              <a:off x="3104267" y="3897631"/>
              <a:ext cx="77083" cy="7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grpSp>
          <p:nvGrpSpPr>
            <p:cNvPr id="88" name="Grupo 87">
              <a:extLst>
                <a:ext uri="{FF2B5EF4-FFF2-40B4-BE49-F238E27FC236}">
                  <a16:creationId xmlns:a16="http://schemas.microsoft.com/office/drawing/2014/main" id="{92C77465-8522-E01B-DA40-57CA96C12D9E}"/>
                </a:ext>
              </a:extLst>
            </p:cNvPr>
            <p:cNvGrpSpPr/>
            <p:nvPr/>
          </p:nvGrpSpPr>
          <p:grpSpPr>
            <a:xfrm>
              <a:off x="3178545" y="3267613"/>
              <a:ext cx="66418" cy="663319"/>
              <a:chOff x="3288653" y="3400486"/>
              <a:chExt cx="110706" cy="663319"/>
            </a:xfrm>
            <a:noFill/>
          </p:grpSpPr>
          <p:sp>
            <p:nvSpPr>
              <p:cNvPr id="89" name="CuadroTexto 88">
                <a:extLst>
                  <a:ext uri="{FF2B5EF4-FFF2-40B4-BE49-F238E27FC236}">
                    <a16:creationId xmlns:a16="http://schemas.microsoft.com/office/drawing/2014/main" id="{D3F1F90B-1CED-9DBD-053C-B537DC8C8AFD}"/>
                  </a:ext>
                </a:extLst>
              </p:cNvPr>
              <p:cNvSpPr txBox="1"/>
              <p:nvPr/>
            </p:nvSpPr>
            <p:spPr>
              <a:xfrm>
                <a:off x="3304798" y="3909917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0</a:t>
                </a:r>
              </a:p>
            </p:txBody>
          </p:sp>
          <p:sp>
            <p:nvSpPr>
              <p:cNvPr id="90" name="CuadroTexto 89">
                <a:extLst>
                  <a:ext uri="{FF2B5EF4-FFF2-40B4-BE49-F238E27FC236}">
                    <a16:creationId xmlns:a16="http://schemas.microsoft.com/office/drawing/2014/main" id="{71426B1E-8DC9-35EC-7A8B-6F912EFD85C7}"/>
                  </a:ext>
                </a:extLst>
              </p:cNvPr>
              <p:cNvSpPr txBox="1"/>
              <p:nvPr/>
            </p:nvSpPr>
            <p:spPr>
              <a:xfrm>
                <a:off x="3300184" y="3812657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1</a:t>
                </a:r>
              </a:p>
            </p:txBody>
          </p:sp>
          <p:sp>
            <p:nvSpPr>
              <p:cNvPr id="91" name="CuadroTexto 90">
                <a:extLst>
                  <a:ext uri="{FF2B5EF4-FFF2-40B4-BE49-F238E27FC236}">
                    <a16:creationId xmlns:a16="http://schemas.microsoft.com/office/drawing/2014/main" id="{583BE4DF-E4A3-5ED8-5D96-D6B63FBDFA1F}"/>
                  </a:ext>
                </a:extLst>
              </p:cNvPr>
              <p:cNvSpPr txBox="1"/>
              <p:nvPr/>
            </p:nvSpPr>
            <p:spPr>
              <a:xfrm>
                <a:off x="3300184" y="3713775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2</a:t>
                </a:r>
              </a:p>
            </p:txBody>
          </p:sp>
          <p:sp>
            <p:nvSpPr>
              <p:cNvPr id="92" name="CuadroTexto 91">
                <a:extLst>
                  <a:ext uri="{FF2B5EF4-FFF2-40B4-BE49-F238E27FC236}">
                    <a16:creationId xmlns:a16="http://schemas.microsoft.com/office/drawing/2014/main" id="{2716F3EF-92AE-EDF0-6529-0CD850C8F5AC}"/>
                  </a:ext>
                </a:extLst>
              </p:cNvPr>
              <p:cNvSpPr txBox="1"/>
              <p:nvPr/>
            </p:nvSpPr>
            <p:spPr>
              <a:xfrm>
                <a:off x="3295779" y="3610398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3</a:t>
                </a:r>
              </a:p>
            </p:txBody>
          </p:sp>
          <p:sp>
            <p:nvSpPr>
              <p:cNvPr id="93" name="CuadroTexto 92">
                <a:extLst>
                  <a:ext uri="{FF2B5EF4-FFF2-40B4-BE49-F238E27FC236}">
                    <a16:creationId xmlns:a16="http://schemas.microsoft.com/office/drawing/2014/main" id="{8BA907D0-FBEF-49D7-A99D-F2F02E3C3D64}"/>
                  </a:ext>
                </a:extLst>
              </p:cNvPr>
              <p:cNvSpPr txBox="1"/>
              <p:nvPr/>
            </p:nvSpPr>
            <p:spPr>
              <a:xfrm>
                <a:off x="3292322" y="3495799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4</a:t>
                </a:r>
              </a:p>
            </p:txBody>
          </p:sp>
          <p:sp>
            <p:nvSpPr>
              <p:cNvPr id="94" name="CuadroTexto 93">
                <a:extLst>
                  <a:ext uri="{FF2B5EF4-FFF2-40B4-BE49-F238E27FC236}">
                    <a16:creationId xmlns:a16="http://schemas.microsoft.com/office/drawing/2014/main" id="{9F28CACB-D08F-A3B1-8C3E-CFA2C3A49B46}"/>
                  </a:ext>
                </a:extLst>
              </p:cNvPr>
              <p:cNvSpPr txBox="1"/>
              <p:nvPr/>
            </p:nvSpPr>
            <p:spPr>
              <a:xfrm>
                <a:off x="3288653" y="3400486"/>
                <a:ext cx="94561" cy="153888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b="1" dirty="0">
                    <a:solidFill>
                      <a:srgbClr val="FFC000"/>
                    </a:solidFill>
                  </a:rPr>
                  <a:t>5</a:t>
                </a:r>
              </a:p>
            </p:txBody>
          </p:sp>
        </p:grpSp>
        <p:sp>
          <p:nvSpPr>
            <p:cNvPr id="113" name="CuadroTexto 112">
              <a:extLst>
                <a:ext uri="{FF2B5EF4-FFF2-40B4-BE49-F238E27FC236}">
                  <a16:creationId xmlns:a16="http://schemas.microsoft.com/office/drawing/2014/main" id="{9011EC6B-2213-6DE0-7D6B-2F3CAB3962C8}"/>
                </a:ext>
              </a:extLst>
            </p:cNvPr>
            <p:cNvSpPr txBox="1"/>
            <p:nvPr/>
          </p:nvSpPr>
          <p:spPr>
            <a:xfrm rot="5400000">
              <a:off x="3004422" y="3466362"/>
              <a:ext cx="421071" cy="2786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400" dirty="0"/>
                <a:t>MIB score</a:t>
              </a:r>
            </a:p>
          </p:txBody>
        </p:sp>
        <p:pic>
          <p:nvPicPr>
            <p:cNvPr id="120" name="Imagen 119" descr="Escala de tiempo&#10;&#10;Descripción generada automáticamente">
              <a:extLst>
                <a:ext uri="{FF2B5EF4-FFF2-40B4-BE49-F238E27FC236}">
                  <a16:creationId xmlns:a16="http://schemas.microsoft.com/office/drawing/2014/main" id="{979F316C-A31E-AC9C-417A-E5FC563B501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67501" y="5326143"/>
              <a:ext cx="2451518" cy="1654775"/>
            </a:xfrm>
            <a:prstGeom prst="rect">
              <a:avLst/>
            </a:prstGeom>
          </p:spPr>
        </p:pic>
        <p:sp>
          <p:nvSpPr>
            <p:cNvPr id="122" name="CuadroTexto 121">
              <a:extLst>
                <a:ext uri="{FF2B5EF4-FFF2-40B4-BE49-F238E27FC236}">
                  <a16:creationId xmlns:a16="http://schemas.microsoft.com/office/drawing/2014/main" id="{45CB5B0C-4DFB-8545-A44F-F50604DEC04E}"/>
                </a:ext>
              </a:extLst>
            </p:cNvPr>
            <p:cNvSpPr txBox="1"/>
            <p:nvPr/>
          </p:nvSpPr>
          <p:spPr>
            <a:xfrm>
              <a:off x="374679" y="5114155"/>
              <a:ext cx="4224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dirty="0"/>
                <a:t>D</a:t>
              </a:r>
            </a:p>
          </p:txBody>
        </p:sp>
        <p:sp>
          <p:nvSpPr>
            <p:cNvPr id="123" name="CuadroTexto 122">
              <a:extLst>
                <a:ext uri="{FF2B5EF4-FFF2-40B4-BE49-F238E27FC236}">
                  <a16:creationId xmlns:a16="http://schemas.microsoft.com/office/drawing/2014/main" id="{1B2D8F19-09AA-DE18-2696-300DAA896F71}"/>
                </a:ext>
              </a:extLst>
            </p:cNvPr>
            <p:cNvSpPr txBox="1"/>
            <p:nvPr/>
          </p:nvSpPr>
          <p:spPr>
            <a:xfrm>
              <a:off x="371331" y="7110434"/>
              <a:ext cx="4224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dirty="0"/>
                <a:t>E</a:t>
              </a:r>
            </a:p>
          </p:txBody>
        </p:sp>
        <p:sp>
          <p:nvSpPr>
            <p:cNvPr id="126" name="CuadroTexto 125">
              <a:extLst>
                <a:ext uri="{FF2B5EF4-FFF2-40B4-BE49-F238E27FC236}">
                  <a16:creationId xmlns:a16="http://schemas.microsoft.com/office/drawing/2014/main" id="{FC8C91F3-4EA0-2F7C-87DB-A625DA124932}"/>
                </a:ext>
              </a:extLst>
            </p:cNvPr>
            <p:cNvSpPr txBox="1"/>
            <p:nvPr/>
          </p:nvSpPr>
          <p:spPr>
            <a:xfrm>
              <a:off x="1097836" y="3147217"/>
              <a:ext cx="31732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400" dirty="0"/>
                <a:t>H44</a:t>
              </a:r>
            </a:p>
          </p:txBody>
        </p:sp>
        <p:sp>
          <p:nvSpPr>
            <p:cNvPr id="127" name="CuadroTexto 126">
              <a:extLst>
                <a:ext uri="{FF2B5EF4-FFF2-40B4-BE49-F238E27FC236}">
                  <a16:creationId xmlns:a16="http://schemas.microsoft.com/office/drawing/2014/main" id="{262DDD2A-D169-1673-8D41-3E4582760910}"/>
                </a:ext>
              </a:extLst>
            </p:cNvPr>
            <p:cNvSpPr txBox="1"/>
            <p:nvPr/>
          </p:nvSpPr>
          <p:spPr>
            <a:xfrm>
              <a:off x="1363909" y="3144711"/>
              <a:ext cx="31732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400" dirty="0"/>
                <a:t>H53</a:t>
              </a:r>
            </a:p>
          </p:txBody>
        </p:sp>
        <p:sp>
          <p:nvSpPr>
            <p:cNvPr id="128" name="CuadroTexto 127">
              <a:extLst>
                <a:ext uri="{FF2B5EF4-FFF2-40B4-BE49-F238E27FC236}">
                  <a16:creationId xmlns:a16="http://schemas.microsoft.com/office/drawing/2014/main" id="{7FDE8402-2A1A-7C7A-7519-A0D695617686}"/>
                </a:ext>
              </a:extLst>
            </p:cNvPr>
            <p:cNvSpPr txBox="1"/>
            <p:nvPr/>
          </p:nvSpPr>
          <p:spPr>
            <a:xfrm>
              <a:off x="1465110" y="3144711"/>
              <a:ext cx="317327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400" dirty="0"/>
                <a:t>H55</a:t>
              </a:r>
            </a:p>
          </p:txBody>
        </p:sp>
        <p:pic>
          <p:nvPicPr>
            <p:cNvPr id="138" name="Imagen 137">
              <a:extLst>
                <a:ext uri="{FF2B5EF4-FFF2-40B4-BE49-F238E27FC236}">
                  <a16:creationId xmlns:a16="http://schemas.microsoft.com/office/drawing/2014/main" id="{FC6BC73E-97CE-47DB-6D21-572F91624F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4502" t="72270" r="12900" b="4152"/>
            <a:stretch/>
          </p:blipFill>
          <p:spPr>
            <a:xfrm>
              <a:off x="3522247" y="3338880"/>
              <a:ext cx="2280748" cy="570342"/>
            </a:xfrm>
            <a:prstGeom prst="rect">
              <a:avLst/>
            </a:prstGeom>
          </p:spPr>
        </p:pic>
        <p:sp>
          <p:nvSpPr>
            <p:cNvPr id="114" name="Rectángulo 113">
              <a:extLst>
                <a:ext uri="{FF2B5EF4-FFF2-40B4-BE49-F238E27FC236}">
                  <a16:creationId xmlns:a16="http://schemas.microsoft.com/office/drawing/2014/main" id="{2BE88C00-6B8E-FF97-9EA1-C9EB9E2F5AD1}"/>
                </a:ext>
              </a:extLst>
            </p:cNvPr>
            <p:cNvSpPr/>
            <p:nvPr/>
          </p:nvSpPr>
          <p:spPr>
            <a:xfrm>
              <a:off x="3515392" y="2298381"/>
              <a:ext cx="64598" cy="1611905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115" name="Rectángulo 114">
              <a:extLst>
                <a:ext uri="{FF2B5EF4-FFF2-40B4-BE49-F238E27FC236}">
                  <a16:creationId xmlns:a16="http://schemas.microsoft.com/office/drawing/2014/main" id="{3F3BEBBC-529D-6ACF-FADE-677160C9C9D7}"/>
                </a:ext>
              </a:extLst>
            </p:cNvPr>
            <p:cNvSpPr/>
            <p:nvPr/>
          </p:nvSpPr>
          <p:spPr>
            <a:xfrm>
              <a:off x="3849889" y="2298381"/>
              <a:ext cx="186159" cy="1611905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116" name="Rectángulo 115">
              <a:extLst>
                <a:ext uri="{FF2B5EF4-FFF2-40B4-BE49-F238E27FC236}">
                  <a16:creationId xmlns:a16="http://schemas.microsoft.com/office/drawing/2014/main" id="{32A4D2E9-F7BA-7051-E3B8-31B311F48C52}"/>
                </a:ext>
              </a:extLst>
            </p:cNvPr>
            <p:cNvSpPr/>
            <p:nvPr/>
          </p:nvSpPr>
          <p:spPr>
            <a:xfrm>
              <a:off x="4216694" y="2292926"/>
              <a:ext cx="122808" cy="1611905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pic>
          <p:nvPicPr>
            <p:cNvPr id="139" name="Imagen 138">
              <a:extLst>
                <a:ext uri="{FF2B5EF4-FFF2-40B4-BE49-F238E27FC236}">
                  <a16:creationId xmlns:a16="http://schemas.microsoft.com/office/drawing/2014/main" id="{3C3A25C1-A9DF-83B1-DC83-F890950502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1212" t="72377" r="9091" b="4373"/>
            <a:stretch/>
          </p:blipFill>
          <p:spPr>
            <a:xfrm>
              <a:off x="910674" y="3353322"/>
              <a:ext cx="2274377" cy="552532"/>
            </a:xfrm>
            <a:prstGeom prst="rect">
              <a:avLst/>
            </a:prstGeom>
          </p:spPr>
        </p:pic>
        <p:sp>
          <p:nvSpPr>
            <p:cNvPr id="117" name="Rectángulo 116">
              <a:extLst>
                <a:ext uri="{FF2B5EF4-FFF2-40B4-BE49-F238E27FC236}">
                  <a16:creationId xmlns:a16="http://schemas.microsoft.com/office/drawing/2014/main" id="{7721CCC2-2CE8-6F9B-54E2-D12C9AA596F3}"/>
                </a:ext>
              </a:extLst>
            </p:cNvPr>
            <p:cNvSpPr/>
            <p:nvPr/>
          </p:nvSpPr>
          <p:spPr>
            <a:xfrm>
              <a:off x="4528688" y="2298381"/>
              <a:ext cx="194354" cy="1611905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118" name="Rectángulo 117">
              <a:extLst>
                <a:ext uri="{FF2B5EF4-FFF2-40B4-BE49-F238E27FC236}">
                  <a16:creationId xmlns:a16="http://schemas.microsoft.com/office/drawing/2014/main" id="{D5CE85FA-BDD3-DADC-3006-9BB140F43283}"/>
                </a:ext>
              </a:extLst>
            </p:cNvPr>
            <p:cNvSpPr/>
            <p:nvPr/>
          </p:nvSpPr>
          <p:spPr>
            <a:xfrm>
              <a:off x="5300893" y="2296324"/>
              <a:ext cx="46810" cy="1611905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119" name="Rectángulo 118">
              <a:extLst>
                <a:ext uri="{FF2B5EF4-FFF2-40B4-BE49-F238E27FC236}">
                  <a16:creationId xmlns:a16="http://schemas.microsoft.com/office/drawing/2014/main" id="{1D9C9BF4-5C42-4243-1D12-FB298BAC5B41}"/>
                </a:ext>
              </a:extLst>
            </p:cNvPr>
            <p:cNvSpPr/>
            <p:nvPr/>
          </p:nvSpPr>
          <p:spPr>
            <a:xfrm>
              <a:off x="5718378" y="2308048"/>
              <a:ext cx="46810" cy="1611905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8" name="Rectángulo 7">
              <a:extLst>
                <a:ext uri="{FF2B5EF4-FFF2-40B4-BE49-F238E27FC236}">
                  <a16:creationId xmlns:a16="http://schemas.microsoft.com/office/drawing/2014/main" id="{17843040-94AB-880F-9C89-AB7696F1944C}"/>
                </a:ext>
              </a:extLst>
            </p:cNvPr>
            <p:cNvSpPr/>
            <p:nvPr/>
          </p:nvSpPr>
          <p:spPr>
            <a:xfrm>
              <a:off x="912472" y="2302114"/>
              <a:ext cx="108538" cy="1611905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10" name="Rectángulo 9">
              <a:extLst>
                <a:ext uri="{FF2B5EF4-FFF2-40B4-BE49-F238E27FC236}">
                  <a16:creationId xmlns:a16="http://schemas.microsoft.com/office/drawing/2014/main" id="{FFB52DBD-C116-B296-5E60-721A39CC4067}"/>
                </a:ext>
              </a:extLst>
            </p:cNvPr>
            <p:cNvSpPr/>
            <p:nvPr/>
          </p:nvSpPr>
          <p:spPr>
            <a:xfrm>
              <a:off x="1645781" y="2300344"/>
              <a:ext cx="118361" cy="1621956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11" name="Rectángulo 10">
              <a:extLst>
                <a:ext uri="{FF2B5EF4-FFF2-40B4-BE49-F238E27FC236}">
                  <a16:creationId xmlns:a16="http://schemas.microsoft.com/office/drawing/2014/main" id="{3C401836-077E-FBCA-852A-A7F8E96109AA}"/>
                </a:ext>
              </a:extLst>
            </p:cNvPr>
            <p:cNvSpPr/>
            <p:nvPr/>
          </p:nvSpPr>
          <p:spPr>
            <a:xfrm>
              <a:off x="2033127" y="2294650"/>
              <a:ext cx="140747" cy="1619369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12" name="Rectángulo 11">
              <a:extLst>
                <a:ext uri="{FF2B5EF4-FFF2-40B4-BE49-F238E27FC236}">
                  <a16:creationId xmlns:a16="http://schemas.microsoft.com/office/drawing/2014/main" id="{D1C2516E-A669-2895-6EAD-75EAB7B28E1A}"/>
                </a:ext>
              </a:extLst>
            </p:cNvPr>
            <p:cNvSpPr/>
            <p:nvPr/>
          </p:nvSpPr>
          <p:spPr>
            <a:xfrm>
              <a:off x="2640691" y="2294650"/>
              <a:ext cx="48240" cy="1627649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cxnSp>
          <p:nvCxnSpPr>
            <p:cNvPr id="130" name="Conector recto de flecha 129">
              <a:extLst>
                <a:ext uri="{FF2B5EF4-FFF2-40B4-BE49-F238E27FC236}">
                  <a16:creationId xmlns:a16="http://schemas.microsoft.com/office/drawing/2014/main" id="{8DDC1543-7972-BA19-33AC-6157B9FFACF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256500" y="3256654"/>
              <a:ext cx="67475" cy="129600"/>
            </a:xfrm>
            <a:prstGeom prst="straightConnector1">
              <a:avLst/>
            </a:prstGeom>
            <a:ln w="3810" cmpd="dbl">
              <a:solidFill>
                <a:schemeClr val="tx1"/>
              </a:solidFill>
              <a:prstDash val="sysDot"/>
              <a:headEnd w="sm" len="sm"/>
              <a:tailEnd type="arrow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ector recto de flecha 130">
              <a:extLst>
                <a:ext uri="{FF2B5EF4-FFF2-40B4-BE49-F238E27FC236}">
                  <a16:creationId xmlns:a16="http://schemas.microsoft.com/office/drawing/2014/main" id="{C7F3A268-088D-BBF7-C5E0-BD4BCF8298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06524" y="3237530"/>
              <a:ext cx="90000" cy="151200"/>
            </a:xfrm>
            <a:prstGeom prst="straightConnector1">
              <a:avLst/>
            </a:prstGeom>
            <a:ln w="3810" cmpd="dbl">
              <a:solidFill>
                <a:schemeClr val="tx1"/>
              </a:solidFill>
              <a:prstDash val="sysDot"/>
              <a:headEnd w="sm" len="sm"/>
              <a:tailEnd type="arrow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Conector recto de flecha 132">
              <a:extLst>
                <a:ext uri="{FF2B5EF4-FFF2-40B4-BE49-F238E27FC236}">
                  <a16:creationId xmlns:a16="http://schemas.microsoft.com/office/drawing/2014/main" id="{2FD603DD-D055-3A3F-5B3E-179A3A99DBD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31924" y="3250973"/>
              <a:ext cx="162000" cy="133200"/>
            </a:xfrm>
            <a:prstGeom prst="straightConnector1">
              <a:avLst/>
            </a:prstGeom>
            <a:ln w="3810" cmpd="dbl">
              <a:solidFill>
                <a:schemeClr val="tx1"/>
              </a:solidFill>
              <a:prstDash val="sysDot"/>
              <a:headEnd w="sm" len="sm"/>
              <a:tailEnd type="arrow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ángulo 8">
              <a:extLst>
                <a:ext uri="{FF2B5EF4-FFF2-40B4-BE49-F238E27FC236}">
                  <a16:creationId xmlns:a16="http://schemas.microsoft.com/office/drawing/2014/main" id="{E94FB839-DBAC-D065-408E-F4E773DD39C5}"/>
                </a:ext>
              </a:extLst>
            </p:cNvPr>
            <p:cNvSpPr/>
            <p:nvPr/>
          </p:nvSpPr>
          <p:spPr>
            <a:xfrm>
              <a:off x="1288252" y="2302114"/>
              <a:ext cx="180842" cy="1627649"/>
            </a:xfrm>
            <a:prstGeom prst="rect">
              <a:avLst/>
            </a:prstGeom>
            <a:solidFill>
              <a:schemeClr val="bg2">
                <a:alpha val="32374"/>
              </a:schemeClr>
            </a:solidFill>
            <a:ln>
              <a:noFill/>
            </a:ln>
            <a:effectLst>
              <a:reflection endPos="0" dist="50800" dir="5400000" sy="-100000" algn="bl" rotWithShape="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3" name="Rectángulo 2">
              <a:extLst>
                <a:ext uri="{FF2B5EF4-FFF2-40B4-BE49-F238E27FC236}">
                  <a16:creationId xmlns:a16="http://schemas.microsoft.com/office/drawing/2014/main" id="{39EF1756-DDC6-D559-0E19-B9593804957C}"/>
                </a:ext>
              </a:extLst>
            </p:cNvPr>
            <p:cNvSpPr/>
            <p:nvPr/>
          </p:nvSpPr>
          <p:spPr>
            <a:xfrm>
              <a:off x="912471" y="3340157"/>
              <a:ext cx="2278904" cy="577037"/>
            </a:xfrm>
            <a:prstGeom prst="rect">
              <a:avLst/>
            </a:prstGeom>
            <a:noFill/>
            <a:ln w="6350">
              <a:solidFill>
                <a:srgbClr val="FFC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66" name="Rectángulo 65">
              <a:extLst>
                <a:ext uri="{FF2B5EF4-FFF2-40B4-BE49-F238E27FC236}">
                  <a16:creationId xmlns:a16="http://schemas.microsoft.com/office/drawing/2014/main" id="{55D6D51C-01AA-2796-18DF-DC62936BA4A9}"/>
                </a:ext>
              </a:extLst>
            </p:cNvPr>
            <p:cNvSpPr/>
            <p:nvPr/>
          </p:nvSpPr>
          <p:spPr>
            <a:xfrm>
              <a:off x="3519188" y="3348092"/>
              <a:ext cx="2305226" cy="577037"/>
            </a:xfrm>
            <a:prstGeom prst="rect">
              <a:avLst/>
            </a:prstGeom>
            <a:noFill/>
            <a:ln w="6350">
              <a:solidFill>
                <a:srgbClr val="FFC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pic>
          <p:nvPicPr>
            <p:cNvPr id="141" name="Imagen 140" descr="Escala de tiempo&#10;&#10;Descripción generada automáticamente">
              <a:extLst>
                <a:ext uri="{FF2B5EF4-FFF2-40B4-BE49-F238E27FC236}">
                  <a16:creationId xmlns:a16="http://schemas.microsoft.com/office/drawing/2014/main" id="{62057901-23E1-93FF-76D7-D282B0E6464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588898" y="5330189"/>
              <a:ext cx="2451520" cy="1654776"/>
            </a:xfrm>
            <a:prstGeom prst="rect">
              <a:avLst/>
            </a:prstGeom>
          </p:spPr>
        </p:pic>
        <p:pic>
          <p:nvPicPr>
            <p:cNvPr id="142" name="Imagen 141">
              <a:extLst>
                <a:ext uri="{FF2B5EF4-FFF2-40B4-BE49-F238E27FC236}">
                  <a16:creationId xmlns:a16="http://schemas.microsoft.com/office/drawing/2014/main" id="{32094C88-D849-8EAE-90FC-ACE782B8E6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6673" t="63505" r="10382" b="13368"/>
            <a:stretch/>
          </p:blipFill>
          <p:spPr>
            <a:xfrm>
              <a:off x="5380645" y="2593297"/>
              <a:ext cx="344455" cy="384602"/>
            </a:xfrm>
            <a:prstGeom prst="rect">
              <a:avLst/>
            </a:prstGeom>
          </p:spPr>
        </p:pic>
        <p:sp>
          <p:nvSpPr>
            <p:cNvPr id="105" name="Rectángulo 104"/>
            <p:cNvSpPr/>
            <p:nvPr/>
          </p:nvSpPr>
          <p:spPr>
            <a:xfrm>
              <a:off x="3121025" y="5736167"/>
              <a:ext cx="88852" cy="410024"/>
            </a:xfrm>
            <a:prstGeom prst="rect">
              <a:avLst/>
            </a:prstGeom>
            <a:solidFill>
              <a:srgbClr val="00FFFF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7" name="Rectángulo 16"/>
            <p:cNvSpPr/>
            <p:nvPr/>
          </p:nvSpPr>
          <p:spPr>
            <a:xfrm>
              <a:off x="767501" y="5326143"/>
              <a:ext cx="2432541" cy="410024"/>
            </a:xfrm>
            <a:prstGeom prst="rect">
              <a:avLst/>
            </a:prstGeom>
            <a:solidFill>
              <a:srgbClr val="00FFFF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3" name="Rectángulo 102"/>
            <p:cNvSpPr/>
            <p:nvPr/>
          </p:nvSpPr>
          <p:spPr>
            <a:xfrm>
              <a:off x="767501" y="5736167"/>
              <a:ext cx="1158666" cy="410024"/>
            </a:xfrm>
            <a:prstGeom prst="rect">
              <a:avLst/>
            </a:prstGeom>
            <a:solidFill>
              <a:srgbClr val="00FFFF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4" name="Rectángulo 103"/>
            <p:cNvSpPr/>
            <p:nvPr/>
          </p:nvSpPr>
          <p:spPr>
            <a:xfrm>
              <a:off x="767503" y="6146191"/>
              <a:ext cx="1065530" cy="410024"/>
            </a:xfrm>
            <a:prstGeom prst="rect">
              <a:avLst/>
            </a:prstGeom>
            <a:solidFill>
              <a:srgbClr val="00FFFF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6" name="Rectángulo 105"/>
            <p:cNvSpPr/>
            <p:nvPr/>
          </p:nvSpPr>
          <p:spPr>
            <a:xfrm>
              <a:off x="1921934" y="5735559"/>
              <a:ext cx="1202266" cy="410024"/>
            </a:xfrm>
            <a:prstGeom prst="rect">
              <a:avLst/>
            </a:prstGeom>
            <a:solidFill>
              <a:srgbClr val="F7832B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7" name="Rectángulo 106"/>
            <p:cNvSpPr/>
            <p:nvPr/>
          </p:nvSpPr>
          <p:spPr>
            <a:xfrm>
              <a:off x="1833033" y="6146191"/>
              <a:ext cx="1376844" cy="410024"/>
            </a:xfrm>
            <a:prstGeom prst="rect">
              <a:avLst/>
            </a:prstGeom>
            <a:solidFill>
              <a:srgbClr val="F7832B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8" name="Rectángulo 107"/>
            <p:cNvSpPr/>
            <p:nvPr/>
          </p:nvSpPr>
          <p:spPr>
            <a:xfrm>
              <a:off x="767501" y="6556823"/>
              <a:ext cx="2442368" cy="410024"/>
            </a:xfrm>
            <a:prstGeom prst="rect">
              <a:avLst/>
            </a:prstGeom>
            <a:solidFill>
              <a:srgbClr val="F7832B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36" name="Rectángulo 135"/>
            <p:cNvSpPr/>
            <p:nvPr/>
          </p:nvSpPr>
          <p:spPr>
            <a:xfrm>
              <a:off x="5753100" y="5753096"/>
              <a:ext cx="267358" cy="410024"/>
            </a:xfrm>
            <a:prstGeom prst="rect">
              <a:avLst/>
            </a:prstGeom>
            <a:solidFill>
              <a:srgbClr val="00FFFF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0" name="Rectángulo 139"/>
            <p:cNvSpPr/>
            <p:nvPr/>
          </p:nvSpPr>
          <p:spPr>
            <a:xfrm>
              <a:off x="3578082" y="5343072"/>
              <a:ext cx="2432541" cy="410024"/>
            </a:xfrm>
            <a:prstGeom prst="rect">
              <a:avLst/>
            </a:prstGeom>
            <a:solidFill>
              <a:srgbClr val="00FFFF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3" name="Rectángulo 142"/>
            <p:cNvSpPr/>
            <p:nvPr/>
          </p:nvSpPr>
          <p:spPr>
            <a:xfrm>
              <a:off x="3578082" y="5753096"/>
              <a:ext cx="930418" cy="410024"/>
            </a:xfrm>
            <a:prstGeom prst="rect">
              <a:avLst/>
            </a:prstGeom>
            <a:solidFill>
              <a:srgbClr val="00FFFF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5" name="Rectángulo 144"/>
            <p:cNvSpPr/>
            <p:nvPr/>
          </p:nvSpPr>
          <p:spPr>
            <a:xfrm>
              <a:off x="3578084" y="6163120"/>
              <a:ext cx="1044716" cy="410024"/>
            </a:xfrm>
            <a:prstGeom prst="rect">
              <a:avLst/>
            </a:prstGeom>
            <a:solidFill>
              <a:srgbClr val="00FFFF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6" name="Rectángulo 145"/>
            <p:cNvSpPr/>
            <p:nvPr/>
          </p:nvSpPr>
          <p:spPr>
            <a:xfrm>
              <a:off x="4505325" y="5752488"/>
              <a:ext cx="1247775" cy="410024"/>
            </a:xfrm>
            <a:prstGeom prst="rect">
              <a:avLst/>
            </a:prstGeom>
            <a:solidFill>
              <a:srgbClr val="F7832B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7" name="Rectángulo 146"/>
            <p:cNvSpPr/>
            <p:nvPr/>
          </p:nvSpPr>
          <p:spPr>
            <a:xfrm>
              <a:off x="4622800" y="6163120"/>
              <a:ext cx="1397658" cy="410024"/>
            </a:xfrm>
            <a:prstGeom prst="rect">
              <a:avLst/>
            </a:prstGeom>
            <a:solidFill>
              <a:srgbClr val="F7832B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8" name="Rectángulo 147"/>
            <p:cNvSpPr/>
            <p:nvPr/>
          </p:nvSpPr>
          <p:spPr>
            <a:xfrm>
              <a:off x="3578082" y="6573752"/>
              <a:ext cx="1933718" cy="410024"/>
            </a:xfrm>
            <a:prstGeom prst="rect">
              <a:avLst/>
            </a:prstGeom>
            <a:solidFill>
              <a:srgbClr val="F7832B">
                <a:alpha val="23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9" name="CuadroTexto 148">
              <a:extLst>
                <a:ext uri="{FF2B5EF4-FFF2-40B4-BE49-F238E27FC236}">
                  <a16:creationId xmlns:a16="http://schemas.microsoft.com/office/drawing/2014/main" id="{E586665B-80BC-7F59-9CB4-928D4D1DEC84}"/>
                </a:ext>
              </a:extLst>
            </p:cNvPr>
            <p:cNvSpPr txBox="1"/>
            <p:nvPr/>
          </p:nvSpPr>
          <p:spPr>
            <a:xfrm>
              <a:off x="920387" y="236884"/>
              <a:ext cx="22209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s-ES_tradnl" sz="800" b="1" dirty="0">
                <a:cs typeface="Courier New"/>
              </a:endParaRPr>
            </a:p>
            <a:p>
              <a:pPr algn="ctr"/>
              <a:r>
                <a:rPr lang="es-ES_tradnl" sz="800" b="1" i="1" dirty="0" err="1">
                  <a:cs typeface="Courier New"/>
                </a:rPr>
                <a:t>Anabaena</a:t>
              </a:r>
              <a:r>
                <a:rPr lang="es-ES_tradnl" sz="800" b="1" i="1" dirty="0">
                  <a:cs typeface="Courier New"/>
                </a:rPr>
                <a:t> </a:t>
              </a:r>
              <a:r>
                <a:rPr lang="es-ES_tradnl" sz="800" b="1" dirty="0" err="1">
                  <a:cs typeface="Courier New"/>
                </a:rPr>
                <a:t>sp</a:t>
              </a:r>
              <a:r>
                <a:rPr lang="es-ES_tradnl" sz="800" b="1" dirty="0">
                  <a:cs typeface="Courier New"/>
                </a:rPr>
                <a:t>. PCC 7120 (</a:t>
              </a:r>
              <a:r>
                <a:rPr lang="es-ES_tradnl" sz="800" b="1" dirty="0" err="1">
                  <a:cs typeface="Courier New"/>
                </a:rPr>
                <a:t>Cyanobacteria</a:t>
              </a:r>
              <a:r>
                <a:rPr lang="es-ES_tradnl" sz="800" b="1" dirty="0">
                  <a:cs typeface="Courier New"/>
                </a:rPr>
                <a:t>)</a:t>
              </a:r>
            </a:p>
          </p:txBody>
        </p:sp>
        <p:sp>
          <p:nvSpPr>
            <p:cNvPr id="150" name="CuadroTexto 149">
              <a:extLst>
                <a:ext uri="{FF2B5EF4-FFF2-40B4-BE49-F238E27FC236}">
                  <a16:creationId xmlns:a16="http://schemas.microsoft.com/office/drawing/2014/main" id="{ED0227CF-8EAB-2235-5DB9-AD235D24FE42}"/>
                </a:ext>
              </a:extLst>
            </p:cNvPr>
            <p:cNvSpPr txBox="1"/>
            <p:nvPr/>
          </p:nvSpPr>
          <p:spPr>
            <a:xfrm>
              <a:off x="3630950" y="236884"/>
              <a:ext cx="21151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pt-PT" sz="8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endParaRPr>
            </a:p>
            <a:p>
              <a:pPr algn="ctr"/>
              <a:r>
                <a:rPr lang="pt-PT" sz="800" b="1" i="1" dirty="0" err="1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Lacipirellula</a:t>
              </a:r>
              <a:r>
                <a:rPr lang="pt-PT" sz="800" b="1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</a:t>
              </a:r>
              <a:r>
                <a:rPr lang="pt-PT" sz="800" b="1" i="1" dirty="0" err="1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limnantheis</a:t>
              </a:r>
              <a:r>
                <a:rPr lang="pt-PT" sz="800" b="1" i="1" dirty="0">
                  <a:solidFill>
                    <a:srgbClr val="000000"/>
                  </a:solidFill>
                  <a:ea typeface="Times New Roman" panose="02020603050405020304" pitchFamily="18" charset="0"/>
                </a:rPr>
                <a:t> </a:t>
              </a:r>
              <a:r>
                <a:rPr lang="pt-PT" sz="800" b="1" dirty="0">
                  <a:solidFill>
                    <a:srgbClr val="000000"/>
                  </a:solidFill>
                  <a:ea typeface="Times New Roman" panose="02020603050405020304" pitchFamily="18" charset="0"/>
                </a:rPr>
                <a:t>(PVC </a:t>
              </a:r>
              <a:r>
                <a:rPr lang="pt-PT" sz="800" b="1" dirty="0" err="1">
                  <a:solidFill>
                    <a:srgbClr val="000000"/>
                  </a:solidFill>
                  <a:ea typeface="Times New Roman" panose="02020603050405020304" pitchFamily="18" charset="0"/>
                </a:rPr>
                <a:t>superphylum</a:t>
              </a:r>
              <a:r>
                <a:rPr lang="pt-PT" sz="800" b="1" dirty="0">
                  <a:solidFill>
                    <a:srgbClr val="000000"/>
                  </a:solidFill>
                  <a:ea typeface="Times New Roman" panose="02020603050405020304" pitchFamily="18" charset="0"/>
                </a:rPr>
                <a:t>)</a:t>
              </a:r>
              <a:r>
                <a:rPr lang="pt-PT" sz="800" b="1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</a:t>
              </a:r>
              <a:endParaRPr lang="es-ES_tradnl" sz="800" dirty="0"/>
            </a:p>
          </p:txBody>
        </p:sp>
        <p:pic>
          <p:nvPicPr>
            <p:cNvPr id="2" name="Imagen 1"/>
            <p:cNvPicPr>
              <a:picLocks noChangeAspect="1"/>
            </p:cNvPicPr>
            <p:nvPr/>
          </p:nvPicPr>
          <p:blipFill rotWithShape="1">
            <a:blip r:embed="rId13"/>
            <a:srcRect t="14738" r="19008"/>
            <a:stretch/>
          </p:blipFill>
          <p:spPr>
            <a:xfrm>
              <a:off x="876298" y="7309908"/>
              <a:ext cx="2340000" cy="140045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pic>
          <p:nvPicPr>
            <p:cNvPr id="18" name="Imagen 17"/>
            <p:cNvPicPr>
              <a:picLocks noChangeAspect="1"/>
            </p:cNvPicPr>
            <p:nvPr/>
          </p:nvPicPr>
          <p:blipFill rotWithShape="1">
            <a:blip r:embed="rId14"/>
            <a:srcRect t="14154" r="18348" b="264"/>
            <a:stretch/>
          </p:blipFill>
          <p:spPr>
            <a:xfrm>
              <a:off x="3672981" y="7309908"/>
              <a:ext cx="2340000" cy="139433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7855604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/>
          <p:cNvSpPr/>
          <p:nvPr/>
        </p:nvSpPr>
        <p:spPr>
          <a:xfrm>
            <a:off x="923701" y="1289368"/>
            <a:ext cx="5234306" cy="50167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000" b="1" dirty="0">
                <a:latin typeface="Times New Roman"/>
                <a:cs typeface="Times New Roman"/>
              </a:rPr>
              <a:t>Fig. S4.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Sequence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conservation</a:t>
            </a:r>
            <a:r>
              <a:rPr lang="es-ES" sz="1000" b="1" dirty="0">
                <a:latin typeface="Times New Roman"/>
                <a:cs typeface="Times New Roman"/>
              </a:rPr>
              <a:t> and </a:t>
            </a:r>
            <a:r>
              <a:rPr lang="es-ES" sz="1000" b="1" dirty="0" err="1">
                <a:latin typeface="Times New Roman"/>
                <a:cs typeface="Times New Roman"/>
              </a:rPr>
              <a:t>coverage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analysis</a:t>
            </a:r>
            <a:r>
              <a:rPr lang="es-ES" sz="1000" b="1" dirty="0">
                <a:latin typeface="Times New Roman"/>
                <a:cs typeface="Times New Roman"/>
              </a:rPr>
              <a:t>, </a:t>
            </a:r>
            <a:r>
              <a:rPr lang="es-ES" sz="1000" b="1" dirty="0" err="1">
                <a:latin typeface="Times New Roman"/>
                <a:cs typeface="Times New Roman"/>
              </a:rPr>
              <a:t>predicted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accuracy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of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models</a:t>
            </a:r>
            <a:r>
              <a:rPr lang="es-ES" sz="1000" b="1" dirty="0">
                <a:latin typeface="Times New Roman"/>
                <a:cs typeface="Times New Roman"/>
              </a:rPr>
              <a:t>, and </a:t>
            </a:r>
            <a:r>
              <a:rPr lang="es-ES" sz="1000" b="1" dirty="0" err="1">
                <a:latin typeface="Times New Roman"/>
                <a:cs typeface="Times New Roman"/>
              </a:rPr>
              <a:t>prediction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of</a:t>
            </a:r>
            <a:r>
              <a:rPr lang="es-ES" sz="1000" b="1" dirty="0">
                <a:latin typeface="Times New Roman"/>
                <a:cs typeface="Times New Roman"/>
              </a:rPr>
              <a:t> metal-</a:t>
            </a:r>
            <a:r>
              <a:rPr lang="es-ES" sz="1000" b="1" dirty="0" err="1">
                <a:latin typeface="Times New Roman"/>
                <a:cs typeface="Times New Roman"/>
              </a:rPr>
              <a:t>binding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residues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of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ZepA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from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i="1" dirty="0" err="1">
                <a:latin typeface="Times New Roman"/>
                <a:cs typeface="Times New Roman"/>
              </a:rPr>
              <a:t>Anabaena</a:t>
            </a:r>
            <a:r>
              <a:rPr lang="es-ES" sz="1000" b="1" dirty="0">
                <a:latin typeface="Times New Roman"/>
                <a:cs typeface="Times New Roman"/>
              </a:rPr>
              <a:t> and </a:t>
            </a:r>
            <a:r>
              <a:rPr lang="es-ES" sz="1000" b="1" i="1" dirty="0" err="1">
                <a:latin typeface="Times New Roman"/>
                <a:cs typeface="Times New Roman"/>
              </a:rPr>
              <a:t>Lacipirellula</a:t>
            </a:r>
            <a:r>
              <a:rPr lang="es-ES" sz="1000" b="1" i="1" dirty="0">
                <a:latin typeface="Times New Roman"/>
                <a:cs typeface="Times New Roman"/>
              </a:rPr>
              <a:t> </a:t>
            </a:r>
            <a:r>
              <a:rPr lang="es-ES" sz="1000" b="1" i="1" dirty="0" err="1">
                <a:latin typeface="Times New Roman"/>
                <a:cs typeface="Times New Roman"/>
              </a:rPr>
              <a:t>limnantheis</a:t>
            </a:r>
            <a:r>
              <a:rPr lang="es-ES" sz="1000" b="1" i="1" dirty="0">
                <a:latin typeface="Times New Roman"/>
                <a:cs typeface="Times New Roman"/>
              </a:rPr>
              <a:t>. </a:t>
            </a:r>
            <a:r>
              <a:rPr lang="es-ES" sz="1000" dirty="0">
                <a:latin typeface="Times New Roman"/>
                <a:cs typeface="Times New Roman"/>
              </a:rPr>
              <a:t>(A) </a:t>
            </a:r>
            <a:r>
              <a:rPr lang="es-ES" sz="1000" dirty="0" err="1">
                <a:latin typeface="Times New Roman"/>
                <a:cs typeface="Times New Roman"/>
              </a:rPr>
              <a:t>Coverage</a:t>
            </a:r>
            <a:r>
              <a:rPr lang="es-ES" sz="1000" dirty="0">
                <a:latin typeface="Times New Roman"/>
                <a:cs typeface="Times New Roman"/>
              </a:rPr>
              <a:t> and </a:t>
            </a:r>
            <a:r>
              <a:rPr lang="es-ES" sz="1000" dirty="0" err="1">
                <a:latin typeface="Times New Roman"/>
                <a:cs typeface="Times New Roman"/>
              </a:rPr>
              <a:t>identit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analysis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ultipl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equenc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alignmen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ovid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Alphafold2 </a:t>
            </a:r>
            <a:r>
              <a:rPr lang="es-ES" sz="1000" dirty="0" err="1">
                <a:latin typeface="Times New Roman"/>
                <a:cs typeface="Times New Roman"/>
              </a:rPr>
              <a:t>fo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tructur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ediction</a:t>
            </a:r>
            <a:r>
              <a:rPr lang="es-ES" sz="1000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Tw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juxtapos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lots</a:t>
            </a:r>
            <a:r>
              <a:rPr lang="es-ES" sz="1000" dirty="0">
                <a:latin typeface="Times New Roman"/>
                <a:cs typeface="Times New Roman"/>
              </a:rPr>
              <a:t> are </a:t>
            </a:r>
            <a:r>
              <a:rPr lang="es-ES" sz="1000" dirty="0" err="1">
                <a:latin typeface="Times New Roman"/>
                <a:cs typeface="Times New Roman"/>
              </a:rPr>
              <a:t>shown</a:t>
            </a:r>
            <a:r>
              <a:rPr lang="es-ES" sz="1000" dirty="0">
                <a:latin typeface="Times New Roman"/>
                <a:cs typeface="Times New Roman"/>
              </a:rPr>
              <a:t> in </a:t>
            </a:r>
            <a:r>
              <a:rPr lang="es-ES" sz="1000" dirty="0" err="1">
                <a:latin typeface="Times New Roman"/>
                <a:cs typeface="Times New Roman"/>
              </a:rPr>
              <a:t>this</a:t>
            </a:r>
            <a:r>
              <a:rPr lang="es-ES" sz="1000" dirty="0">
                <a:latin typeface="Times New Roman"/>
                <a:cs typeface="Times New Roman"/>
              </a:rPr>
              <a:t> panel. </a:t>
            </a:r>
            <a:r>
              <a:rPr lang="es-ES" sz="1000" dirty="0" err="1">
                <a:latin typeface="Times New Roman"/>
                <a:cs typeface="Times New Roman"/>
              </a:rPr>
              <a:t>On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lot</a:t>
            </a:r>
            <a:r>
              <a:rPr lang="es-ES" sz="1000" dirty="0">
                <a:latin typeface="Times New Roman"/>
                <a:cs typeface="Times New Roman"/>
              </a:rPr>
              <a:t> shows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verage</a:t>
            </a:r>
            <a:r>
              <a:rPr lang="es-ES" sz="1000" dirty="0">
                <a:latin typeface="Times New Roman"/>
                <a:cs typeface="Times New Roman"/>
              </a:rPr>
              <a:t> and </a:t>
            </a:r>
            <a:r>
              <a:rPr lang="es-ES" sz="1000" dirty="0" err="1">
                <a:latin typeface="Times New Roman"/>
                <a:cs typeface="Times New Roman"/>
              </a:rPr>
              <a:t>identity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sequenc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homolog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epresented</a:t>
            </a:r>
            <a:r>
              <a:rPr lang="es-ES" sz="1000" dirty="0">
                <a:latin typeface="Times New Roman"/>
                <a:cs typeface="Times New Roman"/>
              </a:rPr>
              <a:t> as complete </a:t>
            </a:r>
            <a:r>
              <a:rPr lang="es-ES" sz="1000" dirty="0" err="1">
                <a:latin typeface="Times New Roman"/>
                <a:cs typeface="Times New Roman"/>
              </a:rPr>
              <a:t>o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interrupted</a:t>
            </a:r>
            <a:r>
              <a:rPr lang="es-ES" sz="1000" dirty="0">
                <a:latin typeface="Times New Roman"/>
                <a:cs typeface="Times New Roman"/>
              </a:rPr>
              <a:t> horizontal </a:t>
            </a:r>
            <a:r>
              <a:rPr lang="es-ES" sz="1000" dirty="0" err="1">
                <a:latin typeface="Times New Roman"/>
                <a:cs typeface="Times New Roman"/>
              </a:rPr>
              <a:t>line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order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from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less</a:t>
            </a:r>
            <a:r>
              <a:rPr lang="es-ES" sz="1000" dirty="0">
                <a:latin typeface="Times New Roman"/>
                <a:cs typeface="Times New Roman"/>
              </a:rPr>
              <a:t> (</a:t>
            </a:r>
            <a:r>
              <a:rPr lang="es-ES" sz="1000" dirty="0" err="1">
                <a:latin typeface="Times New Roman"/>
                <a:cs typeface="Times New Roman"/>
              </a:rPr>
              <a:t>bottom</a:t>
            </a:r>
            <a:r>
              <a:rPr lang="es-ES" sz="1000" dirty="0">
                <a:latin typeface="Times New Roman"/>
                <a:cs typeface="Times New Roman"/>
              </a:rPr>
              <a:t>)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more (top) </a:t>
            </a:r>
            <a:r>
              <a:rPr lang="es-ES" sz="1000" dirty="0" err="1">
                <a:latin typeface="Times New Roman"/>
                <a:cs typeface="Times New Roman"/>
              </a:rPr>
              <a:t>conserv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wit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espec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atur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equence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ZepA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i="1" dirty="0" err="1">
                <a:latin typeface="Times New Roman"/>
                <a:cs typeface="Times New Roman"/>
              </a:rPr>
              <a:t>Anabaena</a:t>
            </a:r>
            <a:r>
              <a:rPr lang="es-ES" sz="1000" dirty="0">
                <a:latin typeface="Times New Roman"/>
                <a:cs typeface="Times New Roman"/>
              </a:rPr>
              <a:t> (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query</a:t>
            </a:r>
            <a:r>
              <a:rPr lang="es-ES" sz="1000" dirty="0">
                <a:latin typeface="Times New Roman"/>
                <a:cs typeface="Times New Roman"/>
              </a:rPr>
              <a:t>). </a:t>
            </a:r>
            <a:r>
              <a:rPr lang="es-ES" sz="1000" dirty="0" err="1">
                <a:latin typeface="Times New Roman"/>
                <a:cs typeface="Times New Roman"/>
              </a:rPr>
              <a:t>Each</a:t>
            </a:r>
            <a:r>
              <a:rPr lang="es-ES" sz="1000" dirty="0">
                <a:latin typeface="Times New Roman"/>
                <a:cs typeface="Times New Roman"/>
              </a:rPr>
              <a:t> line </a:t>
            </a:r>
            <a:r>
              <a:rPr lang="es-ES" sz="1000" dirty="0" err="1">
                <a:latin typeface="Times New Roman"/>
                <a:cs typeface="Times New Roman"/>
              </a:rPr>
              <a:t>i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depic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accord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color </a:t>
            </a:r>
            <a:r>
              <a:rPr lang="es-ES" sz="1000" dirty="0" err="1">
                <a:latin typeface="Times New Roman"/>
                <a:cs typeface="Times New Roman"/>
              </a:rPr>
              <a:t>scale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equenc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identit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hown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on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igh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ide</a:t>
            </a:r>
            <a:r>
              <a:rPr lang="es-ES" sz="1000" dirty="0">
                <a:latin typeface="Times New Roman"/>
                <a:cs typeface="Times New Roman"/>
              </a:rPr>
              <a:t>. Gaps in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alignment</a:t>
            </a:r>
            <a:r>
              <a:rPr lang="es-ES" sz="1000" dirty="0">
                <a:latin typeface="Times New Roman"/>
                <a:cs typeface="Times New Roman"/>
              </a:rPr>
              <a:t> are </a:t>
            </a:r>
            <a:r>
              <a:rPr lang="es-ES" sz="1000" dirty="0" err="1">
                <a:latin typeface="Times New Roman"/>
                <a:cs typeface="Times New Roman"/>
              </a:rPr>
              <a:t>shown</a:t>
            </a:r>
            <a:r>
              <a:rPr lang="es-ES" sz="1000" dirty="0">
                <a:latin typeface="Times New Roman"/>
                <a:cs typeface="Times New Roman"/>
              </a:rPr>
              <a:t> as </a:t>
            </a:r>
            <a:r>
              <a:rPr lang="es-ES" sz="1000" dirty="0" err="1">
                <a:latin typeface="Times New Roman"/>
                <a:cs typeface="Times New Roman"/>
              </a:rPr>
              <a:t>empt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paces</a:t>
            </a:r>
            <a:r>
              <a:rPr lang="es-ES" sz="1000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econ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lot</a:t>
            </a:r>
            <a:r>
              <a:rPr lang="es-ES" sz="1000" dirty="0">
                <a:latin typeface="Times New Roman"/>
                <a:cs typeface="Times New Roman"/>
              </a:rPr>
              <a:t> in </a:t>
            </a:r>
            <a:r>
              <a:rPr lang="es-ES" sz="1000" dirty="0" err="1">
                <a:latin typeface="Times New Roman"/>
                <a:cs typeface="Times New Roman"/>
              </a:rPr>
              <a:t>thi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left</a:t>
            </a:r>
            <a:r>
              <a:rPr lang="es-ES" sz="1000" dirty="0">
                <a:latin typeface="Times New Roman"/>
                <a:cs typeface="Times New Roman"/>
              </a:rPr>
              <a:t> panel </a:t>
            </a:r>
            <a:r>
              <a:rPr lang="es-ES" sz="1000" dirty="0" err="1">
                <a:latin typeface="Times New Roman"/>
                <a:cs typeface="Times New Roman"/>
              </a:rPr>
              <a:t>correspond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lack</a:t>
            </a:r>
            <a:r>
              <a:rPr lang="es-ES" sz="1000" dirty="0">
                <a:latin typeface="Times New Roman"/>
                <a:cs typeface="Times New Roman"/>
              </a:rPr>
              <a:t> line, </a:t>
            </a:r>
            <a:r>
              <a:rPr lang="es-ES" sz="1000" dirty="0" err="1">
                <a:latin typeface="Times New Roman"/>
                <a:cs typeface="Times New Roman"/>
              </a:rPr>
              <a:t>whic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epresent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number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sequences</a:t>
            </a:r>
            <a:r>
              <a:rPr lang="es-ES" sz="1000" dirty="0">
                <a:latin typeface="Times New Roman"/>
                <a:cs typeface="Times New Roman"/>
              </a:rPr>
              <a:t> (</a:t>
            </a:r>
            <a:r>
              <a:rPr lang="es-ES" sz="1000" dirty="0" err="1">
                <a:latin typeface="Times New Roman"/>
                <a:cs typeface="Times New Roman"/>
              </a:rPr>
              <a:t>left</a:t>
            </a:r>
            <a:r>
              <a:rPr lang="es-ES" sz="1000" dirty="0">
                <a:latin typeface="Times New Roman"/>
                <a:cs typeface="Times New Roman"/>
              </a:rPr>
              <a:t> vertical axis) in </a:t>
            </a:r>
            <a:r>
              <a:rPr lang="es-ES" sz="1000" dirty="0" err="1">
                <a:latin typeface="Times New Roman"/>
                <a:cs typeface="Times New Roman"/>
              </a:rPr>
              <a:t>which</a:t>
            </a:r>
            <a:r>
              <a:rPr lang="es-ES" sz="1000" dirty="0">
                <a:latin typeface="Times New Roman"/>
                <a:cs typeface="Times New Roman"/>
              </a:rPr>
              <a:t> a </a:t>
            </a:r>
            <a:r>
              <a:rPr lang="es-ES" sz="1000" dirty="0" err="1">
                <a:latin typeface="Times New Roman"/>
                <a:cs typeface="Times New Roman"/>
              </a:rPr>
              <a:t>given</a:t>
            </a:r>
            <a:r>
              <a:rPr lang="es-ES" sz="1000" dirty="0">
                <a:latin typeface="Times New Roman"/>
                <a:cs typeface="Times New Roman"/>
              </a:rPr>
              <a:t> position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quer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otein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i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nserved</a:t>
            </a:r>
            <a:r>
              <a:rPr lang="es-ES" sz="1000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ight</a:t>
            </a:r>
            <a:r>
              <a:rPr lang="es-ES" sz="1000" dirty="0">
                <a:latin typeface="Times New Roman"/>
                <a:cs typeface="Times New Roman"/>
              </a:rPr>
              <a:t> panel </a:t>
            </a:r>
            <a:r>
              <a:rPr lang="es-ES" sz="1000" dirty="0" err="1">
                <a:latin typeface="Times New Roman"/>
                <a:cs typeface="Times New Roman"/>
              </a:rPr>
              <a:t>is</a:t>
            </a:r>
            <a:r>
              <a:rPr lang="es-ES" sz="1000" dirty="0">
                <a:latin typeface="Times New Roman"/>
                <a:cs typeface="Times New Roman"/>
              </a:rPr>
              <a:t> similar </a:t>
            </a:r>
            <a:r>
              <a:rPr lang="es-ES" sz="1000" dirty="0" err="1">
                <a:latin typeface="Times New Roman"/>
                <a:cs typeface="Times New Roman"/>
              </a:rPr>
              <a:t>but</a:t>
            </a:r>
            <a:r>
              <a:rPr lang="es-ES" sz="1000" dirty="0">
                <a:latin typeface="Times New Roman"/>
                <a:cs typeface="Times New Roman"/>
              </a:rPr>
              <a:t> uses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ZepA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otein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from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i="1" dirty="0" err="1">
                <a:latin typeface="Times New Roman"/>
                <a:cs typeface="Times New Roman"/>
              </a:rPr>
              <a:t>Lacipirellula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i="1" dirty="0" err="1">
                <a:latin typeface="Times New Roman"/>
                <a:cs typeface="Times New Roman"/>
              </a:rPr>
              <a:t>limnantheis</a:t>
            </a:r>
            <a:r>
              <a:rPr lang="es-ES" sz="1000" i="1" dirty="0">
                <a:latin typeface="Times New Roman"/>
                <a:cs typeface="Times New Roman"/>
              </a:rPr>
              <a:t> </a:t>
            </a:r>
            <a:r>
              <a:rPr lang="es-ES" sz="1000" dirty="0">
                <a:latin typeface="Times New Roman"/>
                <a:cs typeface="Times New Roman"/>
              </a:rPr>
              <a:t>(PVC </a:t>
            </a:r>
            <a:r>
              <a:rPr lang="es-ES" sz="1000" dirty="0" err="1">
                <a:latin typeface="Times New Roman"/>
                <a:cs typeface="Times New Roman"/>
              </a:rPr>
              <a:t>superphylum</a:t>
            </a:r>
            <a:r>
              <a:rPr lang="es-ES" sz="1000" dirty="0">
                <a:latin typeface="Times New Roman"/>
                <a:cs typeface="Times New Roman"/>
              </a:rPr>
              <a:t>)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dirty="0">
                <a:latin typeface="Times New Roman"/>
                <a:cs typeface="Times New Roman"/>
              </a:rPr>
              <a:t>as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quer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otein</a:t>
            </a:r>
            <a:r>
              <a:rPr lang="es-ES" sz="1000" dirty="0">
                <a:latin typeface="Times New Roman"/>
                <a:cs typeface="Times New Roman"/>
              </a:rPr>
              <a:t>. In </a:t>
            </a:r>
            <a:r>
              <a:rPr lang="es-ES" sz="1000" dirty="0" err="1">
                <a:latin typeface="Times New Roman"/>
                <a:cs typeface="Times New Roman"/>
              </a:rPr>
              <a:t>this</a:t>
            </a:r>
            <a:r>
              <a:rPr lang="es-ES" sz="1000" dirty="0">
                <a:latin typeface="Times New Roman"/>
                <a:cs typeface="Times New Roman"/>
              </a:rPr>
              <a:t> case, </a:t>
            </a:r>
            <a:r>
              <a:rPr lang="es-ES" sz="1000" dirty="0" err="1">
                <a:latin typeface="Times New Roman"/>
                <a:cs typeface="Times New Roman"/>
              </a:rPr>
              <a:t>homologou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equence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quer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otein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wer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elec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y</a:t>
            </a:r>
            <a:r>
              <a:rPr lang="es-ES" sz="1000" dirty="0">
                <a:latin typeface="Times New Roman"/>
                <a:cs typeface="Times New Roman"/>
              </a:rPr>
              <a:t> Alphafold2 (mmseqs2_uniref_env </a:t>
            </a:r>
            <a:r>
              <a:rPr lang="es-ES" sz="1000" dirty="0" err="1">
                <a:latin typeface="Times New Roman"/>
                <a:cs typeface="Times New Roman"/>
              </a:rPr>
              <a:t>setting</a:t>
            </a:r>
            <a:r>
              <a:rPr lang="es-ES" sz="1000" dirty="0">
                <a:latin typeface="Times New Roman"/>
                <a:cs typeface="Times New Roman"/>
              </a:rPr>
              <a:t>). (B) </a:t>
            </a:r>
            <a:r>
              <a:rPr lang="es-ES" sz="1000" dirty="0" err="1">
                <a:latin typeface="Times New Roman"/>
                <a:cs typeface="Times New Roman"/>
              </a:rPr>
              <a:t>Predic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lDDT</a:t>
            </a:r>
            <a:r>
              <a:rPr lang="es-ES" sz="1000" dirty="0">
                <a:latin typeface="Times New Roman"/>
                <a:cs typeface="Times New Roman"/>
              </a:rPr>
              <a:t> per position </a:t>
            </a:r>
            <a:r>
              <a:rPr lang="es-ES" sz="1000" dirty="0" err="1">
                <a:latin typeface="Times New Roman"/>
                <a:cs typeface="Times New Roman"/>
              </a:rPr>
              <a:t>on</a:t>
            </a:r>
            <a:r>
              <a:rPr lang="es-ES" sz="1000" dirty="0">
                <a:latin typeface="Times New Roman"/>
                <a:cs typeface="Times New Roman"/>
              </a:rPr>
              <a:t> a </a:t>
            </a:r>
            <a:r>
              <a:rPr lang="es-ES" sz="1000" dirty="0" err="1">
                <a:latin typeface="Times New Roman"/>
                <a:cs typeface="Times New Roman"/>
              </a:rPr>
              <a:t>scal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from</a:t>
            </a:r>
            <a:r>
              <a:rPr lang="es-ES" sz="1000" dirty="0">
                <a:latin typeface="Times New Roman"/>
                <a:cs typeface="Times New Roman"/>
              </a:rPr>
              <a:t> 0 –100 of </a:t>
            </a:r>
            <a:r>
              <a:rPr lang="es-ES" sz="1000" dirty="0" err="1">
                <a:latin typeface="Times New Roman"/>
                <a:cs typeface="Times New Roman"/>
              </a:rPr>
              <a:t>five</a:t>
            </a:r>
            <a:r>
              <a:rPr lang="es-ES" sz="1000" dirty="0">
                <a:latin typeface="Times New Roman"/>
                <a:cs typeface="Times New Roman"/>
              </a:rPr>
              <a:t> AlphaFold2 </a:t>
            </a:r>
            <a:r>
              <a:rPr lang="es-ES" sz="1000" dirty="0" err="1">
                <a:latin typeface="Times New Roman"/>
                <a:cs typeface="Times New Roman"/>
              </a:rPr>
              <a:t>model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lor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ank</a:t>
            </a:r>
            <a:r>
              <a:rPr lang="es-ES" sz="1000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averag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LDDT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os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nfiden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ediction</a:t>
            </a:r>
            <a:r>
              <a:rPr lang="es-ES" sz="1000" dirty="0">
                <a:latin typeface="Times New Roman"/>
                <a:cs typeface="Times New Roman"/>
              </a:rPr>
              <a:t> (rank1) </a:t>
            </a:r>
            <a:r>
              <a:rPr lang="es-ES" sz="1000" dirty="0" err="1">
                <a:latin typeface="Times New Roman"/>
                <a:cs typeface="Times New Roman"/>
              </a:rPr>
              <a:t>is</a:t>
            </a:r>
            <a:r>
              <a:rPr lang="es-ES" sz="1000" dirty="0">
                <a:latin typeface="Times New Roman"/>
                <a:cs typeface="Times New Roman"/>
              </a:rPr>
              <a:t> 93.5 (</a:t>
            </a:r>
            <a:r>
              <a:rPr lang="es-ES" sz="1000" dirty="0" err="1">
                <a:latin typeface="Times New Roman"/>
                <a:cs typeface="Times New Roman"/>
              </a:rPr>
              <a:t>fo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i="1" dirty="0" err="1">
                <a:latin typeface="Times New Roman"/>
                <a:cs typeface="Times New Roman"/>
              </a:rPr>
              <a:t>Anabaena</a:t>
            </a:r>
            <a:r>
              <a:rPr lang="es-ES" sz="1000" dirty="0">
                <a:latin typeface="Times New Roman"/>
                <a:cs typeface="Times New Roman"/>
              </a:rPr>
              <a:t>) and 95.2 (</a:t>
            </a:r>
            <a:r>
              <a:rPr lang="es-ES" sz="1000" dirty="0" err="1">
                <a:latin typeface="Times New Roman"/>
                <a:cs typeface="Times New Roman"/>
              </a:rPr>
              <a:t>fo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i="1" dirty="0" err="1">
                <a:latin typeface="Times New Roman"/>
                <a:cs typeface="Times New Roman"/>
              </a:rPr>
              <a:t>Lacipirellula</a:t>
            </a:r>
            <a:r>
              <a:rPr lang="es-ES" sz="1000" dirty="0">
                <a:latin typeface="Times New Roman"/>
                <a:cs typeface="Times New Roman"/>
              </a:rPr>
              <a:t>). </a:t>
            </a:r>
            <a:r>
              <a:rPr lang="es-ES" sz="1000" dirty="0" err="1">
                <a:latin typeface="Times New Roman"/>
                <a:cs typeface="Times New Roman"/>
              </a:rPr>
              <a:t>Model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nfidenc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varie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ignificantl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alo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hain</a:t>
            </a:r>
            <a:r>
              <a:rPr lang="es-ES" sz="1000" dirty="0">
                <a:latin typeface="Times New Roman"/>
                <a:cs typeface="Times New Roman"/>
              </a:rPr>
              <a:t>, </a:t>
            </a:r>
            <a:r>
              <a:rPr lang="es-ES" sz="1000" dirty="0" err="1">
                <a:latin typeface="Times New Roman"/>
                <a:cs typeface="Times New Roman"/>
              </a:rPr>
              <a:t>bu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ost</a:t>
            </a:r>
            <a:r>
              <a:rPr lang="es-ES" sz="1000" dirty="0">
                <a:latin typeface="Times New Roman"/>
                <a:cs typeface="Times New Roman"/>
              </a:rPr>
              <a:t> positions are </a:t>
            </a:r>
            <a:r>
              <a:rPr lang="es-ES" sz="1000" dirty="0" err="1">
                <a:latin typeface="Times New Roman"/>
                <a:cs typeface="Times New Roman"/>
              </a:rPr>
              <a:t>model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wit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hig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accuracy</a:t>
            </a:r>
            <a:r>
              <a:rPr lang="es-ES" sz="1000" dirty="0">
                <a:latin typeface="Times New Roman"/>
                <a:cs typeface="Times New Roman"/>
              </a:rPr>
              <a:t> (</a:t>
            </a:r>
            <a:r>
              <a:rPr lang="es-ES" sz="1000" dirty="0" err="1">
                <a:latin typeface="Times New Roman"/>
                <a:cs typeface="Times New Roman"/>
              </a:rPr>
              <a:t>pLDDT</a:t>
            </a:r>
            <a:r>
              <a:rPr lang="es-ES" sz="1000" dirty="0">
                <a:latin typeface="Times New Roman"/>
                <a:cs typeface="Times New Roman"/>
              </a:rPr>
              <a:t> &gt; 90) and can </a:t>
            </a:r>
            <a:r>
              <a:rPr lang="es-ES" sz="1000" dirty="0" err="1">
                <a:latin typeface="Times New Roman"/>
                <a:cs typeface="Times New Roman"/>
              </a:rPr>
              <a:t>serv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haracteriz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ind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ites</a:t>
            </a:r>
            <a:r>
              <a:rPr lang="es-ES" sz="1000" dirty="0">
                <a:latin typeface="Times New Roman"/>
                <a:cs typeface="Times New Roman"/>
              </a:rPr>
              <a:t>. In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fiv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odels</a:t>
            </a:r>
            <a:r>
              <a:rPr lang="es-ES" sz="1000" dirty="0">
                <a:latin typeface="Times New Roman"/>
                <a:cs typeface="Times New Roman"/>
              </a:rPr>
              <a:t>, </a:t>
            </a:r>
            <a:r>
              <a:rPr lang="es-ES" sz="1000" dirty="0" err="1">
                <a:latin typeface="Times New Roman"/>
                <a:cs typeface="Times New Roman"/>
              </a:rPr>
              <a:t>accurac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decreas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etween</a:t>
            </a:r>
            <a:r>
              <a:rPr lang="es-ES" sz="1000" dirty="0">
                <a:latin typeface="Times New Roman"/>
                <a:cs typeface="Times New Roman"/>
              </a:rPr>
              <a:t> 30 and 70 at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ten N-terminal amino </a:t>
            </a:r>
            <a:r>
              <a:rPr lang="es-ES" sz="1000" dirty="0" err="1">
                <a:latin typeface="Times New Roman"/>
                <a:cs typeface="Times New Roman"/>
              </a:rPr>
              <a:t>acids</a:t>
            </a:r>
            <a:r>
              <a:rPr lang="es-ES" sz="1000" dirty="0">
                <a:latin typeface="Times New Roman"/>
                <a:cs typeface="Times New Roman"/>
              </a:rPr>
              <a:t> (</a:t>
            </a:r>
            <a:r>
              <a:rPr lang="es-ES" sz="1000" dirty="0" err="1">
                <a:latin typeface="Times New Roman"/>
                <a:cs typeface="Times New Roman"/>
              </a:rPr>
              <a:t>pLDDT</a:t>
            </a:r>
            <a:r>
              <a:rPr lang="es-ES" sz="1000" dirty="0">
                <a:latin typeface="Times New Roman"/>
                <a:cs typeface="Times New Roman"/>
              </a:rPr>
              <a:t>&lt;50) </a:t>
            </a:r>
            <a:r>
              <a:rPr lang="es-ES" sz="1000" dirty="0" err="1">
                <a:latin typeface="Times New Roman"/>
                <a:cs typeface="Times New Roman"/>
              </a:rPr>
              <a:t>predicting</a:t>
            </a:r>
            <a:r>
              <a:rPr lang="es-ES" sz="1000" dirty="0">
                <a:latin typeface="Times New Roman"/>
                <a:cs typeface="Times New Roman"/>
              </a:rPr>
              <a:t> a </a:t>
            </a:r>
            <a:r>
              <a:rPr lang="es-ES" sz="1000" dirty="0" err="1">
                <a:latin typeface="Times New Roman"/>
                <a:cs typeface="Times New Roman"/>
              </a:rPr>
              <a:t>disorder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egion</a:t>
            </a:r>
            <a:r>
              <a:rPr lang="es-ES" sz="1000" dirty="0">
                <a:latin typeface="Times New Roman"/>
                <a:cs typeface="Times New Roman"/>
              </a:rPr>
              <a:t> (</a:t>
            </a:r>
            <a:r>
              <a:rPr lang="es-ES" sz="1000" dirty="0" err="1">
                <a:latin typeface="Times New Roman"/>
                <a:cs typeface="Times New Roman"/>
              </a:rPr>
              <a:t>unstructur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unde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hysiological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nditions</a:t>
            </a:r>
            <a:r>
              <a:rPr lang="es-ES" sz="1000" dirty="0">
                <a:latin typeface="Times New Roman"/>
                <a:cs typeface="Times New Roman"/>
              </a:rPr>
              <a:t>).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yellow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inse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epresent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output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MIB2 metal </a:t>
            </a:r>
            <a:r>
              <a:rPr lang="es-ES" sz="1000" dirty="0" err="1">
                <a:latin typeface="Times New Roman"/>
                <a:cs typeface="Times New Roman"/>
              </a:rPr>
              <a:t>bind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ediction</a:t>
            </a:r>
            <a:r>
              <a:rPr lang="es-ES" sz="1000" dirty="0">
                <a:latin typeface="Times New Roman"/>
                <a:cs typeface="Times New Roman"/>
              </a:rPr>
              <a:t> server </a:t>
            </a:r>
            <a:r>
              <a:rPr lang="es-ES" sz="1000" dirty="0" err="1">
                <a:latin typeface="Times New Roman"/>
                <a:cs typeface="Times New Roman"/>
              </a:rPr>
              <a:t>showing</a:t>
            </a:r>
            <a:r>
              <a:rPr lang="es-ES" sz="1000" dirty="0">
                <a:latin typeface="Times New Roman"/>
                <a:cs typeface="Times New Roman"/>
              </a:rPr>
              <a:t> metal </a:t>
            </a:r>
            <a:r>
              <a:rPr lang="es-ES" sz="1000" dirty="0" err="1">
                <a:latin typeface="Times New Roman"/>
                <a:cs typeface="Times New Roman"/>
              </a:rPr>
              <a:t>binding</a:t>
            </a:r>
            <a:r>
              <a:rPr lang="es-ES" sz="1000" dirty="0">
                <a:latin typeface="Times New Roman"/>
                <a:cs typeface="Times New Roman"/>
              </a:rPr>
              <a:t> scores </a:t>
            </a:r>
            <a:r>
              <a:rPr lang="es-ES" sz="1000" dirty="0" err="1">
                <a:latin typeface="Times New Roman"/>
                <a:cs typeface="Times New Roman"/>
              </a:rPr>
              <a:t>fo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each</a:t>
            </a:r>
            <a:r>
              <a:rPr lang="es-ES" sz="1000" dirty="0">
                <a:latin typeface="Times New Roman"/>
                <a:cs typeface="Times New Roman"/>
              </a:rPr>
              <a:t> amino </a:t>
            </a:r>
            <a:r>
              <a:rPr lang="es-ES" sz="1000" dirty="0" err="1">
                <a:latin typeface="Times New Roman"/>
                <a:cs typeface="Times New Roman"/>
              </a:rPr>
              <a:t>acid</a:t>
            </a:r>
            <a:r>
              <a:rPr lang="es-ES" sz="1000" dirty="0">
                <a:latin typeface="Times New Roman"/>
                <a:cs typeface="Times New Roman"/>
              </a:rPr>
              <a:t> (</a:t>
            </a:r>
            <a:r>
              <a:rPr lang="es-ES" sz="1000" dirty="0" err="1">
                <a:latin typeface="Times New Roman"/>
                <a:cs typeface="Times New Roman"/>
              </a:rPr>
              <a:t>deriv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from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equence</a:t>
            </a:r>
            <a:r>
              <a:rPr lang="es-ES" sz="1000" dirty="0">
                <a:latin typeface="Times New Roman"/>
                <a:cs typeface="Times New Roman"/>
              </a:rPr>
              <a:t> and </a:t>
            </a:r>
            <a:r>
              <a:rPr lang="es-ES" sz="1000" dirty="0" err="1">
                <a:latin typeface="Times New Roman"/>
                <a:cs typeface="Times New Roman"/>
              </a:rPr>
              <a:t>structur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nservation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easures</a:t>
            </a:r>
            <a:r>
              <a:rPr lang="es-ES" sz="1000" dirty="0">
                <a:latin typeface="Times New Roman"/>
                <a:cs typeface="Times New Roman"/>
              </a:rPr>
              <a:t>) as a </a:t>
            </a:r>
            <a:r>
              <a:rPr lang="es-ES" sz="1000" dirty="0" err="1">
                <a:latin typeface="Times New Roman"/>
                <a:cs typeface="Times New Roman"/>
              </a:rPr>
              <a:t>yellow</a:t>
            </a:r>
            <a:r>
              <a:rPr lang="es-ES" sz="1000" dirty="0">
                <a:latin typeface="Times New Roman"/>
                <a:cs typeface="Times New Roman"/>
              </a:rPr>
              <a:t> line. Scores </a:t>
            </a:r>
            <a:r>
              <a:rPr lang="es-ES" sz="1000" dirty="0" err="1">
                <a:latin typeface="Times New Roman"/>
                <a:cs typeface="Times New Roman"/>
              </a:rPr>
              <a:t>highe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an</a:t>
            </a:r>
            <a:r>
              <a:rPr lang="es-ES" sz="1000" dirty="0">
                <a:latin typeface="Times New Roman"/>
                <a:cs typeface="Times New Roman"/>
              </a:rPr>
              <a:t> 2 </a:t>
            </a:r>
            <a:r>
              <a:rPr lang="es-ES" sz="1000" dirty="0" err="1">
                <a:latin typeface="Times New Roman"/>
                <a:cs typeface="Times New Roman"/>
              </a:rPr>
              <a:t>predict</a:t>
            </a:r>
            <a:r>
              <a:rPr lang="es-ES" sz="1000" dirty="0">
                <a:latin typeface="Times New Roman"/>
                <a:cs typeface="Times New Roman"/>
              </a:rPr>
              <a:t> a metal-</a:t>
            </a:r>
            <a:r>
              <a:rPr lang="es-ES" sz="1000" dirty="0" err="1">
                <a:latin typeface="Times New Roman"/>
                <a:cs typeface="Times New Roman"/>
              </a:rPr>
              <a:t>bind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esidue</a:t>
            </a:r>
            <a:r>
              <a:rPr lang="es-ES" sz="1000" dirty="0">
                <a:latin typeface="Times New Roman"/>
                <a:cs typeface="Times New Roman"/>
              </a:rPr>
              <a:t> (red </a:t>
            </a:r>
            <a:r>
              <a:rPr lang="es-ES" sz="1000" dirty="0" err="1">
                <a:latin typeface="Times New Roman"/>
                <a:cs typeface="Times New Roman"/>
              </a:rPr>
              <a:t>circle</a:t>
            </a:r>
            <a:r>
              <a:rPr lang="es-ES" sz="1000" dirty="0">
                <a:latin typeface="Times New Roman"/>
                <a:cs typeface="Times New Roman"/>
              </a:rPr>
              <a:t>). Vertical grey </a:t>
            </a:r>
            <a:r>
              <a:rPr lang="es-ES" sz="1000" dirty="0" err="1">
                <a:latin typeface="Times New Roman"/>
                <a:cs typeface="Times New Roman"/>
              </a:rPr>
              <a:t>band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wer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depic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show </a:t>
            </a:r>
            <a:r>
              <a:rPr lang="es-ES" sz="1000" dirty="0" err="1">
                <a:latin typeface="Times New Roman"/>
                <a:cs typeface="Times New Roman"/>
              </a:rPr>
              <a:t>tha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edicted</a:t>
            </a:r>
            <a:r>
              <a:rPr lang="es-ES" sz="1000" dirty="0">
                <a:latin typeface="Times New Roman"/>
                <a:cs typeface="Times New Roman"/>
              </a:rPr>
              <a:t> metal </a:t>
            </a:r>
            <a:r>
              <a:rPr lang="es-ES" sz="1000" dirty="0" err="1">
                <a:latin typeface="Times New Roman"/>
                <a:cs typeface="Times New Roman"/>
              </a:rPr>
              <a:t>bind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ites</a:t>
            </a:r>
            <a:r>
              <a:rPr lang="es-ES" sz="1000" dirty="0">
                <a:latin typeface="Times New Roman"/>
                <a:cs typeface="Times New Roman"/>
              </a:rPr>
              <a:t> are </a:t>
            </a:r>
            <a:r>
              <a:rPr lang="es-ES" sz="1000" dirty="0" err="1">
                <a:latin typeface="Times New Roman"/>
                <a:cs typeface="Times New Roman"/>
              </a:rPr>
              <a:t>located</a:t>
            </a:r>
            <a:r>
              <a:rPr lang="es-ES" sz="1000" dirty="0">
                <a:latin typeface="Times New Roman"/>
                <a:cs typeface="Times New Roman"/>
              </a:rPr>
              <a:t> at </a:t>
            </a:r>
            <a:r>
              <a:rPr lang="es-ES" sz="1000" dirty="0" err="1">
                <a:latin typeface="Times New Roman"/>
                <a:cs typeface="Times New Roman"/>
              </a:rPr>
              <a:t>region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wher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odel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nfidenc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i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lower</a:t>
            </a:r>
            <a:r>
              <a:rPr lang="es-ES" sz="1000" dirty="0">
                <a:latin typeface="Times New Roman"/>
                <a:cs typeface="Times New Roman"/>
              </a:rPr>
              <a:t>, </a:t>
            </a:r>
            <a:r>
              <a:rPr lang="es-ES" sz="1000" dirty="0" err="1">
                <a:latin typeface="Times New Roman"/>
                <a:cs typeface="Times New Roman"/>
              </a:rPr>
              <a:t>whic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also</a:t>
            </a:r>
            <a:r>
              <a:rPr lang="es-ES" sz="1000" dirty="0">
                <a:latin typeface="Times New Roman"/>
                <a:cs typeface="Times New Roman"/>
              </a:rPr>
              <a:t> coincides </a:t>
            </a:r>
            <a:r>
              <a:rPr lang="es-ES" sz="1000" dirty="0" err="1">
                <a:latin typeface="Times New Roman"/>
                <a:cs typeface="Times New Roman"/>
              </a:rPr>
              <a:t>wit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egions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low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equenc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nservation</a:t>
            </a:r>
            <a:r>
              <a:rPr lang="es-ES" sz="1000" dirty="0">
                <a:latin typeface="Times New Roman"/>
                <a:cs typeface="Times New Roman"/>
              </a:rPr>
              <a:t> in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lot</a:t>
            </a:r>
            <a:r>
              <a:rPr lang="es-ES" sz="1000" dirty="0">
                <a:latin typeface="Times New Roman"/>
                <a:cs typeface="Times New Roman"/>
              </a:rPr>
              <a:t> in (A). </a:t>
            </a:r>
            <a:r>
              <a:rPr lang="es-ES" sz="1000" dirty="0" err="1">
                <a:latin typeface="Times New Roman"/>
                <a:cs typeface="Times New Roman"/>
              </a:rPr>
              <a:t>Histidines</a:t>
            </a:r>
            <a:r>
              <a:rPr lang="es-ES" sz="1000" dirty="0">
                <a:latin typeface="Times New Roman"/>
                <a:cs typeface="Times New Roman"/>
              </a:rPr>
              <a:t> 44, 53, and 55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i="1" dirty="0" err="1">
                <a:latin typeface="Times New Roman"/>
                <a:cs typeface="Times New Roman"/>
              </a:rPr>
              <a:t>Anabaena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ZepA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otein</a:t>
            </a:r>
            <a:r>
              <a:rPr lang="es-ES" sz="1000" dirty="0">
                <a:latin typeface="Times New Roman"/>
                <a:cs typeface="Times New Roman"/>
              </a:rPr>
              <a:t> are </a:t>
            </a:r>
            <a:r>
              <a:rPr lang="es-ES" sz="1000" dirty="0" err="1">
                <a:latin typeface="Times New Roman"/>
                <a:cs typeface="Times New Roman"/>
              </a:rPr>
              <a:t>indicated</a:t>
            </a:r>
            <a:r>
              <a:rPr lang="es-ES" sz="1000" dirty="0">
                <a:latin typeface="Times New Roman"/>
                <a:cs typeface="Times New Roman"/>
              </a:rPr>
              <a:t>. C) </a:t>
            </a:r>
            <a:r>
              <a:rPr lang="es-ES" sz="1000" dirty="0" err="1">
                <a:latin typeface="Times New Roman"/>
                <a:cs typeface="Times New Roman"/>
              </a:rPr>
              <a:t>Confidence</a:t>
            </a:r>
            <a:r>
              <a:rPr lang="es-ES" sz="1000" dirty="0">
                <a:latin typeface="Times New Roman"/>
                <a:cs typeface="Times New Roman"/>
              </a:rPr>
              <a:t> in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elative</a:t>
            </a:r>
            <a:r>
              <a:rPr lang="es-ES" sz="1000" dirty="0">
                <a:latin typeface="Times New Roman"/>
                <a:cs typeface="Times New Roman"/>
              </a:rPr>
              <a:t> position and </a:t>
            </a:r>
            <a:r>
              <a:rPr lang="es-ES" sz="1000" dirty="0" err="1">
                <a:latin typeface="Times New Roman"/>
                <a:cs typeface="Times New Roman"/>
              </a:rPr>
              <a:t>orientation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different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odel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arts</a:t>
            </a:r>
            <a:r>
              <a:rPr lang="es-ES" sz="1000" dirty="0">
                <a:latin typeface="Times New Roman"/>
                <a:cs typeface="Times New Roman"/>
              </a:rPr>
              <a:t> as </a:t>
            </a:r>
            <a:r>
              <a:rPr lang="es-ES" sz="1000" dirty="0" err="1">
                <a:latin typeface="Times New Roman"/>
                <a:cs typeface="Times New Roman"/>
              </a:rPr>
              <a:t>Predic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Align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Errors</a:t>
            </a:r>
            <a:r>
              <a:rPr lang="es-ES" sz="1000" dirty="0">
                <a:latin typeface="Times New Roman"/>
                <a:cs typeface="Times New Roman"/>
              </a:rPr>
              <a:t> (PAE). Blue </a:t>
            </a:r>
            <a:r>
              <a:rPr lang="es-ES" sz="1000" dirty="0" err="1">
                <a:latin typeface="Times New Roman"/>
                <a:cs typeface="Times New Roman"/>
              </a:rPr>
              <a:t>color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indicat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nfidence</a:t>
            </a:r>
            <a:r>
              <a:rPr lang="es-ES" sz="1000" dirty="0">
                <a:latin typeface="Times New Roman"/>
                <a:cs typeface="Times New Roman"/>
              </a:rPr>
              <a:t> in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elative</a:t>
            </a:r>
            <a:r>
              <a:rPr lang="es-ES" sz="1000" dirty="0">
                <a:latin typeface="Times New Roman"/>
                <a:cs typeface="Times New Roman"/>
              </a:rPr>
              <a:t> position of </a:t>
            </a:r>
            <a:r>
              <a:rPr lang="es-ES" sz="1000" dirty="0" err="1">
                <a:latin typeface="Times New Roman"/>
                <a:cs typeface="Times New Roman"/>
              </a:rPr>
              <a:t>domains</a:t>
            </a:r>
            <a:r>
              <a:rPr lang="es-ES" sz="1000" dirty="0">
                <a:latin typeface="Times New Roman"/>
                <a:cs typeface="Times New Roman"/>
              </a:rPr>
              <a:t>. (D) PDB </a:t>
            </a:r>
            <a:r>
              <a:rPr lang="es-ES" sz="1000" dirty="0" err="1">
                <a:latin typeface="Times New Roman"/>
                <a:cs typeface="Times New Roman"/>
              </a:rPr>
              <a:t>summary</a:t>
            </a:r>
            <a:r>
              <a:rPr lang="es-ES" sz="1000" dirty="0">
                <a:latin typeface="Times New Roman"/>
                <a:cs typeface="Times New Roman"/>
              </a:rPr>
              <a:t> (</a:t>
            </a:r>
            <a:r>
              <a:rPr lang="es-ES" sz="1000" dirty="0" err="1">
                <a:latin typeface="Times New Roman"/>
                <a:cs typeface="Times New Roman"/>
              </a:rPr>
              <a:t>PDBsum</a:t>
            </a:r>
            <a:r>
              <a:rPr lang="es-ES" sz="1000" dirty="0">
                <a:latin typeface="Times New Roman"/>
                <a:cs typeface="Times New Roman"/>
              </a:rPr>
              <a:t>)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edic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tructural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odels</a:t>
            </a:r>
            <a:r>
              <a:rPr lang="es-ES" sz="1000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Residue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elong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domain</a:t>
            </a:r>
            <a:r>
              <a:rPr lang="es-ES" sz="1000" dirty="0">
                <a:latin typeface="Times New Roman"/>
                <a:cs typeface="Times New Roman"/>
              </a:rPr>
              <a:t> A are </a:t>
            </a:r>
            <a:r>
              <a:rPr lang="es-ES" sz="1000" dirty="0" err="1">
                <a:latin typeface="Times New Roman"/>
                <a:cs typeface="Times New Roman"/>
              </a:rPr>
              <a:t>highlighted</a:t>
            </a:r>
            <a:r>
              <a:rPr lang="es-ES" sz="1000" dirty="0">
                <a:latin typeface="Times New Roman"/>
                <a:cs typeface="Times New Roman"/>
              </a:rPr>
              <a:t> in </a:t>
            </a:r>
            <a:r>
              <a:rPr lang="es-ES" sz="1000" dirty="0" err="1">
                <a:latin typeface="Times New Roman"/>
                <a:cs typeface="Times New Roman"/>
              </a:rPr>
              <a:t>orange</a:t>
            </a:r>
            <a:r>
              <a:rPr lang="es-ES" sz="1000" dirty="0">
                <a:latin typeface="Times New Roman"/>
                <a:cs typeface="Times New Roman"/>
              </a:rPr>
              <a:t>, and </a:t>
            </a:r>
            <a:r>
              <a:rPr lang="es-ES" sz="1000" dirty="0" err="1">
                <a:latin typeface="Times New Roman"/>
                <a:cs typeface="Times New Roman"/>
              </a:rPr>
              <a:t>those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domain</a:t>
            </a:r>
            <a:r>
              <a:rPr lang="es-ES" sz="1000" dirty="0">
                <a:latin typeface="Times New Roman"/>
                <a:cs typeface="Times New Roman"/>
              </a:rPr>
              <a:t> B are in </a:t>
            </a:r>
            <a:r>
              <a:rPr lang="es-ES" sz="1000" dirty="0" err="1">
                <a:latin typeface="Times New Roman"/>
                <a:cs typeface="Times New Roman"/>
              </a:rPr>
              <a:t>cyan</a:t>
            </a:r>
            <a:r>
              <a:rPr lang="es-ES" sz="1000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Histidines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utative</a:t>
            </a:r>
            <a:r>
              <a:rPr lang="es-ES" sz="1000" dirty="0">
                <a:latin typeface="Times New Roman"/>
                <a:cs typeface="Times New Roman"/>
              </a:rPr>
              <a:t> zinc-</a:t>
            </a:r>
            <a:r>
              <a:rPr lang="es-ES" sz="1000" dirty="0" err="1">
                <a:latin typeface="Times New Roman"/>
                <a:cs typeface="Times New Roman"/>
              </a:rPr>
              <a:t>bind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ocket</a:t>
            </a:r>
            <a:r>
              <a:rPr lang="es-ES" sz="1000" dirty="0">
                <a:latin typeface="Times New Roman"/>
                <a:cs typeface="Times New Roman"/>
              </a:rPr>
              <a:t> are </a:t>
            </a:r>
            <a:r>
              <a:rPr lang="es-ES" sz="1000" dirty="0" err="1">
                <a:latin typeface="Times New Roman"/>
                <a:cs typeface="Times New Roman"/>
              </a:rPr>
              <a:t>label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with</a:t>
            </a:r>
            <a:r>
              <a:rPr lang="es-ES" sz="1000" dirty="0">
                <a:latin typeface="Times New Roman"/>
                <a:cs typeface="Times New Roman"/>
              </a:rPr>
              <a:t> a </a:t>
            </a:r>
            <a:r>
              <a:rPr lang="es-ES" sz="1000" dirty="0" err="1">
                <a:latin typeface="Times New Roman"/>
                <a:cs typeface="Times New Roman"/>
              </a:rPr>
              <a:t>dot</a:t>
            </a:r>
            <a:r>
              <a:rPr lang="es-ES" sz="1000" dirty="0">
                <a:latin typeface="Times New Roman"/>
                <a:cs typeface="Times New Roman"/>
              </a:rPr>
              <a:t>. (E) </a:t>
            </a:r>
            <a:r>
              <a:rPr lang="es-ES" sz="1000" dirty="0" err="1">
                <a:latin typeface="Times New Roman"/>
                <a:cs typeface="Times New Roman"/>
              </a:rPr>
              <a:t>Clos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view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putative zinc-</a:t>
            </a:r>
            <a:r>
              <a:rPr lang="es-ES" sz="1000" dirty="0" err="1">
                <a:latin typeface="Times New Roman"/>
                <a:cs typeface="Times New Roman"/>
              </a:rPr>
              <a:t>bind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ocket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ZepA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rotein</a:t>
            </a:r>
            <a:r>
              <a:rPr lang="es-ES" sz="1000" dirty="0">
                <a:latin typeface="Times New Roman"/>
                <a:cs typeface="Times New Roman"/>
              </a:rPr>
              <a:t> of </a:t>
            </a:r>
            <a:r>
              <a:rPr lang="es-ES" sz="1000" i="1" dirty="0" err="1">
                <a:latin typeface="Times New Roman"/>
                <a:cs typeface="Times New Roman"/>
              </a:rPr>
              <a:t>Anabaena</a:t>
            </a:r>
            <a:r>
              <a:rPr lang="es-ES" sz="1000" dirty="0">
                <a:latin typeface="Times New Roman"/>
                <a:cs typeface="Times New Roman"/>
              </a:rPr>
              <a:t> (</a:t>
            </a:r>
            <a:r>
              <a:rPr lang="es-ES" sz="1000" dirty="0" err="1">
                <a:latin typeface="Times New Roman"/>
                <a:cs typeface="Times New Roman"/>
              </a:rPr>
              <a:t>left</a:t>
            </a:r>
            <a:r>
              <a:rPr lang="es-ES" sz="1000" dirty="0">
                <a:latin typeface="Times New Roman"/>
                <a:cs typeface="Times New Roman"/>
              </a:rPr>
              <a:t>) and </a:t>
            </a:r>
            <a:r>
              <a:rPr lang="es-ES" sz="1000" i="1" dirty="0" err="1">
                <a:latin typeface="Times New Roman"/>
                <a:cs typeface="Times New Roman"/>
              </a:rPr>
              <a:t>Lacipirellula</a:t>
            </a:r>
            <a:r>
              <a:rPr lang="es-ES" sz="1000" dirty="0">
                <a:latin typeface="Times New Roman"/>
                <a:cs typeface="Times New Roman"/>
              </a:rPr>
              <a:t> (</a:t>
            </a:r>
            <a:r>
              <a:rPr lang="es-ES" sz="1000" dirty="0" err="1">
                <a:latin typeface="Times New Roman"/>
                <a:cs typeface="Times New Roman"/>
              </a:rPr>
              <a:t>right</a:t>
            </a:r>
            <a:r>
              <a:rPr lang="es-ES" sz="1000" dirty="0">
                <a:latin typeface="Times New Roman"/>
                <a:cs typeface="Times New Roman"/>
              </a:rPr>
              <a:t>) </a:t>
            </a:r>
            <a:r>
              <a:rPr lang="es-ES" sz="1000" dirty="0" err="1">
                <a:latin typeface="Times New Roman"/>
                <a:cs typeface="Times New Roman"/>
              </a:rPr>
              <a:t>show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distance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etween</a:t>
            </a:r>
            <a:r>
              <a:rPr lang="es-ES" sz="1000" dirty="0">
                <a:latin typeface="Times New Roman"/>
                <a:cs typeface="Times New Roman"/>
              </a:rPr>
              <a:t> N </a:t>
            </a:r>
            <a:r>
              <a:rPr lang="es-ES" sz="1000" dirty="0" err="1">
                <a:latin typeface="Times New Roman"/>
                <a:cs typeface="Times New Roman"/>
              </a:rPr>
              <a:t>atoms</a:t>
            </a:r>
            <a:r>
              <a:rPr lang="es-ES" sz="1000" dirty="0">
                <a:latin typeface="Times New Roman"/>
                <a:cs typeface="Times New Roman"/>
              </a:rPr>
              <a:t> in </a:t>
            </a:r>
            <a:r>
              <a:rPr lang="es-ES" sz="1000" dirty="0" err="1">
                <a:latin typeface="Times New Roman"/>
                <a:cs typeface="Times New Roman"/>
              </a:rPr>
              <a:t>histidin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residues</a:t>
            </a:r>
            <a:r>
              <a:rPr lang="es-ES" sz="1000" dirty="0">
                <a:latin typeface="Times New Roman"/>
                <a:cs typeface="Times New Roman"/>
              </a:rPr>
              <a:t> and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zinc </a:t>
            </a:r>
            <a:r>
              <a:rPr lang="es-ES" sz="1000" dirty="0" err="1">
                <a:latin typeface="Times New Roman"/>
                <a:cs typeface="Times New Roman"/>
              </a:rPr>
              <a:t>atom</a:t>
            </a:r>
            <a:r>
              <a:rPr lang="es-ES" sz="1000" dirty="0">
                <a:latin typeface="Times New Roman"/>
                <a:cs typeface="Times New Roman"/>
              </a:rPr>
              <a:t> in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odel</a:t>
            </a:r>
            <a:r>
              <a:rPr lang="es-ES" sz="1000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data </a:t>
            </a:r>
            <a:r>
              <a:rPr lang="es-ES" sz="1000" dirty="0" err="1">
                <a:latin typeface="Times New Roman"/>
                <a:cs typeface="Times New Roman"/>
              </a:rPr>
              <a:t>underly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is</a:t>
            </a:r>
            <a:r>
              <a:rPr lang="es-ES" sz="1000" dirty="0">
                <a:latin typeface="Times New Roman"/>
                <a:cs typeface="Times New Roman"/>
              </a:rPr>
              <a:t> figure can be </a:t>
            </a:r>
            <a:r>
              <a:rPr lang="es-ES" sz="1000" dirty="0" err="1">
                <a:latin typeface="Times New Roman"/>
                <a:cs typeface="Times New Roman"/>
              </a:rPr>
              <a:t>found</a:t>
            </a:r>
            <a:r>
              <a:rPr lang="es-ES" sz="1000" dirty="0">
                <a:latin typeface="Times New Roman"/>
                <a:cs typeface="Times New Roman"/>
              </a:rPr>
              <a:t> in S1</a:t>
            </a:r>
            <a:r>
              <a:rPr lang="es-ES" sz="1000">
                <a:latin typeface="Times New Roman"/>
                <a:cs typeface="Times New Roman"/>
              </a:rPr>
              <a:t>_Data. </a:t>
            </a:r>
            <a:endParaRPr lang="es-ES" sz="10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26754809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43</TotalTime>
  <Words>599</Words>
  <Application>Microsoft Macintosh PowerPoint</Application>
  <PresentationFormat>A4 Paper (210x297 mm)</PresentationFormat>
  <Paragraphs>3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ourier New</vt:lpstr>
      <vt:lpstr>Times New Roman</vt:lpstr>
      <vt:lpstr>Tema de Office</vt:lpstr>
      <vt:lpstr>PowerPoint Presentation</vt:lpstr>
      <vt:lpstr>PowerPoint Presentation</vt:lpstr>
    </vt:vector>
  </TitlesOfParts>
  <Company>IBV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Luque Romero</dc:creator>
  <cp:lastModifiedBy>Ignacio Luque</cp:lastModifiedBy>
  <cp:revision>24</cp:revision>
  <dcterms:created xsi:type="dcterms:W3CDTF">2022-12-22T19:53:09Z</dcterms:created>
  <dcterms:modified xsi:type="dcterms:W3CDTF">2024-02-07T14:17:44Z</dcterms:modified>
</cp:coreProperties>
</file>